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8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1A82C2D-CEA3-4ADD-B72B-8C2A4C688D33}" v="28" dt="2023-07-19T10:57:07.71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96" d="100"/>
          <a:sy n="96" d="100"/>
        </p:scale>
        <p:origin x="414" y="-11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E1A82C2D-CEA3-4ADD-B72B-8C2A4C688D33}"/>
    <pc:docChg chg="undo redo custSel addSld delSld modSld modMainMaster modNotesMaster">
      <pc:chgData name="JUAN MANUEL LOZANO GIL" userId="618ed11e-cb2c-4b03-8ac9-a8cf52f924c9" providerId="ADAL" clId="{E1A82C2D-CEA3-4ADD-B72B-8C2A4C688D33}" dt="2023-07-19T10:58:11.482" v="367" actId="14100"/>
      <pc:docMkLst>
        <pc:docMk/>
      </pc:docMkLst>
      <pc:sldChg chg="addSp delSp modSp mod modNotes">
        <pc:chgData name="JUAN MANUEL LOZANO GIL" userId="618ed11e-cb2c-4b03-8ac9-a8cf52f924c9" providerId="ADAL" clId="{E1A82C2D-CEA3-4ADD-B72B-8C2A4C688D33}" dt="2023-07-19T10:22:37.401" v="245" actId="1076"/>
        <pc:sldMkLst>
          <pc:docMk/>
          <pc:sldMk cId="3278798907" sldId="256"/>
        </pc:sldMkLst>
        <pc:spChg chg="add mod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9" creationId="{146086C0-B663-8443-F4B7-2719B3DFBC7A}"/>
          </ac:spMkLst>
        </pc:spChg>
        <pc:spChg chg="add mod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21" creationId="{E6FAAC9E-4562-B972-E7DE-16A5145C38A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9" creationId="{6FE0C5C9-EFFF-D8EF-6794-40A8A3B3FDB4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30" creationId="{69A63828-D0E6-C303-7DAB-022683830F6B}"/>
          </ac:spMkLst>
        </pc:spChg>
        <pc:spChg chg="del">
          <ac:chgData name="JUAN MANUEL LOZANO GIL" userId="618ed11e-cb2c-4b03-8ac9-a8cf52f924c9" providerId="ADAL" clId="{E1A82C2D-CEA3-4ADD-B72B-8C2A4C688D33}" dt="2023-07-19T10:04:49.937" v="26" actId="478"/>
          <ac:spMkLst>
            <pc:docMk/>
            <pc:sldMk cId="3278798907" sldId="256"/>
            <ac:spMk id="31" creationId="{EC910EE7-D130-C396-5EB0-59BC79EF144D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2" creationId="{7AACA306-674B-1C70-235C-CCCCACCF8049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3" creationId="{40B58694-FE1E-CCFD-0228-0AA311C76DFA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44" creationId="{BD6261B1-AF8A-600C-86F5-AC0B8B5DEF74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5" creationId="{31A25F3E-6C68-F161-3D0F-F200414B1A3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6" creationId="{3638FD81-EEFB-3605-A26A-B156E0406D02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47" creationId="{BBD7C682-AC1C-3AC2-4AB1-81C157A2132D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8" creationId="{43D45783-35DE-6202-F1E7-93A721736D85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49" creationId="{29E10A20-1F20-FCB7-63FA-D9EDDADD0B1D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50" creationId="{6E9FCBC0-E68F-83A1-B005-C1EF0A517685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1" creationId="{A06224D5-42DC-2220-0691-7BB9BAC19105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2" creationId="{FC76A523-D22C-9CE9-86C0-3291B5E55716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53" creationId="{7F1575BB-08B9-8701-715E-E77B24154E6A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4" creationId="{1865E9DC-E288-5D5B-E8CE-3964A7FF498A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55" creationId="{3340EB4D-D450-3A93-EC03-0A0352BE4422}"/>
          </ac:spMkLst>
        </pc:spChg>
        <pc:spChg chg="del mod">
          <ac:chgData name="JUAN MANUEL LOZANO GIL" userId="618ed11e-cb2c-4b03-8ac9-a8cf52f924c9" providerId="ADAL" clId="{E1A82C2D-CEA3-4ADD-B72B-8C2A4C688D33}" dt="2023-07-19T10:06:17.411" v="55" actId="478"/>
          <ac:spMkLst>
            <pc:docMk/>
            <pc:sldMk cId="3278798907" sldId="256"/>
            <ac:spMk id="56" creationId="{48ED9661-A95F-EB2D-3C34-8D798C4666EB}"/>
          </ac:spMkLst>
        </pc:spChg>
        <pc:spChg chg="del">
          <ac:chgData name="JUAN MANUEL LOZANO GIL" userId="618ed11e-cb2c-4b03-8ac9-a8cf52f924c9" providerId="ADAL" clId="{E1A82C2D-CEA3-4ADD-B72B-8C2A4C688D33}" dt="2023-07-19T10:04:43.714" v="22" actId="478"/>
          <ac:spMkLst>
            <pc:docMk/>
            <pc:sldMk cId="3278798907" sldId="256"/>
            <ac:spMk id="57" creationId="{28CA052F-27E2-63EB-F3F6-80FE3D734D00}"/>
          </ac:spMkLst>
        </pc:spChg>
        <pc:spChg chg="del">
          <ac:chgData name="JUAN MANUEL LOZANO GIL" userId="618ed11e-cb2c-4b03-8ac9-a8cf52f924c9" providerId="ADAL" clId="{E1A82C2D-CEA3-4ADD-B72B-8C2A4C688D33}" dt="2023-07-19T10:04:40.730" v="21" actId="478"/>
          <ac:spMkLst>
            <pc:docMk/>
            <pc:sldMk cId="3278798907" sldId="256"/>
            <ac:spMk id="58" creationId="{804C4DA3-BFC8-7599-5D2F-611F69F9E7D6}"/>
          </ac:spMkLst>
        </pc:spChg>
        <pc:spChg chg="del">
          <ac:chgData name="JUAN MANUEL LOZANO GIL" userId="618ed11e-cb2c-4b03-8ac9-a8cf52f924c9" providerId="ADAL" clId="{E1A82C2D-CEA3-4ADD-B72B-8C2A4C688D33}" dt="2023-07-19T10:04:38.970" v="20" actId="478"/>
          <ac:spMkLst>
            <pc:docMk/>
            <pc:sldMk cId="3278798907" sldId="256"/>
            <ac:spMk id="59" creationId="{C16583F2-6CA4-58DD-020E-AF1AA81B75F4}"/>
          </ac:spMkLst>
        </pc:spChg>
        <pc:spChg chg="del">
          <ac:chgData name="JUAN MANUEL LOZANO GIL" userId="618ed11e-cb2c-4b03-8ac9-a8cf52f924c9" providerId="ADAL" clId="{E1A82C2D-CEA3-4ADD-B72B-8C2A4C688D33}" dt="2023-07-19T10:04:45.578" v="23" actId="478"/>
          <ac:spMkLst>
            <pc:docMk/>
            <pc:sldMk cId="3278798907" sldId="256"/>
            <ac:spMk id="62" creationId="{FAEC6570-2D19-B589-D262-D645471A2FA8}"/>
          </ac:spMkLst>
        </pc:spChg>
        <pc:spChg chg="del">
          <ac:chgData name="JUAN MANUEL LOZANO GIL" userId="618ed11e-cb2c-4b03-8ac9-a8cf52f924c9" providerId="ADAL" clId="{E1A82C2D-CEA3-4ADD-B72B-8C2A4C688D33}" dt="2023-07-19T10:04:47.010" v="24" actId="478"/>
          <ac:spMkLst>
            <pc:docMk/>
            <pc:sldMk cId="3278798907" sldId="256"/>
            <ac:spMk id="63" creationId="{A5FAB260-0C17-FE6B-E06E-4D090A964AED}"/>
          </ac:spMkLst>
        </pc:spChg>
        <pc:spChg chg="del">
          <ac:chgData name="JUAN MANUEL LOZANO GIL" userId="618ed11e-cb2c-4b03-8ac9-a8cf52f924c9" providerId="ADAL" clId="{E1A82C2D-CEA3-4ADD-B72B-8C2A4C688D33}" dt="2023-07-19T10:04:48.610" v="25" actId="478"/>
          <ac:spMkLst>
            <pc:docMk/>
            <pc:sldMk cId="3278798907" sldId="256"/>
            <ac:spMk id="64" creationId="{6B5EAE6D-5B4A-9AA1-129A-AAA3DD980E3A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23" creationId="{ADB6E049-3E35-ED91-D48D-5CDE07739EFB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24" creationId="{106C1AF1-94C5-F629-15FD-623F681A8C50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28" creationId="{4DDF8618-B36F-119A-CA7A-EE88C352364F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3" creationId="{F7D03FBE-A81A-6BC4-1C33-3A183B86791D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4" creationId="{913B9BB6-4065-0AE0-54C4-70791E5BB21A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5" creationId="{34F0A8C1-B00F-FC42-FA0E-7F64DFB6A559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6" creationId="{DE770029-C13A-362F-EA6B-452F863DBC8A}"/>
          </ac:spMkLst>
        </pc:spChg>
        <pc:spChg chg="mod topLvl">
          <ac:chgData name="JUAN MANUEL LOZANO GIL" userId="618ed11e-cb2c-4b03-8ac9-a8cf52f924c9" providerId="ADAL" clId="{E1A82C2D-CEA3-4ADD-B72B-8C2A4C688D33}" dt="2023-07-19T10:22:37.401" v="245" actId="1076"/>
          <ac:spMkLst>
            <pc:docMk/>
            <pc:sldMk cId="3278798907" sldId="256"/>
            <ac:spMk id="139" creationId="{02190607-545A-EAEF-B8B5-30DDD473E609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0" creationId="{71A1120A-ECF7-C944-D0A7-629ED2FD6F5D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1" creationId="{2A665B5F-90E1-1DF7-3916-53928A302641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2" creationId="{0DCE5BAF-A005-6A19-35A8-D034638BD2A3}"/>
          </ac:spMkLst>
        </pc:spChg>
        <pc:spChg chg="mod topLvl">
          <ac:chgData name="JUAN MANUEL LOZANO GIL" userId="618ed11e-cb2c-4b03-8ac9-a8cf52f924c9" providerId="ADAL" clId="{E1A82C2D-CEA3-4ADD-B72B-8C2A4C688D33}" dt="2023-07-19T10:08:57.717" v="113"/>
          <ac:spMkLst>
            <pc:docMk/>
            <pc:sldMk cId="3278798907" sldId="256"/>
            <ac:spMk id="213" creationId="{9B2CD68D-1162-BD7B-04C0-5EA88A3A3A9E}"/>
          </ac:spMkLst>
        </pc:spChg>
        <pc:spChg chg="del">
          <ac:chgData name="JUAN MANUEL LOZANO GIL" userId="618ed11e-cb2c-4b03-8ac9-a8cf52f924c9" providerId="ADAL" clId="{E1A82C2D-CEA3-4ADD-B72B-8C2A4C688D33}" dt="2023-07-19T10:03:33.114" v="0" actId="478"/>
          <ac:spMkLst>
            <pc:docMk/>
            <pc:sldMk cId="3278798907" sldId="256"/>
            <ac:spMk id="330" creationId="{3B65D7B5-A3E2-577C-C8DD-AA8F8F51F348}"/>
          </ac:spMkLst>
        </pc:spChg>
        <pc:grpChg chg="add mod">
          <ac:chgData name="JUAN MANUEL LOZANO GIL" userId="618ed11e-cb2c-4b03-8ac9-a8cf52f924c9" providerId="ADAL" clId="{E1A82C2D-CEA3-4ADD-B72B-8C2A4C688D33}" dt="2023-07-19T10:22:37.401" v="245" actId="1076"/>
          <ac:grpSpMkLst>
            <pc:docMk/>
            <pc:sldMk cId="3278798907" sldId="256"/>
            <ac:grpSpMk id="7" creationId="{8D97C7FF-949E-1C1F-907C-9204A55EBD96}"/>
          </ac:grpSpMkLst>
        </pc:grpChg>
        <pc:grpChg chg="add mod">
          <ac:chgData name="JUAN MANUEL LOZANO GIL" userId="618ed11e-cb2c-4b03-8ac9-a8cf52f924c9" providerId="ADAL" clId="{E1A82C2D-CEA3-4ADD-B72B-8C2A4C688D33}" dt="2023-07-19T10:08:57.150" v="111" actId="164"/>
          <ac:grpSpMkLst>
            <pc:docMk/>
            <pc:sldMk cId="3278798907" sldId="256"/>
            <ac:grpSpMk id="8" creationId="{0B7F23BE-A6C5-B3EC-2F15-8A0F60252FAF}"/>
          </ac:grpSpMkLst>
        </pc:grpChg>
        <pc:grpChg chg="del">
          <ac:chgData name="JUAN MANUEL LOZANO GIL" userId="618ed11e-cb2c-4b03-8ac9-a8cf52f924c9" providerId="ADAL" clId="{E1A82C2D-CEA3-4ADD-B72B-8C2A4C688D33}" dt="2023-07-19T10:04:07.055" v="13" actId="21"/>
          <ac:grpSpMkLst>
            <pc:docMk/>
            <pc:sldMk cId="3278798907" sldId="256"/>
            <ac:grpSpMk id="12" creationId="{FD2B8B51-4257-7A31-F5BD-6F4E817CE3D7}"/>
          </ac:grpSpMkLst>
        </pc:grpChg>
        <pc:grpChg chg="del mod">
          <ac:chgData name="JUAN MANUEL LOZANO GIL" userId="618ed11e-cb2c-4b03-8ac9-a8cf52f924c9" providerId="ADAL" clId="{E1A82C2D-CEA3-4ADD-B72B-8C2A4C688D33}" dt="2023-07-19T10:07:09.774" v="82" actId="165"/>
          <ac:grpSpMkLst>
            <pc:docMk/>
            <pc:sldMk cId="3278798907" sldId="256"/>
            <ac:grpSpMk id="14" creationId="{A3B00373-ECCE-3F0D-9077-8FAD8A5CD4E7}"/>
          </ac:grpSpMkLst>
        </pc:grpChg>
        <pc:grpChg chg="mod topLvl">
          <ac:chgData name="JUAN MANUEL LOZANO GIL" userId="618ed11e-cb2c-4b03-8ac9-a8cf52f924c9" providerId="ADAL" clId="{E1A82C2D-CEA3-4ADD-B72B-8C2A4C688D33}" dt="2023-07-19T10:22:37.401" v="245" actId="1076"/>
          <ac:grpSpMkLst>
            <pc:docMk/>
            <pc:sldMk cId="3278798907" sldId="256"/>
            <ac:grpSpMk id="20" creationId="{C3D67D48-DBD6-F3C7-14EA-203AA1CEB286}"/>
          </ac:grpSpMkLst>
        </pc:grpChg>
        <pc:grpChg chg="del">
          <ac:chgData name="JUAN MANUEL LOZANO GIL" userId="618ed11e-cb2c-4b03-8ac9-a8cf52f924c9" providerId="ADAL" clId="{E1A82C2D-CEA3-4ADD-B72B-8C2A4C688D33}" dt="2023-07-19T10:03:44.814" v="1" actId="21"/>
          <ac:grpSpMkLst>
            <pc:docMk/>
            <pc:sldMk cId="3278798907" sldId="256"/>
            <ac:grpSpMk id="23" creationId="{C689D05A-6159-D3DD-CE48-3B7FF27422C9}"/>
          </ac:grpSpMkLst>
        </pc:grpChg>
        <pc:grpChg chg="mod">
          <ac:chgData name="JUAN MANUEL LOZANO GIL" userId="618ed11e-cb2c-4b03-8ac9-a8cf52f924c9" providerId="ADAL" clId="{E1A82C2D-CEA3-4ADD-B72B-8C2A4C688D33}" dt="2023-07-19T10:08:57.717" v="113"/>
          <ac:grpSpMkLst>
            <pc:docMk/>
            <pc:sldMk cId="3278798907" sldId="256"/>
            <ac:grpSpMk id="32" creationId="{5121F8BE-6AAD-93AE-7F46-DD245EED2E35}"/>
          </ac:grpSpMkLst>
        </pc:grpChg>
        <pc:grpChg chg="mod topLvl">
          <ac:chgData name="JUAN MANUEL LOZANO GIL" userId="618ed11e-cb2c-4b03-8ac9-a8cf52f924c9" providerId="ADAL" clId="{E1A82C2D-CEA3-4ADD-B72B-8C2A4C688D33}" dt="2023-07-19T10:22:37.401" v="245" actId="1076"/>
          <ac:grpSpMkLst>
            <pc:docMk/>
            <pc:sldMk cId="3278798907" sldId="256"/>
            <ac:grpSpMk id="65" creationId="{A5E5CDB5-C751-0E14-2CF2-8CD6EEB4673D}"/>
          </ac:grpSpMkLst>
        </pc:grpChg>
        <pc:grpChg chg="mod topLvl">
          <ac:chgData name="JUAN MANUEL LOZANO GIL" userId="618ed11e-cb2c-4b03-8ac9-a8cf52f924c9" providerId="ADAL" clId="{E1A82C2D-CEA3-4ADD-B72B-8C2A4C688D33}" dt="2023-07-19T10:08:57.717" v="113"/>
          <ac:grpSpMkLst>
            <pc:docMk/>
            <pc:sldMk cId="3278798907" sldId="256"/>
            <ac:grpSpMk id="204" creationId="{8ACC7B1E-E575-A5C9-001D-648B9DED9431}"/>
          </ac:grpSpMkLst>
        </pc:grpChg>
        <pc:grpChg chg="del mod topLvl">
          <ac:chgData name="JUAN MANUEL LOZANO GIL" userId="618ed11e-cb2c-4b03-8ac9-a8cf52f924c9" providerId="ADAL" clId="{E1A82C2D-CEA3-4ADD-B72B-8C2A4C688D33}" dt="2023-07-19T10:07:20.387" v="83" actId="165"/>
          <ac:grpSpMkLst>
            <pc:docMk/>
            <pc:sldMk cId="3278798907" sldId="256"/>
            <ac:grpSpMk id="219" creationId="{30313194-4B88-D4FC-5F98-5FAD5B936A2E}"/>
          </ac:grpSpMkLst>
        </pc:grpChg>
        <pc:picChg chg="mod topLvl modCrop">
          <ac:chgData name="JUAN MANUEL LOZANO GIL" userId="618ed11e-cb2c-4b03-8ac9-a8cf52f924c9" providerId="ADAL" clId="{E1A82C2D-CEA3-4ADD-B72B-8C2A4C688D33}" dt="2023-07-19T10:22:37.401" v="245" actId="1076"/>
          <ac:picMkLst>
            <pc:docMk/>
            <pc:sldMk cId="3278798907" sldId="256"/>
            <ac:picMk id="13" creationId="{A3918CB1-7E0E-12FB-DEA9-93F0D716FC59}"/>
          </ac:picMkLst>
        </pc:picChg>
        <pc:picChg chg="mod topLvl modCrop">
          <ac:chgData name="JUAN MANUEL LOZANO GIL" userId="618ed11e-cb2c-4b03-8ac9-a8cf52f924c9" providerId="ADAL" clId="{E1A82C2D-CEA3-4ADD-B72B-8C2A4C688D33}" dt="2023-07-19T10:08:57.717" v="113"/>
          <ac:picMkLst>
            <pc:docMk/>
            <pc:sldMk cId="3278798907" sldId="256"/>
            <ac:picMk id="218" creationId="{79CCC012-5C18-36BB-7BFB-CDF561A3F513}"/>
          </ac:picMkLst>
        </pc:pic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5" creationId="{129E63B4-C489-BEB8-4402-11F892A8CF0B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6" creationId="{2BD03A2C-A553-B425-123C-509BB86E89A9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7" creationId="{E9A25BB7-3C06-F81F-C768-BB81B8DBCCCA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8" creationId="{78C4AB6F-D797-1CFE-3B4A-E15CBF255F8B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19" creationId="{8ED8A38E-CC84-360C-366C-FA96E46AE39E}"/>
          </ac:cxnSpMkLst>
        </pc:cxnChg>
        <pc:cxnChg chg="mod topLvl">
          <ac:chgData name="JUAN MANUEL LOZANO GIL" userId="618ed11e-cb2c-4b03-8ac9-a8cf52f924c9" providerId="ADAL" clId="{E1A82C2D-CEA3-4ADD-B72B-8C2A4C688D33}" dt="2023-07-19T10:22:37.401" v="245" actId="1076"/>
          <ac:cxnSpMkLst>
            <pc:docMk/>
            <pc:sldMk cId="3278798907" sldId="256"/>
            <ac:cxnSpMk id="127" creationId="{8839E733-E7A2-2B25-2A5F-F486A05DED28}"/>
          </ac:cxnSpMkLst>
        </pc:cxnChg>
        <pc:cxnChg chg="mod">
          <ac:chgData name="JUAN MANUEL LOZANO GIL" userId="618ed11e-cb2c-4b03-8ac9-a8cf52f924c9" providerId="ADAL" clId="{E1A82C2D-CEA3-4ADD-B72B-8C2A4C688D33}" dt="2023-07-19T10:04:07.055" v="13" actId="21"/>
          <ac:cxnSpMkLst>
            <pc:docMk/>
            <pc:sldMk cId="3278798907" sldId="256"/>
            <ac:cxnSpMk id="183" creationId="{26892D6D-7238-9454-402A-4E8F4570AED3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5" creationId="{740BA44F-D247-349E-363F-65A0FDBE4E40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6" creationId="{7078B968-C719-5F90-98A2-8D1838D02E9A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7" creationId="{4EBF6361-0149-0467-B190-B5CD93833555}"/>
          </ac:cxnSpMkLst>
        </pc:cxnChg>
        <pc:cxnChg chg="mod">
          <ac:chgData name="JUAN MANUEL LOZANO GIL" userId="618ed11e-cb2c-4b03-8ac9-a8cf52f924c9" providerId="ADAL" clId="{E1A82C2D-CEA3-4ADD-B72B-8C2A4C688D33}" dt="2023-07-19T10:08:57.717" v="113"/>
          <ac:cxnSpMkLst>
            <pc:docMk/>
            <pc:sldMk cId="3278798907" sldId="256"/>
            <ac:cxnSpMk id="208" creationId="{9EF16A84-0776-03ED-FF8A-4557944FE18D}"/>
          </ac:cxnSpMkLst>
        </pc:cxnChg>
      </pc:sldChg>
      <pc:sldChg chg="addSp delSp modSp new del mod">
        <pc:chgData name="JUAN MANUEL LOZANO GIL" userId="618ed11e-cb2c-4b03-8ac9-a8cf52f924c9" providerId="ADAL" clId="{E1A82C2D-CEA3-4ADD-B72B-8C2A4C688D33}" dt="2023-07-19T10:04:27.409" v="19" actId="47"/>
        <pc:sldMkLst>
          <pc:docMk/>
          <pc:sldMk cId="657655474" sldId="257"/>
        </pc:sldMkLst>
        <pc:spChg chg="del">
          <ac:chgData name="JUAN MANUEL LOZANO GIL" userId="618ed11e-cb2c-4b03-8ac9-a8cf52f924c9" providerId="ADAL" clId="{E1A82C2D-CEA3-4ADD-B72B-8C2A4C688D33}" dt="2023-07-19T10:03:47.634" v="3" actId="478"/>
          <ac:spMkLst>
            <pc:docMk/>
            <pc:sldMk cId="657655474" sldId="257"/>
            <ac:spMk id="2" creationId="{800A1122-484B-2A3C-C0CE-768AEFDB229F}"/>
          </ac:spMkLst>
        </pc:spChg>
        <pc:spChg chg="del">
          <ac:chgData name="JUAN MANUEL LOZANO GIL" userId="618ed11e-cb2c-4b03-8ac9-a8cf52f924c9" providerId="ADAL" clId="{E1A82C2D-CEA3-4ADD-B72B-8C2A4C688D33}" dt="2023-07-19T10:03:47.634" v="3" actId="478"/>
          <ac:spMkLst>
            <pc:docMk/>
            <pc:sldMk cId="657655474" sldId="257"/>
            <ac:spMk id="3" creationId="{8983F845-CDCB-E8E2-5481-70C4C4DE771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8" creationId="{13B95DF6-AC6E-32A6-E0CF-80764C83780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4" creationId="{64296D20-BC9E-AC68-7173-7AC8718B7B5E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5" creationId="{6F38B3DE-1E9D-7CC0-651F-B1BB5C1B1A71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6" creationId="{DB8C024E-C177-7355-4492-D71C1CBCBEBB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7" creationId="{2356E297-0235-1843-7B95-6D2320B6ECEB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8" creationId="{919AF038-5971-659C-BB5B-0CD22769FBD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19" creationId="{87E25859-5B28-A8CA-A5D6-B081ED71438D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0" creationId="{AD817CB9-7FBC-57C2-4EF9-FDB0B3D0FDD5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1" creationId="{12DB9528-A010-8B73-8D3D-A1F9B8A435F0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2" creationId="{68737114-D9C9-932C-0B3D-86BC7C67970B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3" creationId="{8558E92D-4995-5D1F-6B6A-12C74644B288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4" creationId="{A6A5E9A4-12A2-91E8-6A13-DAFDA2B77A64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5" creationId="{5B8D7973-C0A6-1DB8-618B-DC624357553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6" creationId="{60A8C35C-71D0-45FC-3ACA-EABA480B63DF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7" creationId="{25006787-46F7-BA6B-5E21-73986F464DC5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8" creationId="{16B8B580-665A-8687-A8B0-97ECF5B70AE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29" creationId="{375B7161-F1EF-DD00-39BD-03D388AD4CD8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0" creationId="{FF00E615-99D3-D640-C607-6738790ED6B7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1" creationId="{2A663975-9145-1DFC-AE48-962A36D14AD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2" creationId="{30C68098-6199-2A55-D301-BDA0940A4F2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3" creationId="{923D6D64-DD6B-9827-DA42-7857F191863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4" creationId="{22A971D7-CDF5-AA83-E53B-8FC57BAE2F8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5" creationId="{FBB9DC96-86E5-1CD0-78D5-316DD8AB9F51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6" creationId="{82779C37-7345-0D8C-863C-6A32EBC8306A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7" creationId="{0FC4A4F2-4FC8-C06A-822D-9C29E16B9125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8" creationId="{F28D6A8F-0C1D-4714-95CB-6E00E6DB6184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39" creationId="{F3480020-B9D7-6F4B-4F3A-B9374205E81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0" creationId="{9A3C3AE8-51BC-A892-6361-F1F05BACC0AA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1" creationId="{767BECB2-FE5E-007E-21A8-124E872CDC0E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2" creationId="{53D78F58-A0B5-B747-CA26-2743B804B4F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3" creationId="{D6E81EB4-8973-7F85-EDE7-18C00069439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4" creationId="{AFDAB819-70B8-963C-66B1-A0CEB4140177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5" creationId="{5CF7CDF4-728A-1C4A-E14E-C7E6A5B61428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6" creationId="{58486834-BE79-0D37-1263-F208E1F6B27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7" creationId="{3A348ABF-8C97-0DD9-E5ED-8C9CD50D880A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8" creationId="{09798B4B-6B67-EBA6-B63C-015680777ABE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49" creationId="{8BDDE868-9749-CBC7-6110-6CB0091BCF3D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0" creationId="{863EEE31-DA9F-FAE2-7A47-66ACC7076F7F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1" creationId="{A362B612-6642-4317-4598-E92B26504FC6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2" creationId="{CBC005AC-B79C-D69F-CFDB-799E8F1D66C7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3" creationId="{42A25EC2-C884-C457-EDF5-F6C9E2C1E943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4" creationId="{A208FDB5-5894-61E2-68E1-BCE3356C2040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5" creationId="{4DEDB3A3-4ABB-C974-0C09-B3AA27AEC27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6" creationId="{DA0C6D4E-860B-1550-6137-511809214A39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7" creationId="{E4D56B3E-E89C-DB84-9E21-A589E7BFD442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8" creationId="{E6801279-A728-51EB-88BA-CE9476C82B7C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59" creationId="{168D749A-BB4D-9F45-9B0E-7A125878023C}"/>
          </ac:spMkLst>
        </pc:spChg>
        <pc:spChg chg="mod">
          <ac:chgData name="JUAN MANUEL LOZANO GIL" userId="618ed11e-cb2c-4b03-8ac9-a8cf52f924c9" providerId="ADAL" clId="{E1A82C2D-CEA3-4ADD-B72B-8C2A4C688D33}" dt="2023-07-19T10:03:56.385" v="10" actId="403"/>
          <ac:spMkLst>
            <pc:docMk/>
            <pc:sldMk cId="657655474" sldId="257"/>
            <ac:spMk id="60" creationId="{09EF38BC-9F80-3C2E-D744-BD5007A5B81F}"/>
          </ac:spMkLst>
        </pc:spChg>
        <pc:grpChg chg="add del mod">
          <ac:chgData name="JUAN MANUEL LOZANO GIL" userId="618ed11e-cb2c-4b03-8ac9-a8cf52f924c9" providerId="ADAL" clId="{E1A82C2D-CEA3-4ADD-B72B-8C2A4C688D33}" dt="2023-07-19T10:04:25.042" v="18" actId="478"/>
          <ac:grpSpMkLst>
            <pc:docMk/>
            <pc:sldMk cId="657655474" sldId="257"/>
            <ac:grpSpMk id="4" creationId="{076C00F7-FD69-5186-B803-20280C92CA1B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5" creationId="{DAE0C129-EF7D-EAD6-1326-A35EE88CC140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7" creationId="{DDAB57F5-FADF-95AE-FEB1-64DEF7BAF674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9" creationId="{A45F0C8D-7AE3-7BF7-0DF2-4B72858E2BC9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10" creationId="{D5332EE4-85D6-3CC8-256A-B6DF748C77B0}"/>
          </ac:grpSpMkLst>
        </pc:grpChg>
        <pc:grpChg chg="mod">
          <ac:chgData name="JUAN MANUEL LOZANO GIL" userId="618ed11e-cb2c-4b03-8ac9-a8cf52f924c9" providerId="ADAL" clId="{E1A82C2D-CEA3-4ADD-B72B-8C2A4C688D33}" dt="2023-07-19T10:03:48.505" v="4"/>
          <ac:grpSpMkLst>
            <pc:docMk/>
            <pc:sldMk cId="657655474" sldId="257"/>
            <ac:grpSpMk id="11" creationId="{837EFC31-E307-5819-4048-9EC2952E37CF}"/>
          </ac:grpSpMkLst>
        </pc:grpChg>
        <pc:picChg chg="mod">
          <ac:chgData name="JUAN MANUEL LOZANO GIL" userId="618ed11e-cb2c-4b03-8ac9-a8cf52f924c9" providerId="ADAL" clId="{E1A82C2D-CEA3-4ADD-B72B-8C2A4C688D33}" dt="2023-07-19T10:03:48.505" v="4"/>
          <ac:picMkLst>
            <pc:docMk/>
            <pc:sldMk cId="657655474" sldId="257"/>
            <ac:picMk id="6" creationId="{BE2BC3B9-6081-10D0-1670-7FE44754AA15}"/>
          </ac:picMkLst>
        </pc:picChg>
        <pc:cxnChg chg="mod">
          <ac:chgData name="JUAN MANUEL LOZANO GIL" userId="618ed11e-cb2c-4b03-8ac9-a8cf52f924c9" providerId="ADAL" clId="{E1A82C2D-CEA3-4ADD-B72B-8C2A4C688D33}" dt="2023-07-19T10:03:48.505" v="4"/>
          <ac:cxnSpMkLst>
            <pc:docMk/>
            <pc:sldMk cId="657655474" sldId="257"/>
            <ac:cxnSpMk id="12" creationId="{85A79910-A1F8-F4E4-2B64-55271DF270E3}"/>
          </ac:cxnSpMkLst>
        </pc:cxnChg>
        <pc:cxnChg chg="mod">
          <ac:chgData name="JUAN MANUEL LOZANO GIL" userId="618ed11e-cb2c-4b03-8ac9-a8cf52f924c9" providerId="ADAL" clId="{E1A82C2D-CEA3-4ADD-B72B-8C2A4C688D33}" dt="2023-07-19T10:03:48.505" v="4"/>
          <ac:cxnSpMkLst>
            <pc:docMk/>
            <pc:sldMk cId="657655474" sldId="257"/>
            <ac:cxnSpMk id="13" creationId="{F4187C01-CD97-ABFD-340A-6D7C0167F857}"/>
          </ac:cxnSpMkLst>
        </pc:cxnChg>
      </pc:sldChg>
      <pc:sldChg chg="addSp delSp modSp new mod">
        <pc:chgData name="JUAN MANUEL LOZANO GIL" userId="618ed11e-cb2c-4b03-8ac9-a8cf52f924c9" providerId="ADAL" clId="{E1A82C2D-CEA3-4ADD-B72B-8C2A4C688D33}" dt="2023-07-19T10:58:11.482" v="367" actId="14100"/>
        <pc:sldMkLst>
          <pc:docMk/>
          <pc:sldMk cId="2860491393" sldId="258"/>
        </pc:sldMkLst>
        <pc:spChg chg="del">
          <ac:chgData name="JUAN MANUEL LOZANO GIL" userId="618ed11e-cb2c-4b03-8ac9-a8cf52f924c9" providerId="ADAL" clId="{E1A82C2D-CEA3-4ADD-B72B-8C2A4C688D33}" dt="2023-07-19T10:04:11.161" v="15" actId="478"/>
          <ac:spMkLst>
            <pc:docMk/>
            <pc:sldMk cId="2860491393" sldId="258"/>
            <ac:spMk id="2" creationId="{5E41A4A5-BA38-A7C0-732D-177ECF774E7F}"/>
          </ac:spMkLst>
        </pc:spChg>
        <pc:spChg chg="add mod">
          <ac:chgData name="JUAN MANUEL LOZANO GIL" userId="618ed11e-cb2c-4b03-8ac9-a8cf52f924c9" providerId="ADAL" clId="{E1A82C2D-CEA3-4ADD-B72B-8C2A4C688D33}" dt="2023-07-19T10:56:30.955" v="247" actId="1076"/>
          <ac:spMkLst>
            <pc:docMk/>
            <pc:sldMk cId="2860491393" sldId="258"/>
            <ac:spMk id="2" creationId="{F9D90965-11B9-B89A-CD49-86E9DC7AC05E}"/>
          </ac:spMkLst>
        </pc:spChg>
        <pc:spChg chg="add mod">
          <ac:chgData name="JUAN MANUEL LOZANO GIL" userId="618ed11e-cb2c-4b03-8ac9-a8cf52f924c9" providerId="ADAL" clId="{E1A82C2D-CEA3-4ADD-B72B-8C2A4C688D33}" dt="2023-07-19T10:56:30.955" v="247" actId="1076"/>
          <ac:spMkLst>
            <pc:docMk/>
            <pc:sldMk cId="2860491393" sldId="258"/>
            <ac:spMk id="3" creationId="{79A126E4-6F4C-074D-2CDC-4BD9DF390A42}"/>
          </ac:spMkLst>
        </pc:spChg>
        <pc:spChg chg="del">
          <ac:chgData name="JUAN MANUEL LOZANO GIL" userId="618ed11e-cb2c-4b03-8ac9-a8cf52f924c9" providerId="ADAL" clId="{E1A82C2D-CEA3-4ADD-B72B-8C2A4C688D33}" dt="2023-07-19T10:04:11.161" v="15" actId="478"/>
          <ac:spMkLst>
            <pc:docMk/>
            <pc:sldMk cId="2860491393" sldId="258"/>
            <ac:spMk id="3" creationId="{CCCAEE68-9E15-A899-76F6-6D9A524823ED}"/>
          </ac:spMkLst>
        </pc:spChg>
        <pc:spChg chg="add mod">
          <ac:chgData name="JUAN MANUEL LOZANO GIL" userId="618ed11e-cb2c-4b03-8ac9-a8cf52f924c9" providerId="ADAL" clId="{E1A82C2D-CEA3-4ADD-B72B-8C2A4C688D33}" dt="2023-07-19T10:56:36.425" v="248" actId="1076"/>
          <ac:spMkLst>
            <pc:docMk/>
            <pc:sldMk cId="2860491393" sldId="258"/>
            <ac:spMk id="4" creationId="{1B8E72D8-1892-3747-D63B-9CEE1596979D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6" creationId="{87336119-D584-C803-7DA7-B285C21A5862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7" creationId="{DFC1C928-B58C-5B39-6A36-94B095AF7742}"/>
          </ac:spMkLst>
        </pc:spChg>
        <pc:spChg chg="add mod">
          <ac:chgData name="JUAN MANUEL LOZANO GIL" userId="618ed11e-cb2c-4b03-8ac9-a8cf52f924c9" providerId="ADAL" clId="{E1A82C2D-CEA3-4ADD-B72B-8C2A4C688D33}" dt="2023-07-19T10:57:35.250" v="363" actId="20577"/>
          <ac:spMkLst>
            <pc:docMk/>
            <pc:sldMk cId="2860491393" sldId="258"/>
            <ac:spMk id="8" creationId="{5773C4E2-C6E0-2569-F388-9FC50316B98D}"/>
          </ac:spMkLst>
        </pc:spChg>
        <pc:spChg chg="del mod">
          <ac:chgData name="JUAN MANUEL LOZANO GIL" userId="618ed11e-cb2c-4b03-8ac9-a8cf52f924c9" providerId="ADAL" clId="{E1A82C2D-CEA3-4ADD-B72B-8C2A4C688D33}" dt="2023-07-19T10:09:26.561" v="123" actId="478"/>
          <ac:spMkLst>
            <pc:docMk/>
            <pc:sldMk cId="2860491393" sldId="258"/>
            <ac:spMk id="8" creationId="{98E41257-3ED5-73D0-F8C2-6A17DF48BA45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9" creationId="{212ED726-7A90-A745-4B8C-A235A7C7A7AD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0" creationId="{ED2B8D90-DDC0-18CA-4ADE-49ED80D89D0C}"/>
          </ac:spMkLst>
        </pc:spChg>
        <pc:spChg chg="del mod">
          <ac:chgData name="JUAN MANUEL LOZANO GIL" userId="618ed11e-cb2c-4b03-8ac9-a8cf52f924c9" providerId="ADAL" clId="{E1A82C2D-CEA3-4ADD-B72B-8C2A4C688D33}" dt="2023-07-19T10:09:27.961" v="124" actId="478"/>
          <ac:spMkLst>
            <pc:docMk/>
            <pc:sldMk cId="2860491393" sldId="258"/>
            <ac:spMk id="11" creationId="{C8A953EE-EF13-F88B-401B-B0F5F029A744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2" creationId="{1901EB10-0267-51F1-3E8E-B92CA8345349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3" creationId="{89944078-0670-9E61-4EE3-C9F0F12D0445}"/>
          </ac:spMkLst>
        </pc:spChg>
        <pc:spChg chg="del mod">
          <ac:chgData name="JUAN MANUEL LOZANO GIL" userId="618ed11e-cb2c-4b03-8ac9-a8cf52f924c9" providerId="ADAL" clId="{E1A82C2D-CEA3-4ADD-B72B-8C2A4C688D33}" dt="2023-07-19T10:09:29.523" v="125" actId="478"/>
          <ac:spMkLst>
            <pc:docMk/>
            <pc:sldMk cId="2860491393" sldId="258"/>
            <ac:spMk id="14" creationId="{4E370508-864A-64BD-90B4-F64BEB8BDD36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5" creationId="{111DD018-B35B-46AF-D271-B4D5562EB4EC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6" creationId="{EF85D84E-9936-A6B4-8EB3-4B8746D40B27}"/>
          </ac:spMkLst>
        </pc:spChg>
        <pc:spChg chg="del mod">
          <ac:chgData name="JUAN MANUEL LOZANO GIL" userId="618ed11e-cb2c-4b03-8ac9-a8cf52f924c9" providerId="ADAL" clId="{E1A82C2D-CEA3-4ADD-B72B-8C2A4C688D33}" dt="2023-07-19T10:09:30.898" v="126" actId="478"/>
          <ac:spMkLst>
            <pc:docMk/>
            <pc:sldMk cId="2860491393" sldId="258"/>
            <ac:spMk id="17" creationId="{0080B20F-9FAA-A4DD-840A-AB071DE95046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8" creationId="{6F29A7E9-B002-6434-C9AC-4FB140B133D5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19" creationId="{14C537EF-4122-C74C-20BE-787C651BFE3F}"/>
          </ac:spMkLst>
        </pc:spChg>
        <pc:spChg chg="del mod">
          <ac:chgData name="JUAN MANUEL LOZANO GIL" userId="618ed11e-cb2c-4b03-8ac9-a8cf52f924c9" providerId="ADAL" clId="{E1A82C2D-CEA3-4ADD-B72B-8C2A4C688D33}" dt="2023-07-19T10:09:32.994" v="127" actId="478"/>
          <ac:spMkLst>
            <pc:docMk/>
            <pc:sldMk cId="2860491393" sldId="258"/>
            <ac:spMk id="20" creationId="{2A97856B-FA77-4C3C-A340-BBDB0F4EE837}"/>
          </ac:spMkLst>
        </pc:spChg>
        <pc:spChg chg="del mod">
          <ac:chgData name="JUAN MANUEL LOZANO GIL" userId="618ed11e-cb2c-4b03-8ac9-a8cf52f924c9" providerId="ADAL" clId="{E1A82C2D-CEA3-4ADD-B72B-8C2A4C688D33}" dt="2023-07-19T10:09:19.242" v="117" actId="478"/>
          <ac:spMkLst>
            <pc:docMk/>
            <pc:sldMk cId="2860491393" sldId="258"/>
            <ac:spMk id="21" creationId="{C6C043D2-62FE-FC07-4845-6B8D27368A44}"/>
          </ac:spMkLst>
        </pc:spChg>
        <pc:spChg chg="del mod">
          <ac:chgData name="JUAN MANUEL LOZANO GIL" userId="618ed11e-cb2c-4b03-8ac9-a8cf52f924c9" providerId="ADAL" clId="{E1A82C2D-CEA3-4ADD-B72B-8C2A4C688D33}" dt="2023-07-19T10:09:17.817" v="116" actId="478"/>
          <ac:spMkLst>
            <pc:docMk/>
            <pc:sldMk cId="2860491393" sldId="258"/>
            <ac:spMk id="22" creationId="{32B4C6D8-0C95-D7DC-6C75-E53776D1CEF1}"/>
          </ac:spMkLst>
        </pc:spChg>
        <pc:spChg chg="del mod">
          <ac:chgData name="JUAN MANUEL LOZANO GIL" userId="618ed11e-cb2c-4b03-8ac9-a8cf52f924c9" providerId="ADAL" clId="{E1A82C2D-CEA3-4ADD-B72B-8C2A4C688D33}" dt="2023-07-19T10:09:15.913" v="115" actId="478"/>
          <ac:spMkLst>
            <pc:docMk/>
            <pc:sldMk cId="2860491393" sldId="258"/>
            <ac:spMk id="23" creationId="{4958475B-2CC1-4546-9427-8DA29BB3618C}"/>
          </ac:spMkLst>
        </pc:spChg>
        <pc:spChg chg="del mod">
          <ac:chgData name="JUAN MANUEL LOZANO GIL" userId="618ed11e-cb2c-4b03-8ac9-a8cf52f924c9" providerId="ADAL" clId="{E1A82C2D-CEA3-4ADD-B72B-8C2A4C688D33}" dt="2023-07-19T10:09:21.922" v="119" actId="478"/>
          <ac:spMkLst>
            <pc:docMk/>
            <pc:sldMk cId="2860491393" sldId="258"/>
            <ac:spMk id="24" creationId="{5FAF6B05-8EE4-0CF5-53EF-829995739CE5}"/>
          </ac:spMkLst>
        </pc:spChg>
        <pc:spChg chg="del mod">
          <ac:chgData name="JUAN MANUEL LOZANO GIL" userId="618ed11e-cb2c-4b03-8ac9-a8cf52f924c9" providerId="ADAL" clId="{E1A82C2D-CEA3-4ADD-B72B-8C2A4C688D33}" dt="2023-07-19T10:09:20.409" v="118" actId="478"/>
          <ac:spMkLst>
            <pc:docMk/>
            <pc:sldMk cId="2860491393" sldId="258"/>
            <ac:spMk id="25" creationId="{027B4904-E349-D199-F83F-FB02D5CBE2F1}"/>
          </ac:spMkLst>
        </pc:spChg>
        <pc:spChg chg="del mod">
          <ac:chgData name="JUAN MANUEL LOZANO GIL" userId="618ed11e-cb2c-4b03-8ac9-a8cf52f924c9" providerId="ADAL" clId="{E1A82C2D-CEA3-4ADD-B72B-8C2A4C688D33}" dt="2023-07-19T10:09:23.849" v="121" actId="478"/>
          <ac:spMkLst>
            <pc:docMk/>
            <pc:sldMk cId="2860491393" sldId="258"/>
            <ac:spMk id="26" creationId="{7F15FCC1-DF59-7A57-A28F-77ADE8DB256D}"/>
          </ac:spMkLst>
        </pc:spChg>
        <pc:spChg chg="mod topLvl">
          <ac:chgData name="JUAN MANUEL LOZANO GIL" userId="618ed11e-cb2c-4b03-8ac9-a8cf52f924c9" providerId="ADAL" clId="{E1A82C2D-CEA3-4ADD-B72B-8C2A4C688D33}" dt="2023-07-19T10:22:04.569" v="242" actId="164"/>
          <ac:spMkLst>
            <pc:docMk/>
            <pc:sldMk cId="2860491393" sldId="258"/>
            <ac:spMk id="28" creationId="{0C3DE269-C139-498D-2E2F-B9880FAF1A5B}"/>
          </ac:spMkLst>
        </pc:spChg>
        <pc:spChg chg="mod topLvl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29" creationId="{D3DB174C-10F2-F6E0-AA63-4002509948D3}"/>
          </ac:spMkLst>
        </pc:spChg>
        <pc:spChg chg="mod topLvl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32" creationId="{0DDAFD28-20F1-385F-18AB-284038AAE9B0}"/>
          </ac:spMkLst>
        </pc:spChg>
        <pc:spChg chg="mod topLvl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36" creationId="{7B5E06C9-E8AC-F79B-49C0-62474A6786F2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38" creationId="{00188FDE-CA41-410D-E08E-E8D3367643A5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39" creationId="{DC21415E-6453-1A82-1604-603DC3D60727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0" creationId="{FA2C3190-C79E-9910-7663-4976DD6A2BF0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1" creationId="{5FE59B0F-AA69-2091-5CA8-90EDDF1F6632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2" creationId="{EB15988B-5F2B-820D-ADE2-D46AEA7E8F56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7" creationId="{B8994DA2-EAD8-5FD1-0F50-BFAD4C5113B9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8" creationId="{F411CD92-9E55-61B7-7816-75760D40E348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49" creationId="{BF76BA7C-92C5-C1F6-B293-AEED1A1599D3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53" creationId="{B841DFBC-3206-9213-1131-051CE9803F4A}"/>
          </ac:spMkLst>
        </pc:spChg>
        <pc:spChg chg="mod">
          <ac:chgData name="JUAN MANUEL LOZANO GIL" userId="618ed11e-cb2c-4b03-8ac9-a8cf52f924c9" providerId="ADAL" clId="{E1A82C2D-CEA3-4ADD-B72B-8C2A4C688D33}" dt="2023-07-19T10:13:49.085" v="198" actId="165"/>
          <ac:spMkLst>
            <pc:docMk/>
            <pc:sldMk cId="2860491393" sldId="258"/>
            <ac:spMk id="54" creationId="{1EFF6E1B-BCF1-9006-0458-C202BFC32981}"/>
          </ac:spMkLst>
        </pc:spChg>
        <pc:spChg chg="del mod">
          <ac:chgData name="JUAN MANUEL LOZANO GIL" userId="618ed11e-cb2c-4b03-8ac9-a8cf52f924c9" providerId="ADAL" clId="{E1A82C2D-CEA3-4ADD-B72B-8C2A4C688D33}" dt="2023-07-19T10:09:25.265" v="122" actId="478"/>
          <ac:spMkLst>
            <pc:docMk/>
            <pc:sldMk cId="2860491393" sldId="258"/>
            <ac:spMk id="55" creationId="{01AE80C0-4C9E-F924-D075-C7F1B1B925EC}"/>
          </ac:spMkLst>
        </pc:spChg>
        <pc:spChg chg="add mod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58" creationId="{DA9C0367-C746-1F75-B0CD-30C330BFC6E4}"/>
          </ac:spMkLst>
        </pc:spChg>
        <pc:spChg chg="add mod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59" creationId="{828D087D-B454-4477-E550-E31F2A808496}"/>
          </ac:spMkLst>
        </pc:spChg>
        <pc:spChg chg="add mod">
          <ac:chgData name="JUAN MANUEL LOZANO GIL" userId="618ed11e-cb2c-4b03-8ac9-a8cf52f924c9" providerId="ADAL" clId="{E1A82C2D-CEA3-4ADD-B72B-8C2A4C688D33}" dt="2023-07-19T10:13:27.635" v="187" actId="164"/>
          <ac:spMkLst>
            <pc:docMk/>
            <pc:sldMk cId="2860491393" sldId="258"/>
            <ac:spMk id="62" creationId="{1BD1084E-A646-D01B-7C11-3C05FA8364BC}"/>
          </ac:spMkLst>
        </pc:spChg>
        <pc:spChg chg="add mod">
          <ac:chgData name="JUAN MANUEL LOZANO GIL" userId="618ed11e-cb2c-4b03-8ac9-a8cf52f924c9" providerId="ADAL" clId="{E1A82C2D-CEA3-4ADD-B72B-8C2A4C688D33}" dt="2023-07-19T10:13:27.635" v="187" actId="164"/>
          <ac:spMkLst>
            <pc:docMk/>
            <pc:sldMk cId="2860491393" sldId="258"/>
            <ac:spMk id="63" creationId="{11C42550-096C-B696-7B08-DF1AC037E0CF}"/>
          </ac:spMkLst>
        </pc:spChg>
        <pc:spChg chg="add mod">
          <ac:chgData name="JUAN MANUEL LOZANO GIL" userId="618ed11e-cb2c-4b03-8ac9-a8cf52f924c9" providerId="ADAL" clId="{E1A82C2D-CEA3-4ADD-B72B-8C2A4C688D33}" dt="2023-07-19T10:22:33.210" v="244" actId="1076"/>
          <ac:spMkLst>
            <pc:docMk/>
            <pc:sldMk cId="2860491393" sldId="258"/>
            <ac:spMk id="65" creationId="{F064E958-1712-56DF-238F-E2F035C4367C}"/>
          </ac:spMkLst>
        </pc:spChg>
        <pc:spChg chg="add mod">
          <ac:chgData name="JUAN MANUEL LOZANO GIL" userId="618ed11e-cb2c-4b03-8ac9-a8cf52f924c9" providerId="ADAL" clId="{E1A82C2D-CEA3-4ADD-B72B-8C2A4C688D33}" dt="2023-07-19T10:58:11.482" v="367" actId="14100"/>
          <ac:spMkLst>
            <pc:docMk/>
            <pc:sldMk cId="2860491393" sldId="258"/>
            <ac:spMk id="66" creationId="{F4FF40EB-946E-3A6B-20C7-F4FD333134CA}"/>
          </ac:spMkLst>
        </pc:spChg>
        <pc:spChg chg="add mod">
          <ac:chgData name="JUAN MANUEL LOZANO GIL" userId="618ed11e-cb2c-4b03-8ac9-a8cf52f924c9" providerId="ADAL" clId="{E1A82C2D-CEA3-4ADD-B72B-8C2A4C688D33}" dt="2023-07-19T10:58:07.490" v="366" actId="14100"/>
          <ac:spMkLst>
            <pc:docMk/>
            <pc:sldMk cId="2860491393" sldId="258"/>
            <ac:spMk id="67" creationId="{7F152798-73F4-22FF-0EE5-BFD03457299F}"/>
          </ac:spMkLst>
        </pc:spChg>
        <pc:grpChg chg="add del mod">
          <ac:chgData name="JUAN MANUEL LOZANO GIL" userId="618ed11e-cb2c-4b03-8ac9-a8cf52f924c9" providerId="ADAL" clId="{E1A82C2D-CEA3-4ADD-B72B-8C2A4C688D33}" dt="2023-07-19T10:13:49.085" v="198" actId="165"/>
          <ac:grpSpMkLst>
            <pc:docMk/>
            <pc:sldMk cId="2860491393" sldId="258"/>
            <ac:grpSpMk id="4" creationId="{D2FFFCF0-8474-A914-5171-7A2F11C0393C}"/>
          </ac:grpSpMkLst>
        </pc:grpChg>
        <pc:grpChg chg="mod topLvl">
          <ac:chgData name="JUAN MANUEL LOZANO GIL" userId="618ed11e-cb2c-4b03-8ac9-a8cf52f924c9" providerId="ADAL" clId="{E1A82C2D-CEA3-4ADD-B72B-8C2A4C688D33}" dt="2023-07-19T10:22:04.569" v="242" actId="164"/>
          <ac:grpSpMkLst>
            <pc:docMk/>
            <pc:sldMk cId="2860491393" sldId="258"/>
            <ac:grpSpMk id="5" creationId="{CC8D6B1B-11E6-E58F-DB82-3C3805254A4C}"/>
          </ac:grpSpMkLst>
        </pc:grpChg>
        <pc:grpChg chg="mod topLvl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31" creationId="{E2CAE058-47B3-DC66-5560-FA2CD01F9303}"/>
          </ac:grpSpMkLst>
        </pc:grpChg>
        <pc:grpChg chg="mod topLvl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33" creationId="{20BDCBC8-51D1-41FD-88D5-43AEEA46DA21}"/>
          </ac:grpSpMkLst>
        </pc:grpChg>
        <pc:grpChg chg="mod">
          <ac:chgData name="JUAN MANUEL LOZANO GIL" userId="618ed11e-cb2c-4b03-8ac9-a8cf52f924c9" providerId="ADAL" clId="{E1A82C2D-CEA3-4ADD-B72B-8C2A4C688D33}" dt="2023-07-19T10:13:49.085" v="198" actId="165"/>
          <ac:grpSpMkLst>
            <pc:docMk/>
            <pc:sldMk cId="2860491393" sldId="258"/>
            <ac:grpSpMk id="37" creationId="{05507EE9-8901-FE84-2A55-94756AAE124F}"/>
          </ac:grpSpMkLst>
        </pc:grpChg>
        <pc:grpChg chg="mod">
          <ac:chgData name="JUAN MANUEL LOZANO GIL" userId="618ed11e-cb2c-4b03-8ac9-a8cf52f924c9" providerId="ADAL" clId="{E1A82C2D-CEA3-4ADD-B72B-8C2A4C688D33}" dt="2023-07-19T10:13:49.085" v="198" actId="165"/>
          <ac:grpSpMkLst>
            <pc:docMk/>
            <pc:sldMk cId="2860491393" sldId="258"/>
            <ac:grpSpMk id="46" creationId="{7136ED82-5400-9726-CB49-085643C6F2B8}"/>
          </ac:grpSpMkLst>
        </pc:grpChg>
        <pc:grpChg chg="add mod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64" creationId="{A6FE1016-2A3F-AC26-ED41-361693AB8198}"/>
          </ac:grpSpMkLst>
        </pc:grpChg>
        <pc:grpChg chg="add mod">
          <ac:chgData name="JUAN MANUEL LOZANO GIL" userId="618ed11e-cb2c-4b03-8ac9-a8cf52f924c9" providerId="ADAL" clId="{E1A82C2D-CEA3-4ADD-B72B-8C2A4C688D33}" dt="2023-07-19T10:22:33.210" v="244" actId="1076"/>
          <ac:grpSpMkLst>
            <pc:docMk/>
            <pc:sldMk cId="2860491393" sldId="258"/>
            <ac:grpSpMk id="68" creationId="{EDE8E204-7F0E-208F-EB7A-81EFD0FE618B}"/>
          </ac:grpSpMkLst>
        </pc:grpChg>
        <pc:picChg chg="mod topLvl modCrop">
          <ac:chgData name="JUAN MANUEL LOZANO GIL" userId="618ed11e-cb2c-4b03-8ac9-a8cf52f924c9" providerId="ADAL" clId="{E1A82C2D-CEA3-4ADD-B72B-8C2A4C688D33}" dt="2023-07-19T10:57:56.171" v="364" actId="732"/>
          <ac:picMkLst>
            <pc:docMk/>
            <pc:sldMk cId="2860491393" sldId="258"/>
            <ac:picMk id="30" creationId="{CC5382B6-4F70-EC2E-215A-07B1AC046252}"/>
          </ac:picMkLst>
        </pc:picChg>
        <pc:picChg chg="mod topLvl modCrop">
          <ac:chgData name="JUAN MANUEL LOZANO GIL" userId="618ed11e-cb2c-4b03-8ac9-a8cf52f924c9" providerId="ADAL" clId="{E1A82C2D-CEA3-4ADD-B72B-8C2A4C688D33}" dt="2023-07-19T10:22:33.210" v="244" actId="1076"/>
          <ac:picMkLst>
            <pc:docMk/>
            <pc:sldMk cId="2860491393" sldId="258"/>
            <ac:picMk id="34" creationId="{92ECEA78-A2D2-3378-562F-27F11BF467A7}"/>
          </ac:picMkLst>
        </pc:picChg>
        <pc:picChg chg="mod topLvl modCrop">
          <ac:chgData name="JUAN MANUEL LOZANO GIL" userId="618ed11e-cb2c-4b03-8ac9-a8cf52f924c9" providerId="ADAL" clId="{E1A82C2D-CEA3-4ADD-B72B-8C2A4C688D33}" dt="2023-07-19T10:58:03.234" v="365" actId="732"/>
          <ac:picMkLst>
            <pc:docMk/>
            <pc:sldMk cId="2860491393" sldId="258"/>
            <ac:picMk id="35" creationId="{BE0F3318-E226-9648-0369-3F5D1C87D6F4}"/>
          </ac:picMkLst>
        </pc:picChg>
        <pc:cxnChg chg="add mod">
          <ac:chgData name="JUAN MANUEL LOZANO GIL" userId="618ed11e-cb2c-4b03-8ac9-a8cf52f924c9" providerId="ADAL" clId="{E1A82C2D-CEA3-4ADD-B72B-8C2A4C688D33}" dt="2023-07-19T10:57:06.275" v="256" actId="1036"/>
          <ac:cxnSpMkLst>
            <pc:docMk/>
            <pc:sldMk cId="2860491393" sldId="258"/>
            <ac:cxnSpMk id="11" creationId="{9D73E918-DCA0-2DF1-ED2B-404242F0910A}"/>
          </ac:cxnSpMkLst>
        </pc:cxnChg>
        <pc:cxnChg chg="add mod">
          <ac:chgData name="JUAN MANUEL LOZANO GIL" userId="618ed11e-cb2c-4b03-8ac9-a8cf52f924c9" providerId="ADAL" clId="{E1A82C2D-CEA3-4ADD-B72B-8C2A4C688D33}" dt="2023-07-19T10:57:06.275" v="256" actId="1036"/>
          <ac:cxnSpMkLst>
            <pc:docMk/>
            <pc:sldMk cId="2860491393" sldId="258"/>
            <ac:cxnSpMk id="14" creationId="{9F48C4E8-6221-156B-0F41-51A23DD54686}"/>
          </ac:cxnSpMkLst>
        </pc:cxnChg>
        <pc:cxnChg chg="add mod">
          <ac:chgData name="JUAN MANUEL LOZANO GIL" userId="618ed11e-cb2c-4b03-8ac9-a8cf52f924c9" providerId="ADAL" clId="{E1A82C2D-CEA3-4ADD-B72B-8C2A4C688D33}" dt="2023-07-19T10:57:21.155" v="296" actId="1036"/>
          <ac:cxnSpMkLst>
            <pc:docMk/>
            <pc:sldMk cId="2860491393" sldId="258"/>
            <ac:cxnSpMk id="17" creationId="{7470D822-AB04-7F40-7F52-468FF9E0B50F}"/>
          </ac:cxnSpMkLst>
        </pc:cxnChg>
        <pc:cxnChg chg="add mod">
          <ac:chgData name="JUAN MANUEL LOZANO GIL" userId="618ed11e-cb2c-4b03-8ac9-a8cf52f924c9" providerId="ADAL" clId="{E1A82C2D-CEA3-4ADD-B72B-8C2A4C688D33}" dt="2023-07-19T10:57:30.395" v="361" actId="1036"/>
          <ac:cxnSpMkLst>
            <pc:docMk/>
            <pc:sldMk cId="2860491393" sldId="258"/>
            <ac:cxnSpMk id="20" creationId="{1EFDB093-4404-6E5A-ACE2-0A12877D5822}"/>
          </ac:cxnSpMkLst>
        </pc:cxnChg>
        <pc:cxnChg chg="mod topLvl">
          <ac:chgData name="JUAN MANUEL LOZANO GIL" userId="618ed11e-cb2c-4b03-8ac9-a8cf52f924c9" providerId="ADAL" clId="{E1A82C2D-CEA3-4ADD-B72B-8C2A4C688D33}" dt="2023-07-19T10:22:04.569" v="242" actId="164"/>
          <ac:cxnSpMkLst>
            <pc:docMk/>
            <pc:sldMk cId="2860491393" sldId="258"/>
            <ac:cxnSpMk id="27" creationId="{186F89D3-D222-0730-62F8-0B6F3E9908AC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43" creationId="{E3AB3F25-4D10-4C3D-C0DE-CD23D0F63C10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44" creationId="{D7F45660-667C-46A6-C412-CE619C680D4A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45" creationId="{4722DD0C-E762-4059-8AB1-E60316CF1F81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50" creationId="{EE321CE7-6324-8E19-B0BB-818ACE86D567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51" creationId="{BE8F1F3D-25CF-C932-C5CD-8027BC0C7650}"/>
          </ac:cxnSpMkLst>
        </pc:cxnChg>
        <pc:cxnChg chg="mod">
          <ac:chgData name="JUAN MANUEL LOZANO GIL" userId="618ed11e-cb2c-4b03-8ac9-a8cf52f924c9" providerId="ADAL" clId="{E1A82C2D-CEA3-4ADD-B72B-8C2A4C688D33}" dt="2023-07-19T10:13:49.085" v="198" actId="165"/>
          <ac:cxnSpMkLst>
            <pc:docMk/>
            <pc:sldMk cId="2860491393" sldId="258"/>
            <ac:cxnSpMk id="52" creationId="{1D5337B2-EE45-01E8-0E83-7C7E11C4505C}"/>
          </ac:cxnSpMkLst>
        </pc:cxnChg>
        <pc:cxnChg chg="add mod">
          <ac:chgData name="JUAN MANUEL LOZANO GIL" userId="618ed11e-cb2c-4b03-8ac9-a8cf52f924c9" providerId="ADAL" clId="{E1A82C2D-CEA3-4ADD-B72B-8C2A4C688D33}" dt="2023-07-19T10:22:33.210" v="244" actId="1076"/>
          <ac:cxnSpMkLst>
            <pc:docMk/>
            <pc:sldMk cId="2860491393" sldId="258"/>
            <ac:cxnSpMk id="56" creationId="{F58A9D6E-16BB-2EB5-1515-F0583110A374}"/>
          </ac:cxnSpMkLst>
        </pc:cxnChg>
        <pc:cxnChg chg="add mod">
          <ac:chgData name="JUAN MANUEL LOZANO GIL" userId="618ed11e-cb2c-4b03-8ac9-a8cf52f924c9" providerId="ADAL" clId="{E1A82C2D-CEA3-4ADD-B72B-8C2A4C688D33}" dt="2023-07-19T10:22:33.210" v="244" actId="1076"/>
          <ac:cxnSpMkLst>
            <pc:docMk/>
            <pc:sldMk cId="2860491393" sldId="258"/>
            <ac:cxnSpMk id="57" creationId="{68460041-6498-1223-9006-01C8ADFE6EB9}"/>
          </ac:cxnSpMkLst>
        </pc:cxnChg>
        <pc:cxnChg chg="add mod">
          <ac:chgData name="JUAN MANUEL LOZANO GIL" userId="618ed11e-cb2c-4b03-8ac9-a8cf52f924c9" providerId="ADAL" clId="{E1A82C2D-CEA3-4ADD-B72B-8C2A4C688D33}" dt="2023-07-19T10:13:27.635" v="187" actId="164"/>
          <ac:cxnSpMkLst>
            <pc:docMk/>
            <pc:sldMk cId="2860491393" sldId="258"/>
            <ac:cxnSpMk id="60" creationId="{9CDADBC7-925D-21BE-C3DE-DAAD8599AD49}"/>
          </ac:cxnSpMkLst>
        </pc:cxnChg>
        <pc:cxnChg chg="add mod">
          <ac:chgData name="JUAN MANUEL LOZANO GIL" userId="618ed11e-cb2c-4b03-8ac9-a8cf52f924c9" providerId="ADAL" clId="{E1A82C2D-CEA3-4ADD-B72B-8C2A4C688D33}" dt="2023-07-19T10:13:27.635" v="187" actId="164"/>
          <ac:cxnSpMkLst>
            <pc:docMk/>
            <pc:sldMk cId="2860491393" sldId="258"/>
            <ac:cxnSpMk id="61" creationId="{3F57266D-F57A-985B-D335-622D8C902424}"/>
          </ac:cxnSpMkLst>
        </pc:cxnChg>
      </pc:sldChg>
      <pc:sldMasterChg chg="modSp modSldLayout">
        <pc:chgData name="JUAN MANUEL LOZANO GIL" userId="618ed11e-cb2c-4b03-8ac9-a8cf52f924c9" providerId="ADAL" clId="{E1A82C2D-CEA3-4ADD-B72B-8C2A4C688D33}" dt="2023-07-19T10:05:43.142" v="40"/>
        <pc:sldMasterMkLst>
          <pc:docMk/>
          <pc:sldMasterMk cId="3039592353" sldId="2147483648"/>
        </pc:sldMasterMkLst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2" creationId="{D0640B11-C415-060F-5D32-F6A7C4019A33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3" creationId="{7D356EEB-5460-227F-04F9-AABC1DDB00A7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4" creationId="{A009BE39-3D56-CD14-9C93-3EC8EA39D8C4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5" creationId="{9518854D-24CD-9798-5DA5-EDAF1903338F}"/>
          </ac:spMkLst>
        </pc:spChg>
        <pc:spChg chg="mod">
          <ac:chgData name="JUAN MANUEL LOZANO GIL" userId="618ed11e-cb2c-4b03-8ac9-a8cf52f924c9" providerId="ADAL" clId="{E1A82C2D-CEA3-4ADD-B72B-8C2A4C688D33}" dt="2023-07-19T10:05:43.142" v="40"/>
          <ac:spMkLst>
            <pc:docMk/>
            <pc:sldMasterMk cId="3039592353" sldId="2147483648"/>
            <ac:spMk id="6" creationId="{146665AB-1EE8-A0BE-8552-352FD853ED2D}"/>
          </ac:spMkLst>
        </pc:sp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3013913324" sldId="2147483649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013913324" sldId="2147483649"/>
              <ac:spMk id="2" creationId="{B953659A-3084-BAC3-9841-B815F0690E2C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013913324" sldId="2147483649"/>
              <ac:spMk id="3" creationId="{2AEB07D3-C99D-82ED-CAB1-A424FD192119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109533071" sldId="2147483651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109533071" sldId="2147483651"/>
              <ac:spMk id="2" creationId="{D404A9DA-EA0B-382E-3095-DC0880AD2CC1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109533071" sldId="2147483651"/>
              <ac:spMk id="3" creationId="{F9883091-E81C-B2AD-8BF9-758DFA5C75BE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3786158922" sldId="2147483652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786158922" sldId="2147483652"/>
              <ac:spMk id="3" creationId="{6C3E7F25-F036-D4DC-FDD9-5C89596AA334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786158922" sldId="2147483652"/>
              <ac:spMk id="4" creationId="{ED705EEA-E05F-ACE8-CD22-84072E570E23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3503595258" sldId="2147483653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2" creationId="{BA14E5FF-E825-B1FF-F325-28E1E868CBF9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3" creationId="{BBB2797D-8219-B72D-5B5D-FA7853C2DA5F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4" creationId="{769191C9-8368-CA14-27E2-D11080490B50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5" creationId="{FDD55E15-1EA3-8442-131B-AD61AE9BF700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3503595258" sldId="2147483653"/>
              <ac:spMk id="6" creationId="{78A75DBE-964B-4ECC-5C1B-2C4D0F04DEE5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298067336" sldId="2147483656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98067336" sldId="2147483656"/>
              <ac:spMk id="2" creationId="{868C1FFA-E667-44D4-42C0-B6EAC0B3CC7B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98067336" sldId="2147483656"/>
              <ac:spMk id="3" creationId="{0A8DED82-2E5E-22CA-72AF-6070552A09EA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98067336" sldId="2147483656"/>
              <ac:spMk id="4" creationId="{252E4A58-963D-A2CC-6745-24332F6BED55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2726528857" sldId="2147483657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26528857" sldId="2147483657"/>
              <ac:spMk id="2" creationId="{11532E81-C183-8360-F5CF-809076B8F5F8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26528857" sldId="2147483657"/>
              <ac:spMk id="3" creationId="{F25D7820-9E80-65A8-AACC-68C96DEA2996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26528857" sldId="2147483657"/>
              <ac:spMk id="4" creationId="{D3A3D3C3-A12C-FA91-361C-530ABAFF040D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5:43.142" v="40"/>
          <pc:sldLayoutMkLst>
            <pc:docMk/>
            <pc:sldMasterMk cId="3039592353" sldId="2147483648"/>
            <pc:sldLayoutMk cId="2792281560" sldId="2147483659"/>
          </pc:sldLayoutMkLst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92281560" sldId="2147483659"/>
              <ac:spMk id="2" creationId="{0CAFFAB5-12E6-631A-DBB5-3EDADB204613}"/>
            </ac:spMkLst>
          </pc:spChg>
          <pc:spChg chg="mod">
            <ac:chgData name="JUAN MANUEL LOZANO GIL" userId="618ed11e-cb2c-4b03-8ac9-a8cf52f924c9" providerId="ADAL" clId="{E1A82C2D-CEA3-4ADD-B72B-8C2A4C688D33}" dt="2023-07-19T10:05:43.142" v="40"/>
            <ac:spMkLst>
              <pc:docMk/>
              <pc:sldMasterMk cId="3039592353" sldId="2147483648"/>
              <pc:sldLayoutMk cId="2792281560" sldId="2147483659"/>
              <ac:spMk id="3" creationId="{4BC6DC10-7FD9-B031-D83F-E463E3807EA6}"/>
            </ac:spMkLst>
          </pc:spChg>
        </pc:sldLayoutChg>
      </pc:sldMasterChg>
      <pc:sldMasterChg chg="modSp modSldLayout">
        <pc:chgData name="JUAN MANUEL LOZANO GIL" userId="618ed11e-cb2c-4b03-8ac9-a8cf52f924c9" providerId="ADAL" clId="{E1A82C2D-CEA3-4ADD-B72B-8C2A4C688D33}" dt="2023-07-19T10:08:57.717" v="113"/>
        <pc:sldMasterMkLst>
          <pc:docMk/>
          <pc:sldMasterMk cId="3108211256" sldId="2147483660"/>
        </pc:sldMasterMkLst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2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3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4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5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717" v="113"/>
          <ac:spMkLst>
            <pc:docMk/>
            <pc:sldMasterMk cId="3108211256" sldId="2147483660"/>
            <ac:spMk id="6" creationId="{00000000-0000-0000-0000-000000000000}"/>
          </ac:spMkLst>
        </pc:sp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1478480377" sldId="2147483661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478480377" sldId="2147483661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478480377" sldId="2147483661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3044350121" sldId="2147483663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3044350121" sldId="2147483663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3044350121" sldId="2147483663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682965052" sldId="2147483664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82965052" sldId="2147483664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82965052" sldId="2147483664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2225490895" sldId="2147483665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4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5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2225490895" sldId="2147483665"/>
              <ac:spMk id="6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633576424" sldId="2147483668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33576424" sldId="2147483668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33576424" sldId="2147483668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633576424" sldId="2147483668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1138390491" sldId="2147483669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138390491" sldId="2147483669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138390491" sldId="2147483669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138390491" sldId="2147483669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717" v="113"/>
          <pc:sldLayoutMkLst>
            <pc:docMk/>
            <pc:sldMasterMk cId="3108211256" sldId="2147483660"/>
            <pc:sldLayoutMk cId="1203963660" sldId="2147483671"/>
          </pc:sldLayoutMkLst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203963660" sldId="2147483671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717" v="113"/>
            <ac:spMkLst>
              <pc:docMk/>
              <pc:sldMasterMk cId="3108211256" sldId="2147483660"/>
              <pc:sldLayoutMk cId="1203963660" sldId="2147483671"/>
              <ac:spMk id="3" creationId="{00000000-0000-0000-0000-000000000000}"/>
            </ac:spMkLst>
          </pc:spChg>
        </pc:sldLayoutChg>
      </pc:sldMasterChg>
      <pc:sldMasterChg chg="modSp modSldLayout">
        <pc:chgData name="JUAN MANUEL LOZANO GIL" userId="618ed11e-cb2c-4b03-8ac9-a8cf52f924c9" providerId="ADAL" clId="{E1A82C2D-CEA3-4ADD-B72B-8C2A4C688D33}" dt="2023-07-19T10:08:57.481" v="112"/>
        <pc:sldMasterMkLst>
          <pc:docMk/>
          <pc:sldMasterMk cId="2488454685" sldId="2147483672"/>
        </pc:sldMasterMkLst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2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3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4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5" creationId="{00000000-0000-0000-0000-000000000000}"/>
          </ac:spMkLst>
        </pc:spChg>
        <pc:spChg chg="mod">
          <ac:chgData name="JUAN MANUEL LOZANO GIL" userId="618ed11e-cb2c-4b03-8ac9-a8cf52f924c9" providerId="ADAL" clId="{E1A82C2D-CEA3-4ADD-B72B-8C2A4C688D33}" dt="2023-07-19T10:08:57.481" v="112"/>
          <ac:spMkLst>
            <pc:docMk/>
            <pc:sldMasterMk cId="2488454685" sldId="2147483672"/>
            <ac:spMk id="6" creationId="{00000000-0000-0000-0000-000000000000}"/>
          </ac:spMkLst>
        </pc:sp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280496838" sldId="2147483673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280496838" sldId="2147483673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280496838" sldId="2147483673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603214847" sldId="2147483675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03214847" sldId="2147483675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03214847" sldId="2147483675"/>
              <ac:spMk id="3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3938553646" sldId="2147483676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3938553646" sldId="2147483676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3938553646" sldId="2147483676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75467544" sldId="2147483677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4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5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75467544" sldId="2147483677"/>
              <ac:spMk id="6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441035540" sldId="2147483680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441035540" sldId="2147483680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441035540" sldId="2147483680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441035540" sldId="2147483680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1678088751" sldId="2147483681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78088751" sldId="2147483681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78088751" sldId="2147483681"/>
              <ac:spMk id="3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1678088751" sldId="2147483681"/>
              <ac:spMk id="4" creationId="{00000000-0000-0000-0000-000000000000}"/>
            </ac:spMkLst>
          </pc:spChg>
        </pc:sldLayoutChg>
        <pc:sldLayoutChg chg="modSp">
          <pc:chgData name="JUAN MANUEL LOZANO GIL" userId="618ed11e-cb2c-4b03-8ac9-a8cf52f924c9" providerId="ADAL" clId="{E1A82C2D-CEA3-4ADD-B72B-8C2A4C688D33}" dt="2023-07-19T10:08:57.481" v="112"/>
          <pc:sldLayoutMkLst>
            <pc:docMk/>
            <pc:sldMasterMk cId="2488454685" sldId="2147483672"/>
            <pc:sldLayoutMk cId="4120903828" sldId="2147483683"/>
          </pc:sldLayoutMkLst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4120903828" sldId="2147483683"/>
              <ac:spMk id="2" creationId="{00000000-0000-0000-0000-000000000000}"/>
            </ac:spMkLst>
          </pc:spChg>
          <pc:spChg chg="mod">
            <ac:chgData name="JUAN MANUEL LOZANO GIL" userId="618ed11e-cb2c-4b03-8ac9-a8cf52f924c9" providerId="ADAL" clId="{E1A82C2D-CEA3-4ADD-B72B-8C2A4C688D33}" dt="2023-07-19T10:08:57.481" v="112"/>
            <ac:spMkLst>
              <pc:docMk/>
              <pc:sldMasterMk cId="2488454685" sldId="2147483672"/>
              <pc:sldLayoutMk cId="4120903828" sldId="2147483683"/>
              <ac:spMk id="3" creationId="{00000000-0000-0000-0000-000000000000}"/>
            </ac:spMkLst>
          </pc:spChg>
        </pc:sldLayoutChg>
      </pc:sldMasterChg>
    </pc:docChg>
  </pc:docChgLst>
  <pc:docChgLst>
    <pc:chgData name="JUAN MANUEL LOZANO GIL" userId="618ed11e-cb2c-4b03-8ac9-a8cf52f924c9" providerId="ADAL" clId="{386DC46B-41D5-40B2-A6A2-885422854031}"/>
    <pc:docChg chg="undo redo custSel modSld">
      <pc:chgData name="JUAN MANUEL LOZANO GIL" userId="618ed11e-cb2c-4b03-8ac9-a8cf52f924c9" providerId="ADAL" clId="{386DC46B-41D5-40B2-A6A2-885422854031}" dt="2022-10-24T11:18:15.923" v="393" actId="20577"/>
      <pc:docMkLst>
        <pc:docMk/>
      </pc:docMkLst>
      <pc:sldChg chg="addSp delSp modSp mod">
        <pc:chgData name="JUAN MANUEL LOZANO GIL" userId="618ed11e-cb2c-4b03-8ac9-a8cf52f924c9" providerId="ADAL" clId="{386DC46B-41D5-40B2-A6A2-885422854031}" dt="2022-10-24T11:18:15.923" v="393" actId="20577"/>
        <pc:sldMkLst>
          <pc:docMk/>
          <pc:sldMk cId="3278798907" sldId="256"/>
        </pc:sldMkLst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" creationId="{9B2CD68D-1162-BD7B-04C0-5EA88A3A3A9E}"/>
          </ac:spMkLst>
        </pc:spChg>
        <pc:spChg chg="mod">
          <ac:chgData name="JUAN MANUEL LOZANO GIL" userId="618ed11e-cb2c-4b03-8ac9-a8cf52f924c9" providerId="ADAL" clId="{386DC46B-41D5-40B2-A6A2-885422854031}" dt="2022-10-24T11:16:37.550" v="331" actId="1076"/>
          <ac:spMkLst>
            <pc:docMk/>
            <pc:sldMk cId="3278798907" sldId="256"/>
            <ac:spMk id="11" creationId="{77509BA6-8B87-6BEF-46F0-E18A14B39EB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28" creationId="{6FE0C5C9-EFFF-D8EF-6794-40A8A3B3FDB4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3" creationId="{69A63828-D0E6-C303-7DAB-022683830F6B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4" creationId="{EC910EE7-D130-C396-5EB0-59BC79EF144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6" creationId="{7AACA306-674B-1C70-235C-CCCCACCF8049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7" creationId="{40B58694-FE1E-CCFD-0228-0AA311C76DF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8" creationId="{BD6261B1-AF8A-600C-86F5-AC0B8B5DEF74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39" creationId="{31A25F3E-6C68-F161-3D0F-F200414B1A30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40" creationId="{3638FD81-EEFB-3605-A26A-B156E0406D02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41" creationId="{BBD7C682-AC1C-3AC2-4AB1-81C157A2132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60" creationId="{43D45783-35DE-6202-F1E7-93A721736D85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61" creationId="{29E10A20-1F20-FCB7-63FA-D9EDDADD0B1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66" creationId="{6E9FCBC0-E68F-83A1-B005-C1EF0A517685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15" creationId="{A06224D5-42DC-2220-0691-7BB9BAC19105}"/>
          </ac:spMkLst>
        </pc:spChg>
        <pc:spChg chg="mod">
          <ac:chgData name="JUAN MANUEL LOZANO GIL" userId="618ed11e-cb2c-4b03-8ac9-a8cf52f924c9" providerId="ADAL" clId="{386DC46B-41D5-40B2-A6A2-885422854031}" dt="2022-10-24T11:18:11.089" v="387" actId="20577"/>
          <ac:spMkLst>
            <pc:docMk/>
            <pc:sldMk cId="3278798907" sldId="256"/>
            <ac:spMk id="118" creationId="{4E9B62DF-D897-38D9-F600-2AB133946753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21" creationId="{FC76A523-D22C-9CE9-86C0-3291B5E55716}"/>
          </ac:spMkLst>
        </pc:spChg>
        <pc:spChg chg="mod">
          <ac:chgData name="JUAN MANUEL LOZANO GIL" userId="618ed11e-cb2c-4b03-8ac9-a8cf52f924c9" providerId="ADAL" clId="{386DC46B-41D5-40B2-A6A2-885422854031}" dt="2022-10-24T11:18:15.923" v="393" actId="20577"/>
          <ac:spMkLst>
            <pc:docMk/>
            <pc:sldMk cId="3278798907" sldId="256"/>
            <ac:spMk id="123" creationId="{ADB6E049-3E35-ED91-D48D-5CDE07739EFB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25" creationId="{ADB6E049-3E35-ED91-D48D-5CDE07739EFB}"/>
          </ac:spMkLst>
        </pc:spChg>
        <pc:spChg chg="mod">
          <ac:chgData name="JUAN MANUEL LOZANO GIL" userId="618ed11e-cb2c-4b03-8ac9-a8cf52f924c9" providerId="ADAL" clId="{386DC46B-41D5-40B2-A6A2-885422854031}" dt="2022-10-24T11:18:02.974" v="382" actId="20577"/>
          <ac:spMkLst>
            <pc:docMk/>
            <pc:sldMk cId="3278798907" sldId="256"/>
            <ac:spMk id="128" creationId="{4DDF8618-B36F-119A-CA7A-EE88C352364F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29" creationId="{7F1575BB-08B9-8701-715E-E77B24154E6A}"/>
          </ac:spMkLst>
        </pc:spChg>
        <pc:spChg chg="mod topLvl">
          <ac:chgData name="JUAN MANUEL LOZANO GIL" userId="618ed11e-cb2c-4b03-8ac9-a8cf52f924c9" providerId="ADAL" clId="{386DC46B-41D5-40B2-A6A2-885422854031}" dt="2022-10-20T14:22:15.187" v="260" actId="1076"/>
          <ac:spMkLst>
            <pc:docMk/>
            <pc:sldMk cId="3278798907" sldId="256"/>
            <ac:spMk id="130" creationId="{106C1AF1-94C5-F629-15FD-623F681A8C50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31" creationId="{1865E9DC-E288-5D5B-E8CE-3964A7FF498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32" creationId="{3340EB4D-D450-3A93-EC03-0A0352BE4422}"/>
          </ac:spMkLst>
        </pc:spChg>
        <pc:spChg chg="del mod topLvl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137" creationId="{390F851F-D000-3AC9-06B7-0086914887CC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37" creationId="{48ED9661-A95F-EB2D-3C34-8D798C4666EB}"/>
          </ac:spMkLst>
        </pc:spChg>
        <pc:spChg chg="del mod topLvl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138" creationId="{9B8EB6DE-BB15-39CA-5B0F-0224CBC5D349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40" creationId="{28CA052F-27E2-63EB-F3F6-80FE3D734D00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42" creationId="{4DDF8618-B36F-119A-CA7A-EE88C352364F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43" creationId="{804C4DA3-BFC8-7599-5D2F-611F69F9E7D6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55" creationId="{C16583F2-6CA4-58DD-020E-AF1AA81B75F4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88" creationId="{F7D03FBE-A81A-6BC4-1C33-3A183B86791D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0" creationId="{FAEC6570-2D19-B589-D262-D645471A2FA8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1" creationId="{913B9BB6-4065-0AE0-54C4-70791E5BB21A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3" creationId="{A5FAB260-0C17-FE6B-E06E-4D090A964AED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4" creationId="{34F0A8C1-B00F-FC42-FA0E-7F64DFB6A559}"/>
          </ac:spMkLst>
        </pc:spChg>
        <pc:spChg chg="mod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6" creationId="{6B5EAE6D-5B4A-9AA1-129A-AAA3DD980E3A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197" creationId="{DE770029-C13A-362F-EA6B-452F863DBC8A}"/>
          </ac:spMkLst>
        </pc:spChg>
        <pc:spChg chg="add del mod">
          <ac:chgData name="JUAN MANUEL LOZANO GIL" userId="618ed11e-cb2c-4b03-8ac9-a8cf52f924c9" providerId="ADAL" clId="{386DC46B-41D5-40B2-A6A2-885422854031}" dt="2022-10-20T14:20:01.245" v="186" actId="478"/>
          <ac:spMkLst>
            <pc:docMk/>
            <pc:sldMk cId="3278798907" sldId="256"/>
            <ac:spMk id="199" creationId="{A7AD7E3A-B856-9E64-DF0B-E6A0B322067C}"/>
          </ac:spMkLst>
        </pc:spChg>
        <pc:spChg chg="add del mod">
          <ac:chgData name="JUAN MANUEL LOZANO GIL" userId="618ed11e-cb2c-4b03-8ac9-a8cf52f924c9" providerId="ADAL" clId="{386DC46B-41D5-40B2-A6A2-885422854031}" dt="2022-10-20T14:20:13.054" v="188" actId="478"/>
          <ac:spMkLst>
            <pc:docMk/>
            <pc:sldMk cId="3278798907" sldId="256"/>
            <ac:spMk id="200" creationId="{537282EA-837B-E7EF-E08B-02EE580A566C}"/>
          </ac:spMkLst>
        </pc:spChg>
        <pc:spChg chg="mod topLvl">
          <ac:chgData name="JUAN MANUEL LOZANO GIL" userId="618ed11e-cb2c-4b03-8ac9-a8cf52f924c9" providerId="ADAL" clId="{386DC46B-41D5-40B2-A6A2-885422854031}" dt="2022-10-20T14:18:45.871" v="137" actId="165"/>
          <ac:spMkLst>
            <pc:docMk/>
            <pc:sldMk cId="3278798907" sldId="256"/>
            <ac:spMk id="201" creationId="{02190607-545A-EAEF-B8B5-30DDD473E609}"/>
          </ac:spMkLst>
        </pc:spChg>
        <pc:spChg chg="add del mod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201" creationId="{218272E8-6C89-A228-9D53-1F700DFE446A}"/>
          </ac:spMkLst>
        </pc:spChg>
        <pc:spChg chg="add del mod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202" creationId="{21713EA9-4EE6-F30C-8A08-973F58C66B40}"/>
          </ac:spMkLst>
        </pc:spChg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02" creationId="{71A1120A-ECF7-C944-D0A7-629ED2FD6F5D}"/>
          </ac:spMkLst>
        </pc:spChg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03" creationId="{2A665B5F-90E1-1DF7-3916-53928A302641}"/>
          </ac:spMkLst>
        </pc:spChg>
        <pc:spChg chg="add del mod">
          <ac:chgData name="JUAN MANUEL LOZANO GIL" userId="618ed11e-cb2c-4b03-8ac9-a8cf52f924c9" providerId="ADAL" clId="{386DC46B-41D5-40B2-A6A2-885422854031}" dt="2022-10-20T14:20:25.661" v="193" actId="478"/>
          <ac:spMkLst>
            <pc:docMk/>
            <pc:sldMk cId="3278798907" sldId="256"/>
            <ac:spMk id="203" creationId="{9B959AB3-A4D4-970E-F7C7-767207857FDA}"/>
          </ac:spMkLst>
        </pc:spChg>
        <pc:spChg chg="add mod">
          <ac:chgData name="JUAN MANUEL LOZANO GIL" userId="618ed11e-cb2c-4b03-8ac9-a8cf52f924c9" providerId="ADAL" clId="{386DC46B-41D5-40B2-A6A2-885422854031}" dt="2022-10-20T14:21:35.566" v="238" actId="164"/>
          <ac:spMkLst>
            <pc:docMk/>
            <pc:sldMk cId="3278798907" sldId="256"/>
            <ac:spMk id="209" creationId="{0DCE5BAF-A005-6A19-35A8-D034638BD2A3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4" creationId="{096E130A-A6D5-3C57-16B3-BA6468B18430}"/>
          </ac:spMkLst>
        </pc:spChg>
        <pc:spChg chg="add del mod">
          <ac:chgData name="JUAN MANUEL LOZANO GIL" userId="618ed11e-cb2c-4b03-8ac9-a8cf52f924c9" providerId="ADAL" clId="{386DC46B-41D5-40B2-A6A2-885422854031}" dt="2022-10-20T14:21:22.265" v="234" actId="478"/>
          <ac:spMkLst>
            <pc:docMk/>
            <pc:sldMk cId="3278798907" sldId="256"/>
            <ac:spMk id="214" creationId="{0FF539EF-A098-4B9E-EAA1-B311F8B58E57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5" creationId="{6A5A3F08-CABA-0898-E275-1EF13EB458E9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6" creationId="{CC171BF4-3923-93D0-A2B7-A84907FFD4E7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17" creationId="{CE97B7D1-5542-35A6-3C5A-6E5AEB1C1B24}"/>
          </ac:spMkLst>
        </pc:spChg>
        <pc:spChg chg="mod">
          <ac:chgData name="JUAN MANUEL LOZANO GIL" userId="618ed11e-cb2c-4b03-8ac9-a8cf52f924c9" providerId="ADAL" clId="{386DC46B-41D5-40B2-A6A2-885422854031}" dt="2022-10-24T11:16:54.150" v="335" actId="1076"/>
          <ac:spMkLst>
            <pc:docMk/>
            <pc:sldMk cId="3278798907" sldId="256"/>
            <ac:spMk id="223" creationId="{2DE36C91-C97D-8322-64DF-0E5FE2EDE9A9}"/>
          </ac:spMkLst>
        </pc:spChg>
        <pc:spChg chg="mod">
          <ac:chgData name="JUAN MANUEL LOZANO GIL" userId="618ed11e-cb2c-4b03-8ac9-a8cf52f924c9" providerId="ADAL" clId="{386DC46B-41D5-40B2-A6A2-885422854031}" dt="2022-10-24T11:16:52.422" v="334" actId="1076"/>
          <ac:spMkLst>
            <pc:docMk/>
            <pc:sldMk cId="3278798907" sldId="256"/>
            <ac:spMk id="224" creationId="{503574D0-7BC7-B436-928C-75A3B1B06FF9}"/>
          </ac:spMkLst>
        </pc:spChg>
        <pc:spChg chg="mod">
          <ac:chgData name="JUAN MANUEL LOZANO GIL" userId="618ed11e-cb2c-4b03-8ac9-a8cf52f924c9" providerId="ADAL" clId="{386DC46B-41D5-40B2-A6A2-885422854031}" dt="2022-10-24T11:16:55.822" v="336" actId="1076"/>
          <ac:spMkLst>
            <pc:docMk/>
            <pc:sldMk cId="3278798907" sldId="256"/>
            <ac:spMk id="225" creationId="{71CD88CA-8D55-15DC-E634-2F94E77AA54E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26" creationId="{37181708-2CFA-36F6-E5C6-076FD5BBA641}"/>
          </ac:spMkLst>
        </pc:spChg>
        <pc:spChg chg="del mod">
          <ac:chgData name="JUAN MANUEL LOZANO GIL" userId="618ed11e-cb2c-4b03-8ac9-a8cf52f924c9" providerId="ADAL" clId="{386DC46B-41D5-40B2-A6A2-885422854031}" dt="2022-10-20T14:23:36.350" v="322" actId="478"/>
          <ac:spMkLst>
            <pc:docMk/>
            <pc:sldMk cId="3278798907" sldId="256"/>
            <ac:spMk id="226" creationId="{7CE19FDC-6765-7356-80A2-3A7989E270FD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30" creationId="{D21C704E-B1F3-C166-FDBA-FB8F1A731670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33" creationId="{8A38D3C8-C0E0-5381-3C57-739D236EE3FF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35" creationId="{26B41E0A-C7CD-8586-90D4-F0E3A6F906C7}"/>
          </ac:spMkLst>
        </pc:spChg>
        <pc:spChg chg="mod">
          <ac:chgData name="JUAN MANUEL LOZANO GIL" userId="618ed11e-cb2c-4b03-8ac9-a8cf52f924c9" providerId="ADAL" clId="{386DC46B-41D5-40B2-A6A2-885422854031}" dt="2022-10-20T14:00:58.511" v="120" actId="14100"/>
          <ac:spMkLst>
            <pc:docMk/>
            <pc:sldMk cId="3278798907" sldId="256"/>
            <ac:spMk id="237" creationId="{ADC8A64C-7A54-ED6F-28BB-0B538EC26499}"/>
          </ac:spMkLst>
        </pc:spChg>
        <pc:spChg chg="mod">
          <ac:chgData name="JUAN MANUEL LOZANO GIL" userId="618ed11e-cb2c-4b03-8ac9-a8cf52f924c9" providerId="ADAL" clId="{386DC46B-41D5-40B2-A6A2-885422854031}" dt="2022-10-20T14:23:01.313" v="272"/>
          <ac:spMkLst>
            <pc:docMk/>
            <pc:sldMk cId="3278798907" sldId="256"/>
            <ac:spMk id="238" creationId="{2DE36C91-C97D-8322-64DF-0E5FE2EDE9A9}"/>
          </ac:spMkLst>
        </pc:spChg>
        <pc:spChg chg="mod">
          <ac:chgData name="JUAN MANUEL LOZANO GIL" userId="618ed11e-cb2c-4b03-8ac9-a8cf52f924c9" providerId="ADAL" clId="{386DC46B-41D5-40B2-A6A2-885422854031}" dt="2022-10-20T14:00:58.511" v="120" actId="14100"/>
          <ac:spMkLst>
            <pc:docMk/>
            <pc:sldMk cId="3278798907" sldId="256"/>
            <ac:spMk id="239" creationId="{AAE3D7B6-9C43-9684-18F2-26E8D2B95261}"/>
          </ac:spMkLst>
        </pc:spChg>
        <pc:spChg chg="mod">
          <ac:chgData name="JUAN MANUEL LOZANO GIL" userId="618ed11e-cb2c-4b03-8ac9-a8cf52f924c9" providerId="ADAL" clId="{386DC46B-41D5-40B2-A6A2-885422854031}" dt="2022-10-20T14:23:01.313" v="272"/>
          <ac:spMkLst>
            <pc:docMk/>
            <pc:sldMk cId="3278798907" sldId="256"/>
            <ac:spMk id="240" creationId="{503574D0-7BC7-B436-928C-75A3B1B06FF9}"/>
          </ac:spMkLst>
        </pc:spChg>
        <pc:spChg chg="mod">
          <ac:chgData name="JUAN MANUEL LOZANO GIL" userId="618ed11e-cb2c-4b03-8ac9-a8cf52f924c9" providerId="ADAL" clId="{386DC46B-41D5-40B2-A6A2-885422854031}" dt="2022-10-20T14:00:58.511" v="120" actId="14100"/>
          <ac:spMkLst>
            <pc:docMk/>
            <pc:sldMk cId="3278798907" sldId="256"/>
            <ac:spMk id="241" creationId="{1785CE50-920E-0E03-5AAF-BC6BB3907611}"/>
          </ac:spMkLst>
        </pc:spChg>
        <pc:spChg chg="mod">
          <ac:chgData name="JUAN MANUEL LOZANO GIL" userId="618ed11e-cb2c-4b03-8ac9-a8cf52f924c9" providerId="ADAL" clId="{386DC46B-41D5-40B2-A6A2-885422854031}" dt="2022-10-20T14:23:01.313" v="272"/>
          <ac:spMkLst>
            <pc:docMk/>
            <pc:sldMk cId="3278798907" sldId="256"/>
            <ac:spMk id="242" creationId="{71CD88CA-8D55-15DC-E634-2F94E77AA54E}"/>
          </ac:spMkLst>
        </pc:spChg>
        <pc:spChg chg="add mod">
          <ac:chgData name="JUAN MANUEL LOZANO GIL" userId="618ed11e-cb2c-4b03-8ac9-a8cf52f924c9" providerId="ADAL" clId="{386DC46B-41D5-40B2-A6A2-885422854031}" dt="2022-10-20T14:00:25.512" v="112" actId="164"/>
          <ac:spMkLst>
            <pc:docMk/>
            <pc:sldMk cId="3278798907" sldId="256"/>
            <ac:spMk id="244" creationId="{870F9BB4-5E94-83CC-2FBF-D612747F3FF6}"/>
          </ac:spMkLst>
        </pc:spChg>
        <pc:spChg chg="add mod">
          <ac:chgData name="JUAN MANUEL LOZANO GIL" userId="618ed11e-cb2c-4b03-8ac9-a8cf52f924c9" providerId="ADAL" clId="{386DC46B-41D5-40B2-A6A2-885422854031}" dt="2022-10-20T14:00:43.272" v="117" actId="164"/>
          <ac:spMkLst>
            <pc:docMk/>
            <pc:sldMk cId="3278798907" sldId="256"/>
            <ac:spMk id="247" creationId="{9EEFF06B-53DF-E558-78A1-3CA16349A03D}"/>
          </ac:spMkLst>
        </pc:spChg>
        <pc:spChg chg="add mod">
          <ac:chgData name="JUAN MANUEL LOZANO GIL" userId="618ed11e-cb2c-4b03-8ac9-a8cf52f924c9" providerId="ADAL" clId="{386DC46B-41D5-40B2-A6A2-885422854031}" dt="2022-10-20T14:23:53.133" v="327" actId="1076"/>
          <ac:spMkLst>
            <pc:docMk/>
            <pc:sldMk cId="3278798907" sldId="256"/>
            <ac:spMk id="250" creationId="{7AA6AC05-9DD5-D083-63F3-9B40C1DA53F2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6" creationId="{E4AAB65D-28F3-7387-E46C-AC718116A4F8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7" creationId="{A78334C1-347E-48A5-D9B5-2E29FE69F1AD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8" creationId="{303F0DA0-E982-90D3-821F-36CC752D532A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59" creationId="{CD1D3C08-86C8-2ABF-8E87-74B9D152F1E1}"/>
          </ac:spMkLst>
        </pc:spChg>
        <pc:spChg chg="add mod topLvl">
          <ac:chgData name="JUAN MANUEL LOZANO GIL" userId="618ed11e-cb2c-4b03-8ac9-a8cf52f924c9" providerId="ADAL" clId="{386DC46B-41D5-40B2-A6A2-885422854031}" dt="2022-10-20T13:59:45.783" v="92" actId="164"/>
          <ac:spMkLst>
            <pc:docMk/>
            <pc:sldMk cId="3278798907" sldId="256"/>
            <ac:spMk id="260" creationId="{E902CA14-68A4-48CE-1B2D-A3D65A140A8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2" creationId="{61619F8F-3148-3FB1-A992-42C52C26E6D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3" creationId="{83497D59-873D-B5EF-13DC-DE7578E1B815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4" creationId="{6476E2A8-777C-3F20-1FFC-2A345EB173E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5" creationId="{8FF2B169-E400-A10F-C71A-EA26D4458792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6" creationId="{42628301-73F9-EDDA-03EA-60856626D61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7" creationId="{B5786838-D9DE-DB01-6B82-56697112CD68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8" creationId="{956DED26-4DF7-EFA5-9DA1-4E833350B141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69" creationId="{57180217-E868-B289-86B8-DED2CA48CA67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0" creationId="{0E6DF3B9-2C17-94F4-1CC3-FA14E40A6C34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1" creationId="{F45A74E9-7C7D-2FC2-AD03-B6FAD86BBB96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2" creationId="{1E2CA450-A78A-2B73-8762-4FEF2EF539D5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3" creationId="{EB804E63-8E46-77FB-A36C-06EDC167C2C6}"/>
          </ac:spMkLst>
        </pc:spChg>
        <pc:spChg chg="mod">
          <ac:chgData name="JUAN MANUEL LOZANO GIL" userId="618ed11e-cb2c-4b03-8ac9-a8cf52f924c9" providerId="ADAL" clId="{386DC46B-41D5-40B2-A6A2-885422854031}" dt="2022-10-20T13:59:59.378" v="96"/>
          <ac:spMkLst>
            <pc:docMk/>
            <pc:sldMk cId="3278798907" sldId="256"/>
            <ac:spMk id="274" creationId="{13AAFE3B-F8BF-9DE7-AC2E-20F8EB375353}"/>
          </ac:spMkLst>
        </pc:spChg>
        <pc:spChg chg="add mod">
          <ac:chgData name="JUAN MANUEL LOZANO GIL" userId="618ed11e-cb2c-4b03-8ac9-a8cf52f924c9" providerId="ADAL" clId="{386DC46B-41D5-40B2-A6A2-885422854031}" dt="2022-10-24T11:17:45.782" v="377" actId="1076"/>
          <ac:spMkLst>
            <pc:docMk/>
            <pc:sldMk cId="3278798907" sldId="256"/>
            <ac:spMk id="330" creationId="{3B65D7B5-A3E2-577C-C8DD-AA8F8F51F348}"/>
          </ac:spMkLst>
        </pc:spChg>
        <pc:grpChg chg="add mod">
          <ac:chgData name="JUAN MANUEL LOZANO GIL" userId="618ed11e-cb2c-4b03-8ac9-a8cf52f924c9" providerId="ADAL" clId="{386DC46B-41D5-40B2-A6A2-885422854031}" dt="2022-10-20T14:21:40.427" v="239" actId="1076"/>
          <ac:grpSpMkLst>
            <pc:docMk/>
            <pc:sldMk cId="3278798907" sldId="256"/>
            <ac:grpSpMk id="5" creationId="{30313194-4B88-D4FC-5F98-5FAD5B936A2E}"/>
          </ac:grpSpMkLst>
        </pc:grpChg>
        <pc:grpChg chg="mod">
          <ac:chgData name="JUAN MANUEL LOZANO GIL" userId="618ed11e-cb2c-4b03-8ac9-a8cf52f924c9" providerId="ADAL" clId="{386DC46B-41D5-40B2-A6A2-885422854031}" dt="2022-10-24T11:17:51.384" v="378" actId="1076"/>
          <ac:grpSpMkLst>
            <pc:docMk/>
            <pc:sldMk cId="3278798907" sldId="256"/>
            <ac:grpSpMk id="12" creationId="{FD2B8B51-4257-7A31-F5BD-6F4E817CE3D7}"/>
          </ac:grpSpMkLst>
        </pc:grpChg>
        <pc:grpChg chg="mod">
          <ac:chgData name="JUAN MANUEL LOZANO GIL" userId="618ed11e-cb2c-4b03-8ac9-a8cf52f924c9" providerId="ADAL" clId="{386DC46B-41D5-40B2-A6A2-885422854031}" dt="2022-10-24T11:17:51.384" v="378" actId="1076"/>
          <ac:grpSpMkLst>
            <pc:docMk/>
            <pc:sldMk cId="3278798907" sldId="256"/>
            <ac:grpSpMk id="14" creationId="{A3B00373-ECCE-3F0D-9077-8FAD8A5CD4E7}"/>
          </ac:grpSpMkLst>
        </pc:grpChg>
        <pc:grpChg chg="mod">
          <ac:chgData name="JUAN MANUEL LOZANO GIL" userId="618ed11e-cb2c-4b03-8ac9-a8cf52f924c9" providerId="ADAL" clId="{386DC46B-41D5-40B2-A6A2-885422854031}" dt="2022-10-24T11:17:51.384" v="378" actId="1076"/>
          <ac:grpSpMkLst>
            <pc:docMk/>
            <pc:sldMk cId="3278798907" sldId="256"/>
            <ac:grpSpMk id="23" creationId="{C689D05A-6159-D3DD-CE48-3B7FF27422C9}"/>
          </ac:grpSpMkLst>
        </pc:grpChg>
        <pc:grpChg chg="del mod topLvl">
          <ac:chgData name="JUAN MANUEL LOZANO GIL" userId="618ed11e-cb2c-4b03-8ac9-a8cf52f924c9" providerId="ADAL" clId="{386DC46B-41D5-40B2-A6A2-885422854031}" dt="2022-10-20T14:20:25.661" v="193" actId="478"/>
          <ac:grpSpMkLst>
            <pc:docMk/>
            <pc:sldMk cId="3278798907" sldId="256"/>
            <ac:grpSpMk id="23" creationId="{D913594C-D5D2-96BB-0977-AEA9E8447F49}"/>
          </ac:grpSpMkLst>
        </pc:grpChg>
        <pc:grpChg chg="mod topLvl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27" creationId="{C3D67D48-DBD6-F3C7-14EA-203AA1CEB286}"/>
          </ac:grpSpMkLst>
        </pc:grpChg>
        <pc:grpChg chg="mod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35" creationId="{5121F8BE-6AAD-93AE-7F46-DD245EED2E35}"/>
          </ac:grpSpMkLst>
        </pc:grpChg>
        <pc:grpChg chg="del mod topLvl">
          <ac:chgData name="JUAN MANUEL LOZANO GIL" userId="618ed11e-cb2c-4b03-8ac9-a8cf52f924c9" providerId="ADAL" clId="{386DC46B-41D5-40B2-A6A2-885422854031}" dt="2022-10-20T13:58:44.030" v="73" actId="165"/>
          <ac:grpSpMkLst>
            <pc:docMk/>
            <pc:sldMk cId="3278798907" sldId="256"/>
            <ac:grpSpMk id="121" creationId="{F93A7FC7-CC95-ECF6-E412-C4F69ED982DD}"/>
          </ac:grpSpMkLst>
        </pc:grpChg>
        <pc:grpChg chg="del mod">
          <ac:chgData name="JUAN MANUEL LOZANO GIL" userId="618ed11e-cb2c-4b03-8ac9-a8cf52f924c9" providerId="ADAL" clId="{386DC46B-41D5-40B2-A6A2-885422854031}" dt="2022-10-20T13:58:40.031" v="72" actId="165"/>
          <ac:grpSpMkLst>
            <pc:docMk/>
            <pc:sldMk cId="3278798907" sldId="256"/>
            <ac:grpSpMk id="125" creationId="{6B270B21-628C-F453-CA11-87D6C789E830}"/>
          </ac:grpSpMkLst>
        </pc:grpChg>
        <pc:grpChg chg="add del mod">
          <ac:chgData name="JUAN MANUEL LOZANO GIL" userId="618ed11e-cb2c-4b03-8ac9-a8cf52f924c9" providerId="ADAL" clId="{386DC46B-41D5-40B2-A6A2-885422854031}" dt="2022-10-20T13:59:29.367" v="88" actId="165"/>
          <ac:grpSpMkLst>
            <pc:docMk/>
            <pc:sldMk cId="3278798907" sldId="256"/>
            <ac:grpSpMk id="155" creationId="{A8ECDDAC-C8E6-16F1-C87B-DDB1461588F5}"/>
          </ac:grpSpMkLst>
        </pc:grpChg>
        <pc:grpChg chg="add mod">
          <ac:chgData name="JUAN MANUEL LOZANO GIL" userId="618ed11e-cb2c-4b03-8ac9-a8cf52f924c9" providerId="ADAL" clId="{386DC46B-41D5-40B2-A6A2-885422854031}" dt="2022-10-20T14:00:25.512" v="112" actId="164"/>
          <ac:grpSpMkLst>
            <pc:docMk/>
            <pc:sldMk cId="3278798907" sldId="256"/>
            <ac:grpSpMk id="156" creationId="{5C677AC8-3C01-91C1-D0CD-E62852EA011B}"/>
          </ac:grpSpMkLst>
        </pc:grpChg>
        <pc:grpChg chg="add mod">
          <ac:chgData name="JUAN MANUEL LOZANO GIL" userId="618ed11e-cb2c-4b03-8ac9-a8cf52f924c9" providerId="ADAL" clId="{386DC46B-41D5-40B2-A6A2-885422854031}" dt="2022-10-20T14:00:25.512" v="112" actId="164"/>
          <ac:grpSpMkLst>
            <pc:docMk/>
            <pc:sldMk cId="3278798907" sldId="256"/>
            <ac:grpSpMk id="157" creationId="{330B89BA-FF7E-0FA7-8141-B09FAFB82709}"/>
          </ac:grpSpMkLst>
        </pc:grpChg>
        <pc:grpChg chg="add mod">
          <ac:chgData name="JUAN MANUEL LOZANO GIL" userId="618ed11e-cb2c-4b03-8ac9-a8cf52f924c9" providerId="ADAL" clId="{386DC46B-41D5-40B2-A6A2-885422854031}" dt="2022-10-20T14:00:43.272" v="117" actId="164"/>
          <ac:grpSpMkLst>
            <pc:docMk/>
            <pc:sldMk cId="3278798907" sldId="256"/>
            <ac:grpSpMk id="185" creationId="{E6ACA5C0-119B-E861-E208-AC553AF53043}"/>
          </ac:grpSpMkLst>
        </pc:grpChg>
        <pc:grpChg chg="add mod">
          <ac:chgData name="JUAN MANUEL LOZANO GIL" userId="618ed11e-cb2c-4b03-8ac9-a8cf52f924c9" providerId="ADAL" clId="{386DC46B-41D5-40B2-A6A2-885422854031}" dt="2022-10-20T14:22:54.029" v="270" actId="14100"/>
          <ac:grpSpMkLst>
            <pc:docMk/>
            <pc:sldMk cId="3278798907" sldId="256"/>
            <ac:grpSpMk id="187" creationId="{B8A5B354-0C3C-948B-7552-8852D6F4978E}"/>
          </ac:grpSpMkLst>
        </pc:grpChg>
        <pc:grpChg chg="add del mod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188" creationId="{7A594213-BB89-0C86-54DC-251C0B1ECDF2}"/>
          </ac:grpSpMkLst>
        </pc:grpChg>
        <pc:grpChg chg="add mod">
          <ac:chgData name="JUAN MANUEL LOZANO GIL" userId="618ed11e-cb2c-4b03-8ac9-a8cf52f924c9" providerId="ADAL" clId="{386DC46B-41D5-40B2-A6A2-885422854031}" dt="2022-10-20T14:21:35.566" v="238" actId="164"/>
          <ac:grpSpMkLst>
            <pc:docMk/>
            <pc:sldMk cId="3278798907" sldId="256"/>
            <ac:grpSpMk id="189" creationId="{8ACC7B1E-E575-A5C9-001D-648B9DED9431}"/>
          </ac:grpSpMkLst>
        </pc:grpChg>
        <pc:grpChg chg="add del mod">
          <ac:chgData name="JUAN MANUEL LOZANO GIL" userId="618ed11e-cb2c-4b03-8ac9-a8cf52f924c9" providerId="ADAL" clId="{386DC46B-41D5-40B2-A6A2-885422854031}" dt="2022-10-20T14:19:29.165" v="148" actId="165"/>
          <ac:grpSpMkLst>
            <pc:docMk/>
            <pc:sldMk cId="3278798907" sldId="256"/>
            <ac:grpSpMk id="193" creationId="{3B65F110-4230-C43A-D519-8EBD9734CAF7}"/>
          </ac:grpSpMkLst>
        </pc:grpChg>
        <pc:grpChg chg="mod topLvl">
          <ac:chgData name="JUAN MANUEL LOZANO GIL" userId="618ed11e-cb2c-4b03-8ac9-a8cf52f924c9" providerId="ADAL" clId="{386DC46B-41D5-40B2-A6A2-885422854031}" dt="2022-10-20T14:18:45.871" v="137" actId="165"/>
          <ac:grpSpMkLst>
            <pc:docMk/>
            <pc:sldMk cId="3278798907" sldId="256"/>
            <ac:grpSpMk id="199" creationId="{A5E5CDB5-C751-0E14-2CF2-8CD6EEB4673D}"/>
          </ac:grpSpMkLst>
        </pc:grpChg>
        <pc:grpChg chg="add mod">
          <ac:chgData name="JUAN MANUEL LOZANO GIL" userId="618ed11e-cb2c-4b03-8ac9-a8cf52f924c9" providerId="ADAL" clId="{386DC46B-41D5-40B2-A6A2-885422854031}" dt="2022-10-20T14:23:34.238" v="321" actId="1038"/>
          <ac:grpSpMkLst>
            <pc:docMk/>
            <pc:sldMk cId="3278798907" sldId="256"/>
            <ac:grpSpMk id="234" creationId="{0698EFBC-52C6-C31A-D27C-3FE0C28EFB1B}"/>
          </ac:grpSpMkLst>
        </pc:grpChg>
        <pc:grpChg chg="mod">
          <ac:chgData name="JUAN MANUEL LOZANO GIL" userId="618ed11e-cb2c-4b03-8ac9-a8cf52f924c9" providerId="ADAL" clId="{386DC46B-41D5-40B2-A6A2-885422854031}" dt="2022-10-20T14:23:01.313" v="272"/>
          <ac:grpSpMkLst>
            <pc:docMk/>
            <pc:sldMk cId="3278798907" sldId="256"/>
            <ac:grpSpMk id="236" creationId="{BF6763EE-8ADD-24AF-582E-13C132599002}"/>
          </ac:grpSpMkLst>
        </pc:grpChg>
        <pc:grpChg chg="add mod topLvl">
          <ac:chgData name="JUAN MANUEL LOZANO GIL" userId="618ed11e-cb2c-4b03-8ac9-a8cf52f924c9" providerId="ADAL" clId="{386DC46B-41D5-40B2-A6A2-885422854031}" dt="2022-10-20T13:59:45.783" v="92" actId="164"/>
          <ac:grpSpMkLst>
            <pc:docMk/>
            <pc:sldMk cId="3278798907" sldId="256"/>
            <ac:grpSpMk id="249" creationId="{903C2705-575E-59AC-7710-E1AFF7D9FE1F}"/>
          </ac:grpSpMkLst>
        </pc:grpChg>
        <pc:grpChg chg="mod">
          <ac:chgData name="JUAN MANUEL LOZANO GIL" userId="618ed11e-cb2c-4b03-8ac9-a8cf52f924c9" providerId="ADAL" clId="{386DC46B-41D5-40B2-A6A2-885422854031}" dt="2022-10-20T13:59:59.378" v="96"/>
          <ac:grpSpMkLst>
            <pc:docMk/>
            <pc:sldMk cId="3278798907" sldId="256"/>
            <ac:grpSpMk id="261" creationId="{01225E6C-879A-320D-15DA-4148DCB0AC30}"/>
          </ac:grpSpMkLst>
        </pc:grpChg>
        <pc:grpChg chg="mod">
          <ac:chgData name="JUAN MANUEL LOZANO GIL" userId="618ed11e-cb2c-4b03-8ac9-a8cf52f924c9" providerId="ADAL" clId="{386DC46B-41D5-40B2-A6A2-885422854031}" dt="2022-10-20T14:23:44.196" v="325" actId="1076"/>
          <ac:grpSpMkLst>
            <pc:docMk/>
            <pc:sldMk cId="3278798907" sldId="256"/>
            <ac:grpSpMk id="327" creationId="{C885E84B-C0CD-1058-8235-F7DBF41CF74E}"/>
          </ac:grpSpMkLst>
        </pc:grpChg>
        <pc:picChg chg="add mod modCrop">
          <ac:chgData name="JUAN MANUEL LOZANO GIL" userId="618ed11e-cb2c-4b03-8ac9-a8cf52f924c9" providerId="ADAL" clId="{386DC46B-41D5-40B2-A6A2-885422854031}" dt="2022-10-20T14:22:18.260" v="262" actId="208"/>
          <ac:picMkLst>
            <pc:docMk/>
            <pc:sldMk cId="3278798907" sldId="256"/>
            <ac:picMk id="4" creationId="{79CCC012-5C18-36BB-7BFB-CDF561A3F513}"/>
          </ac:picMkLst>
        </pc:picChg>
        <pc:picChg chg="mod topLvl">
          <ac:chgData name="JUAN MANUEL LOZANO GIL" userId="618ed11e-cb2c-4b03-8ac9-a8cf52f924c9" providerId="ADAL" clId="{386DC46B-41D5-40B2-A6A2-885422854031}" dt="2022-10-20T14:18:45.871" v="137" actId="165"/>
          <ac:picMkLst>
            <pc:docMk/>
            <pc:sldMk cId="3278798907" sldId="256"/>
            <ac:picMk id="8" creationId="{A3918CB1-7E0E-12FB-DEA9-93F0D716FC59}"/>
          </ac:picMkLst>
        </pc:picChg>
        <pc:picChg chg="mod modCrop">
          <ac:chgData name="JUAN MANUEL LOZANO GIL" userId="618ed11e-cb2c-4b03-8ac9-a8cf52f924c9" providerId="ADAL" clId="{386DC46B-41D5-40B2-A6A2-885422854031}" dt="2022-10-24T11:16:35.886" v="330" actId="1076"/>
          <ac:picMkLst>
            <pc:docMk/>
            <pc:sldMk cId="3278798907" sldId="256"/>
            <ac:picMk id="10" creationId="{07693468-5B9E-FA8D-8054-DC6892E7AA73}"/>
          </ac:picMkLst>
        </pc:picChg>
        <pc:picChg chg="del mod topLvl">
          <ac:chgData name="JUAN MANUEL LOZANO GIL" userId="618ed11e-cb2c-4b03-8ac9-a8cf52f924c9" providerId="ADAL" clId="{386DC46B-41D5-40B2-A6A2-885422854031}" dt="2022-10-20T14:20:24.299" v="192" actId="478"/>
          <ac:picMkLst>
            <pc:docMk/>
            <pc:sldMk cId="3278798907" sldId="256"/>
            <ac:picMk id="22" creationId="{A22DB6EA-1F9E-E42A-7BCC-7E3F6849E1E6}"/>
          </ac:picMkLst>
        </pc:picChg>
        <pc:picChg chg="add mod topLvl modCrop">
          <ac:chgData name="JUAN MANUEL LOZANO GIL" userId="618ed11e-cb2c-4b03-8ac9-a8cf52f924c9" providerId="ADAL" clId="{386DC46B-41D5-40B2-A6A2-885422854031}" dt="2022-10-20T13:59:45.783" v="92" actId="164"/>
          <ac:picMkLst>
            <pc:docMk/>
            <pc:sldMk cId="3278798907" sldId="256"/>
            <ac:picMk id="141" creationId="{1673B805-7289-9CBC-0B85-F86E9AD16D75}"/>
          </ac:picMkLst>
        </pc:picChg>
        <pc:picChg chg="add del mod modCrop">
          <ac:chgData name="JUAN MANUEL LOZANO GIL" userId="618ed11e-cb2c-4b03-8ac9-a8cf52f924c9" providerId="ADAL" clId="{386DC46B-41D5-40B2-A6A2-885422854031}" dt="2022-10-20T13:58:56.263" v="76" actId="478"/>
          <ac:picMkLst>
            <pc:docMk/>
            <pc:sldMk cId="3278798907" sldId="256"/>
            <ac:picMk id="143" creationId="{C60DE01D-1D51-EFAF-5485-D4F0761E65B1}"/>
          </ac:picMkLst>
        </pc:picChg>
        <pc:picChg chg="add del mod modCrop">
          <ac:chgData name="JUAN MANUEL LOZANO GIL" userId="618ed11e-cb2c-4b03-8ac9-a8cf52f924c9" providerId="ADAL" clId="{386DC46B-41D5-40B2-A6A2-885422854031}" dt="2022-10-20T14:20:22.297" v="191" actId="478"/>
          <ac:picMkLst>
            <pc:docMk/>
            <pc:sldMk cId="3278798907" sldId="256"/>
            <ac:picMk id="190" creationId="{4E17EBA7-C687-5A50-499B-7F7362422C3C}"/>
          </ac:picMkLst>
        </pc:picChg>
        <pc:picChg chg="add del mod modCrop">
          <ac:chgData name="JUAN MANUEL LOZANO GIL" userId="618ed11e-cb2c-4b03-8ac9-a8cf52f924c9" providerId="ADAL" clId="{386DC46B-41D5-40B2-A6A2-885422854031}" dt="2022-10-20T14:19:57.053" v="185" actId="478"/>
          <ac:picMkLst>
            <pc:docMk/>
            <pc:sldMk cId="3278798907" sldId="256"/>
            <ac:picMk id="192" creationId="{8818FEEF-C691-BAA6-B7C2-545A691C844D}"/>
          </ac:picMkLst>
        </pc:picChg>
        <pc:picChg chg="add del mod">
          <ac:chgData name="JUAN MANUEL LOZANO GIL" userId="618ed11e-cb2c-4b03-8ac9-a8cf52f924c9" providerId="ADAL" clId="{386DC46B-41D5-40B2-A6A2-885422854031}" dt="2022-10-20T14:20:50.717" v="203" actId="478"/>
          <ac:picMkLst>
            <pc:docMk/>
            <pc:sldMk cId="3278798907" sldId="256"/>
            <ac:picMk id="216" creationId="{FADE502A-C796-80C4-8B2F-A25267386B5C}"/>
          </ac:picMkLst>
        </pc:picChg>
        <pc:picChg chg="add mod modCrop">
          <ac:chgData name="JUAN MANUEL LOZANO GIL" userId="618ed11e-cb2c-4b03-8ac9-a8cf52f924c9" providerId="ADAL" clId="{386DC46B-41D5-40B2-A6A2-885422854031}" dt="2022-10-20T14:23:30.651" v="319" actId="14100"/>
          <ac:picMkLst>
            <pc:docMk/>
            <pc:sldMk cId="3278798907" sldId="256"/>
            <ac:picMk id="232" creationId="{7BC3BC16-7FDE-9D23-EB8A-C1AA2A61F864}"/>
          </ac:picMkLst>
        </pc:pic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9" creationId="{129E63B4-C489-BEB8-4402-11F892A8CF0B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1" creationId="{2BD03A2C-A553-B425-123C-509BB86E89A9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4" creationId="{B64A0862-3398-A01B-21DE-6E3E5F4799EF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4" creationId="{E9A25BB7-3C06-F81F-C768-BB81B8DBCCCA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5" creationId="{78C4AB6F-D797-1CFE-3B4A-E15CBF255F8B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5" creationId="{A4080079-AD9E-5200-A6BF-09E2A2964522}"/>
          </ac:cxnSpMkLst>
        </pc:cxnChg>
        <pc:cxnChg chg="mod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26" creationId="{8ED8A38E-CC84-360C-366C-FA96E46AE39E}"/>
          </ac:cxnSpMkLst>
        </pc:cxnChg>
        <pc:cxnChg chg="mod topLvl">
          <ac:chgData name="JUAN MANUEL LOZANO GIL" userId="618ed11e-cb2c-4b03-8ac9-a8cf52f924c9" providerId="ADAL" clId="{386DC46B-41D5-40B2-A6A2-885422854031}" dt="2022-10-20T14:18:45.871" v="137" actId="165"/>
          <ac:cxnSpMkLst>
            <pc:docMk/>
            <pc:sldMk cId="3278798907" sldId="256"/>
            <ac:cxnSpMk id="138" creationId="{8839E733-E7A2-2B25-2A5F-F486A05DED28}"/>
          </ac:cxnSpMkLst>
        </pc:cxnChg>
        <pc:cxnChg chg="del">
          <ac:chgData name="JUAN MANUEL LOZANO GIL" userId="618ed11e-cb2c-4b03-8ac9-a8cf52f924c9" providerId="ADAL" clId="{386DC46B-41D5-40B2-A6A2-885422854031}" dt="2022-10-24T11:16:44.388" v="332" actId="478"/>
          <ac:cxnSpMkLst>
            <pc:docMk/>
            <pc:sldMk cId="3278798907" sldId="256"/>
            <ac:cxnSpMk id="148" creationId="{5E930379-6189-979C-5E84-A530AF605BD7}"/>
          </ac:cxnSpMkLst>
        </pc:cxnChg>
        <pc:cxnChg chg="del">
          <ac:chgData name="JUAN MANUEL LOZANO GIL" userId="618ed11e-cb2c-4b03-8ac9-a8cf52f924c9" providerId="ADAL" clId="{386DC46B-41D5-40B2-A6A2-885422854031}" dt="2022-10-24T11:16:48.839" v="333" actId="478"/>
          <ac:cxnSpMkLst>
            <pc:docMk/>
            <pc:sldMk cId="3278798907" sldId="256"/>
            <ac:cxnSpMk id="149" creationId="{8AB3ECD2-8851-D907-CED5-8BD60E743663}"/>
          </ac:cxnSpMkLst>
        </pc:cxnChg>
        <pc:cxnChg chg="mod">
          <ac:chgData name="JUAN MANUEL LOZANO GIL" userId="618ed11e-cb2c-4b03-8ac9-a8cf52f924c9" providerId="ADAL" clId="{386DC46B-41D5-40B2-A6A2-885422854031}" dt="2022-10-20T14:20:28.053" v="194"/>
          <ac:cxnSpMkLst>
            <pc:docMk/>
            <pc:sldMk cId="3278798907" sldId="256"/>
            <ac:cxnSpMk id="192" creationId="{740BA44F-D247-349E-363F-65A0FDBE4E40}"/>
          </ac:cxnSpMkLst>
        </pc:cxnChg>
        <pc:cxnChg chg="del mod topLvl">
          <ac:chgData name="JUAN MANUEL LOZANO GIL" userId="618ed11e-cb2c-4b03-8ac9-a8cf52f924c9" providerId="ADAL" clId="{386DC46B-41D5-40B2-A6A2-885422854031}" dt="2022-10-20T14:20:02.262" v="187" actId="478"/>
          <ac:cxnSpMkLst>
            <pc:docMk/>
            <pc:sldMk cId="3278798907" sldId="256"/>
            <ac:cxnSpMk id="194" creationId="{A6B1F438-7625-EA37-EBAA-78AB3CD935A7}"/>
          </ac:cxnSpMkLst>
        </pc:cxnChg>
        <pc:cxnChg chg="mod">
          <ac:chgData name="JUAN MANUEL LOZANO GIL" userId="618ed11e-cb2c-4b03-8ac9-a8cf52f924c9" providerId="ADAL" clId="{386DC46B-41D5-40B2-A6A2-885422854031}" dt="2022-10-20T14:20:28.053" v="194"/>
          <ac:cxnSpMkLst>
            <pc:docMk/>
            <pc:sldMk cId="3278798907" sldId="256"/>
            <ac:cxnSpMk id="195" creationId="{7078B968-C719-5F90-98A2-8D1838D02E9A}"/>
          </ac:cxnSpMkLst>
        </pc:cxnChg>
        <pc:cxnChg chg="del mod topLvl">
          <ac:chgData name="JUAN MANUEL LOZANO GIL" userId="618ed11e-cb2c-4b03-8ac9-a8cf52f924c9" providerId="ADAL" clId="{386DC46B-41D5-40B2-A6A2-885422854031}" dt="2022-10-20T14:20:13.054" v="188" actId="478"/>
          <ac:cxnSpMkLst>
            <pc:docMk/>
            <pc:sldMk cId="3278798907" sldId="256"/>
            <ac:cxnSpMk id="195" creationId="{B4DE5BC2-C833-4E73-E519-D684AF91B74E}"/>
          </ac:cxnSpMkLst>
        </pc:cxnChg>
        <pc:cxnChg chg="del mod topLvl">
          <ac:chgData name="JUAN MANUEL LOZANO GIL" userId="618ed11e-cb2c-4b03-8ac9-a8cf52f924c9" providerId="ADAL" clId="{386DC46B-41D5-40B2-A6A2-885422854031}" dt="2022-10-20T14:20:25.661" v="193" actId="478"/>
          <ac:cxnSpMkLst>
            <pc:docMk/>
            <pc:sldMk cId="3278798907" sldId="256"/>
            <ac:cxnSpMk id="196" creationId="{8D65A4A8-5958-C746-4B6B-D66D3DB6637A}"/>
          </ac:cxnSpMkLst>
        </pc:cxnChg>
        <pc:cxnChg chg="del mod topLvl">
          <ac:chgData name="JUAN MANUEL LOZANO GIL" userId="618ed11e-cb2c-4b03-8ac9-a8cf52f924c9" providerId="ADAL" clId="{386DC46B-41D5-40B2-A6A2-885422854031}" dt="2022-10-20T14:20:25.661" v="193" actId="478"/>
          <ac:cxnSpMkLst>
            <pc:docMk/>
            <pc:sldMk cId="3278798907" sldId="256"/>
            <ac:cxnSpMk id="197" creationId="{F0A4E756-499D-65B5-68E6-FFADEEA7B231}"/>
          </ac:cxnSpMkLst>
        </pc:cxnChg>
        <pc:cxnChg chg="mod">
          <ac:chgData name="JUAN MANUEL LOZANO GIL" userId="618ed11e-cb2c-4b03-8ac9-a8cf52f924c9" providerId="ADAL" clId="{386DC46B-41D5-40B2-A6A2-885422854031}" dt="2022-10-20T14:20:28.053" v="194"/>
          <ac:cxnSpMkLst>
            <pc:docMk/>
            <pc:sldMk cId="3278798907" sldId="256"/>
            <ac:cxnSpMk id="198" creationId="{4EBF6361-0149-0467-B190-B5CD93833555}"/>
          </ac:cxnSpMkLst>
        </pc:cxnChg>
        <pc:cxnChg chg="add del mod topLvl">
          <ac:chgData name="JUAN MANUEL LOZANO GIL" userId="618ed11e-cb2c-4b03-8ac9-a8cf52f924c9" providerId="ADAL" clId="{386DC46B-41D5-40B2-A6A2-885422854031}" dt="2022-10-20T14:20:25.661" v="193" actId="478"/>
          <ac:cxnSpMkLst>
            <pc:docMk/>
            <pc:sldMk cId="3278798907" sldId="256"/>
            <ac:cxnSpMk id="198" creationId="{4FCD0DE1-E132-B1A4-BC6E-F5DBCB42F827}"/>
          </ac:cxnSpMkLst>
        </pc:cxnChg>
        <pc:cxnChg chg="mod">
          <ac:chgData name="JUAN MANUEL LOZANO GIL" userId="618ed11e-cb2c-4b03-8ac9-a8cf52f924c9" providerId="ADAL" clId="{386DC46B-41D5-40B2-A6A2-885422854031}" dt="2022-10-20T14:21:16.947" v="231" actId="1036"/>
          <ac:cxnSpMkLst>
            <pc:docMk/>
            <pc:sldMk cId="3278798907" sldId="256"/>
            <ac:cxnSpMk id="200" creationId="{9EF16A84-0776-03ED-FF8A-4557944FE18D}"/>
          </ac:cxnSpMkLst>
        </pc:cxnChg>
        <pc:cxnChg chg="del mod">
          <ac:chgData name="JUAN MANUEL LOZANO GIL" userId="618ed11e-cb2c-4b03-8ac9-a8cf52f924c9" providerId="ADAL" clId="{386DC46B-41D5-40B2-A6A2-885422854031}" dt="2022-10-20T14:21:24.027" v="235" actId="478"/>
          <ac:cxnSpMkLst>
            <pc:docMk/>
            <pc:sldMk cId="3278798907" sldId="256"/>
            <ac:cxnSpMk id="209" creationId="{9592F787-88C9-B5B5-5C55-D64A77394EBB}"/>
          </ac:cxnSpMkLst>
        </pc:cxnChg>
        <pc:cxnChg chg="del mod">
          <ac:chgData name="JUAN MANUEL LOZANO GIL" userId="618ed11e-cb2c-4b03-8ac9-a8cf52f924c9" providerId="ADAL" clId="{386DC46B-41D5-40B2-A6A2-885422854031}" dt="2022-10-20T14:23:38.259" v="323" actId="478"/>
          <ac:cxnSpMkLst>
            <pc:docMk/>
            <pc:sldMk cId="3278798907" sldId="256"/>
            <ac:cxnSpMk id="230" creationId="{4CCB1181-6F37-6FD6-7A50-5CE1DC5D2253}"/>
          </ac:cxnSpMkLst>
        </pc:cxnChg>
        <pc:cxnChg chg="add mod">
          <ac:chgData name="JUAN MANUEL LOZANO GIL" userId="618ed11e-cb2c-4b03-8ac9-a8cf52f924c9" providerId="ADAL" clId="{386DC46B-41D5-40B2-A6A2-885422854031}" dt="2022-10-20T14:00:25.512" v="112" actId="164"/>
          <ac:cxnSpMkLst>
            <pc:docMk/>
            <pc:sldMk cId="3278798907" sldId="256"/>
            <ac:cxnSpMk id="243" creationId="{26892D6D-7238-9454-402A-4E8F4570AED3}"/>
          </ac:cxnSpMkLst>
        </pc:cxnChg>
        <pc:cxnChg chg="mod">
          <ac:chgData name="JUAN MANUEL LOZANO GIL" userId="618ed11e-cb2c-4b03-8ac9-a8cf52f924c9" providerId="ADAL" clId="{386DC46B-41D5-40B2-A6A2-885422854031}" dt="2022-10-20T14:23:01.313" v="272"/>
          <ac:cxnSpMkLst>
            <pc:docMk/>
            <pc:sldMk cId="3278798907" sldId="256"/>
            <ac:cxnSpMk id="245" creationId="{9F798C0C-085F-8D3B-9973-0DFBC15AF3C1}"/>
          </ac:cxnSpMkLst>
        </pc:cxnChg>
        <pc:cxnChg chg="mod">
          <ac:chgData name="JUAN MANUEL LOZANO GIL" userId="618ed11e-cb2c-4b03-8ac9-a8cf52f924c9" providerId="ADAL" clId="{386DC46B-41D5-40B2-A6A2-885422854031}" dt="2022-10-20T14:23:01.313" v="272"/>
          <ac:cxnSpMkLst>
            <pc:docMk/>
            <pc:sldMk cId="3278798907" sldId="256"/>
            <ac:cxnSpMk id="246" creationId="{C5E3D796-EBC5-4C7E-5166-143FFDE1E54A}"/>
          </ac:cxnSpMkLst>
        </pc:cxnChg>
        <pc:cxnChg chg="mod">
          <ac:chgData name="JUAN MANUEL LOZANO GIL" userId="618ed11e-cb2c-4b03-8ac9-a8cf52f924c9" providerId="ADAL" clId="{386DC46B-41D5-40B2-A6A2-885422854031}" dt="2022-10-20T14:23:01.313" v="272"/>
          <ac:cxnSpMkLst>
            <pc:docMk/>
            <pc:sldMk cId="3278798907" sldId="256"/>
            <ac:cxnSpMk id="248" creationId="{D8F2E568-C835-B0D9-E410-6601636066DE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1" creationId="{610CCD66-D71C-AB67-0FBA-32853F4BD5BC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2" creationId="{FC3D38EF-0FDA-08E4-9171-BA04F555060C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3" creationId="{E4CEA6A9-4A46-3009-7332-E8ECD66177FD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4" creationId="{5E930379-6189-979C-5E84-A530AF605BD7}"/>
          </ac:cxnSpMkLst>
        </pc:cxnChg>
        <pc:cxnChg chg="mod">
          <ac:chgData name="JUAN MANUEL LOZANO GIL" userId="618ed11e-cb2c-4b03-8ac9-a8cf52f924c9" providerId="ADAL" clId="{386DC46B-41D5-40B2-A6A2-885422854031}" dt="2022-10-20T13:59:38.276" v="89" actId="208"/>
          <ac:cxnSpMkLst>
            <pc:docMk/>
            <pc:sldMk cId="3278798907" sldId="256"/>
            <ac:cxnSpMk id="255" creationId="{8AB3ECD2-8851-D907-CED5-8BD60E743663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165751-9B9B-43A8-8312-F0499DA98BA6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06C5EC-28AC-4C1D-A4C5-CB6449FE3E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919351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D06C5EC-28AC-4C1D-A4C5-CB6449FE3EF8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6088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5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784803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72313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039636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819546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50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4350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29650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4453469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9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25490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75443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3839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3576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8390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A4C1E-FDE6-4C97-BB46-5170F348D748}" type="datetimeFigureOut">
              <a:rPr lang="es-ES" smtClean="0"/>
              <a:t>19/07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3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3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D91263-472F-4324-B9E3-11770E3D45D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082112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7" Type="http://schemas.microsoft.com/office/2007/relationships/hdphoto" Target="../media/hdphoto4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microsoft.com/office/2007/relationships/hdphoto" Target="../media/hdphoto3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n 12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A3918CB1-7E0E-12FB-DEA9-93F0D716FC5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189" t="17552" r="57991" b="9368"/>
          <a:stretch/>
        </p:blipFill>
        <p:spPr>
          <a:xfrm>
            <a:off x="2505734" y="1752667"/>
            <a:ext cx="1846531" cy="2544544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0" name="Grupo 19">
            <a:extLst>
              <a:ext uri="{FF2B5EF4-FFF2-40B4-BE49-F238E27FC236}">
                <a16:creationId xmlns:a16="http://schemas.microsoft.com/office/drawing/2014/main" id="{C3D67D48-DBD6-F3C7-14EA-203AA1CEB286}"/>
              </a:ext>
            </a:extLst>
          </p:cNvPr>
          <p:cNvGrpSpPr/>
          <p:nvPr/>
        </p:nvGrpSpPr>
        <p:grpSpPr>
          <a:xfrm>
            <a:off x="2384270" y="2150944"/>
            <a:ext cx="122199" cy="1683857"/>
            <a:chOff x="2126145" y="3916017"/>
            <a:chExt cx="410818" cy="2059057"/>
          </a:xfrm>
        </p:grpSpPr>
        <p:cxnSp>
          <p:nvCxnSpPr>
            <p:cNvPr id="15" name="Conector recto 14">
              <a:extLst>
                <a:ext uri="{FF2B5EF4-FFF2-40B4-BE49-F238E27FC236}">
                  <a16:creationId xmlns:a16="http://schemas.microsoft.com/office/drawing/2014/main" id="{129E63B4-C489-BEB8-4402-11F892A8CF0B}"/>
                </a:ext>
              </a:extLst>
            </p:cNvPr>
            <p:cNvCxnSpPr/>
            <p:nvPr/>
          </p:nvCxnSpPr>
          <p:spPr>
            <a:xfrm>
              <a:off x="2126146" y="3916017"/>
              <a:ext cx="3776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Conector recto 15">
              <a:extLst>
                <a:ext uri="{FF2B5EF4-FFF2-40B4-BE49-F238E27FC236}">
                  <a16:creationId xmlns:a16="http://schemas.microsoft.com/office/drawing/2014/main" id="{2BD03A2C-A553-B425-123C-509BB86E89A9}"/>
                </a:ext>
              </a:extLst>
            </p:cNvPr>
            <p:cNvCxnSpPr/>
            <p:nvPr/>
          </p:nvCxnSpPr>
          <p:spPr>
            <a:xfrm>
              <a:off x="2126145" y="4485861"/>
              <a:ext cx="3776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Conector recto 16">
              <a:extLst>
                <a:ext uri="{FF2B5EF4-FFF2-40B4-BE49-F238E27FC236}">
                  <a16:creationId xmlns:a16="http://schemas.microsoft.com/office/drawing/2014/main" id="{E9A25BB7-3C06-F81F-C768-BB81B8DBCCCA}"/>
                </a:ext>
              </a:extLst>
            </p:cNvPr>
            <p:cNvCxnSpPr/>
            <p:nvPr/>
          </p:nvCxnSpPr>
          <p:spPr>
            <a:xfrm>
              <a:off x="2126145" y="4934778"/>
              <a:ext cx="3776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ector recto 17">
              <a:extLst>
                <a:ext uri="{FF2B5EF4-FFF2-40B4-BE49-F238E27FC236}">
                  <a16:creationId xmlns:a16="http://schemas.microsoft.com/office/drawing/2014/main" id="{78C4AB6F-D797-1CFE-3B4A-E15CBF255F8B}"/>
                </a:ext>
              </a:extLst>
            </p:cNvPr>
            <p:cNvCxnSpPr/>
            <p:nvPr/>
          </p:nvCxnSpPr>
          <p:spPr>
            <a:xfrm>
              <a:off x="2156792" y="5524500"/>
              <a:ext cx="3776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ector recto 18">
              <a:extLst>
                <a:ext uri="{FF2B5EF4-FFF2-40B4-BE49-F238E27FC236}">
                  <a16:creationId xmlns:a16="http://schemas.microsoft.com/office/drawing/2014/main" id="{8ED8A38E-CC84-360C-366C-FA96E46AE39E}"/>
                </a:ext>
              </a:extLst>
            </p:cNvPr>
            <p:cNvCxnSpPr/>
            <p:nvPr/>
          </p:nvCxnSpPr>
          <p:spPr>
            <a:xfrm>
              <a:off x="2159276" y="5975074"/>
              <a:ext cx="3776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Grupo 64">
            <a:extLst>
              <a:ext uri="{FF2B5EF4-FFF2-40B4-BE49-F238E27FC236}">
                <a16:creationId xmlns:a16="http://schemas.microsoft.com/office/drawing/2014/main" id="{A5E5CDB5-C751-0E14-2CF2-8CD6EEB4673D}"/>
              </a:ext>
            </a:extLst>
          </p:cNvPr>
          <p:cNvGrpSpPr/>
          <p:nvPr/>
        </p:nvGrpSpPr>
        <p:grpSpPr>
          <a:xfrm>
            <a:off x="598336" y="1168737"/>
            <a:ext cx="3396689" cy="430353"/>
            <a:chOff x="1275718" y="1079961"/>
            <a:chExt cx="3660559" cy="526242"/>
          </a:xfrm>
        </p:grpSpPr>
        <p:grpSp>
          <p:nvGrpSpPr>
            <p:cNvPr id="32" name="Grupo 31">
              <a:extLst>
                <a:ext uri="{FF2B5EF4-FFF2-40B4-BE49-F238E27FC236}">
                  <a16:creationId xmlns:a16="http://schemas.microsoft.com/office/drawing/2014/main" id="{5121F8BE-6AAD-93AE-7F46-DD245EED2E35}"/>
                </a:ext>
              </a:extLst>
            </p:cNvPr>
            <p:cNvGrpSpPr/>
            <p:nvPr/>
          </p:nvGrpSpPr>
          <p:grpSpPr>
            <a:xfrm>
              <a:off x="1275718" y="1079961"/>
              <a:ext cx="1770306" cy="526242"/>
              <a:chOff x="1056432" y="941164"/>
              <a:chExt cx="1770306" cy="367070"/>
            </a:xfrm>
          </p:grpSpPr>
          <p:sp>
            <p:nvSpPr>
              <p:cNvPr id="29" name="CuadroTexto 28">
                <a:extLst>
                  <a:ext uri="{FF2B5EF4-FFF2-40B4-BE49-F238E27FC236}">
                    <a16:creationId xmlns:a16="http://schemas.microsoft.com/office/drawing/2014/main" id="{6FE0C5C9-EFFF-D8EF-6794-40A8A3B3FDB4}"/>
                  </a:ext>
                </a:extLst>
              </p:cNvPr>
              <p:cNvSpPr txBox="1"/>
              <p:nvPr/>
            </p:nvSpPr>
            <p:spPr>
              <a:xfrm>
                <a:off x="1056432" y="941164"/>
                <a:ext cx="1770306" cy="2362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/>
                  <a:t>NLRP1 (full </a:t>
                </a:r>
                <a:r>
                  <a:rPr lang="es-ES" sz="1200" dirty="0" err="1"/>
                  <a:t>length</a:t>
                </a:r>
                <a:r>
                  <a:rPr lang="es-ES" sz="1200" dirty="0"/>
                  <a:t>)-</a:t>
                </a:r>
                <a:r>
                  <a:rPr lang="es-ES" sz="1200" dirty="0" err="1"/>
                  <a:t>Flag</a:t>
                </a:r>
                <a:endParaRPr lang="es-ES" sz="1200" dirty="0"/>
              </a:p>
            </p:txBody>
          </p:sp>
          <p:sp>
            <p:nvSpPr>
              <p:cNvPr id="30" name="CuadroTexto 29">
                <a:extLst>
                  <a:ext uri="{FF2B5EF4-FFF2-40B4-BE49-F238E27FC236}">
                    <a16:creationId xmlns:a16="http://schemas.microsoft.com/office/drawing/2014/main" id="{69A63828-D0E6-C303-7DAB-022683830F6B}"/>
                  </a:ext>
                </a:extLst>
              </p:cNvPr>
              <p:cNvSpPr txBox="1"/>
              <p:nvPr/>
            </p:nvSpPr>
            <p:spPr>
              <a:xfrm>
                <a:off x="1514891" y="1071968"/>
                <a:ext cx="1225026" cy="2362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/>
                  <a:t>UPA-CARD-</a:t>
                </a:r>
                <a:r>
                  <a:rPr lang="es-ES" sz="1200" dirty="0" err="1"/>
                  <a:t>Flag</a:t>
                </a:r>
                <a:endParaRPr lang="es-ES" sz="1200" dirty="0"/>
              </a:p>
            </p:txBody>
          </p:sp>
        </p:grp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7AACA306-674B-1C70-235C-CCCCACCF8049}"/>
                </a:ext>
              </a:extLst>
            </p:cNvPr>
            <p:cNvSpPr txBox="1"/>
            <p:nvPr/>
          </p:nvSpPr>
          <p:spPr>
            <a:xfrm>
              <a:off x="3360869" y="1092073"/>
              <a:ext cx="249111" cy="3387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/>
                <a:t>-</a:t>
              </a:r>
            </a:p>
          </p:txBody>
        </p:sp>
        <p:sp>
          <p:nvSpPr>
            <p:cNvPr id="43" name="CuadroTexto 42">
              <a:extLst>
                <a:ext uri="{FF2B5EF4-FFF2-40B4-BE49-F238E27FC236}">
                  <a16:creationId xmlns:a16="http://schemas.microsoft.com/office/drawing/2014/main" id="{40B58694-FE1E-CCFD-0228-0AA311C76DFA}"/>
                </a:ext>
              </a:extLst>
            </p:cNvPr>
            <p:cNvSpPr txBox="1"/>
            <p:nvPr/>
          </p:nvSpPr>
          <p:spPr>
            <a:xfrm>
              <a:off x="3363264" y="1244906"/>
              <a:ext cx="249111" cy="3387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/>
                <a:t>-</a:t>
              </a:r>
            </a:p>
          </p:txBody>
        </p:sp>
        <p:sp>
          <p:nvSpPr>
            <p:cNvPr id="45" name="CuadroTexto 44">
              <a:extLst>
                <a:ext uri="{FF2B5EF4-FFF2-40B4-BE49-F238E27FC236}">
                  <a16:creationId xmlns:a16="http://schemas.microsoft.com/office/drawing/2014/main" id="{31A25F3E-6C68-F161-3D0F-F200414B1A30}"/>
                </a:ext>
              </a:extLst>
            </p:cNvPr>
            <p:cNvSpPr txBox="1"/>
            <p:nvPr/>
          </p:nvSpPr>
          <p:spPr>
            <a:xfrm>
              <a:off x="3660731" y="1092073"/>
              <a:ext cx="281933" cy="3387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/>
                <a:t>+</a:t>
              </a:r>
            </a:p>
          </p:txBody>
        </p:sp>
        <p:sp>
          <p:nvSpPr>
            <p:cNvPr id="46" name="CuadroTexto 45">
              <a:extLst>
                <a:ext uri="{FF2B5EF4-FFF2-40B4-BE49-F238E27FC236}">
                  <a16:creationId xmlns:a16="http://schemas.microsoft.com/office/drawing/2014/main" id="{3638FD81-EEFB-3605-A26A-B156E0406D02}"/>
                </a:ext>
              </a:extLst>
            </p:cNvPr>
            <p:cNvSpPr txBox="1"/>
            <p:nvPr/>
          </p:nvSpPr>
          <p:spPr>
            <a:xfrm>
              <a:off x="3679534" y="1244911"/>
              <a:ext cx="249111" cy="3387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/>
                <a:t>-</a:t>
              </a:r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43D45783-35DE-6202-F1E7-93A721736D85}"/>
                </a:ext>
              </a:extLst>
            </p:cNvPr>
            <p:cNvSpPr txBox="1"/>
            <p:nvPr/>
          </p:nvSpPr>
          <p:spPr>
            <a:xfrm>
              <a:off x="3996242" y="1092073"/>
              <a:ext cx="281933" cy="3387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/>
                <a:t>+</a:t>
              </a:r>
            </a:p>
          </p:txBody>
        </p: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29E10A20-1F20-FCB7-63FA-D9EDDADD0B1D}"/>
                </a:ext>
              </a:extLst>
            </p:cNvPr>
            <p:cNvSpPr txBox="1"/>
            <p:nvPr/>
          </p:nvSpPr>
          <p:spPr>
            <a:xfrm>
              <a:off x="4015038" y="1244911"/>
              <a:ext cx="249111" cy="3387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/>
                <a:t>-</a:t>
              </a:r>
            </a:p>
          </p:txBody>
        </p:sp>
        <p:sp>
          <p:nvSpPr>
            <p:cNvPr id="51" name="CuadroTexto 50">
              <a:extLst>
                <a:ext uri="{FF2B5EF4-FFF2-40B4-BE49-F238E27FC236}">
                  <a16:creationId xmlns:a16="http://schemas.microsoft.com/office/drawing/2014/main" id="{A06224D5-42DC-2220-0691-7BB9BAC19105}"/>
                </a:ext>
              </a:extLst>
            </p:cNvPr>
            <p:cNvSpPr txBox="1"/>
            <p:nvPr/>
          </p:nvSpPr>
          <p:spPr>
            <a:xfrm>
              <a:off x="4352090" y="1092073"/>
              <a:ext cx="249111" cy="3387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/>
                <a:t>-</a:t>
              </a:r>
            </a:p>
          </p:txBody>
        </p:sp>
        <p:sp>
          <p:nvSpPr>
            <p:cNvPr id="52" name="CuadroTexto 51">
              <a:extLst>
                <a:ext uri="{FF2B5EF4-FFF2-40B4-BE49-F238E27FC236}">
                  <a16:creationId xmlns:a16="http://schemas.microsoft.com/office/drawing/2014/main" id="{FC76A523-D22C-9CE9-86C0-3291B5E55716}"/>
                </a:ext>
              </a:extLst>
            </p:cNvPr>
            <p:cNvSpPr txBox="1"/>
            <p:nvPr/>
          </p:nvSpPr>
          <p:spPr>
            <a:xfrm>
              <a:off x="4323778" y="1244911"/>
              <a:ext cx="281933" cy="3387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/>
                <a:t>+</a:t>
              </a:r>
            </a:p>
          </p:txBody>
        </p:sp>
        <p:sp>
          <p:nvSpPr>
            <p:cNvPr id="54" name="CuadroTexto 53">
              <a:extLst>
                <a:ext uri="{FF2B5EF4-FFF2-40B4-BE49-F238E27FC236}">
                  <a16:creationId xmlns:a16="http://schemas.microsoft.com/office/drawing/2014/main" id="{1865E9DC-E288-5D5B-E8CE-3964A7FF498A}"/>
                </a:ext>
              </a:extLst>
            </p:cNvPr>
            <p:cNvSpPr txBox="1"/>
            <p:nvPr/>
          </p:nvSpPr>
          <p:spPr>
            <a:xfrm>
              <a:off x="4668361" y="1092073"/>
              <a:ext cx="249111" cy="3387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/>
                <a:t>-</a:t>
              </a:r>
            </a:p>
          </p:txBody>
        </p:sp>
        <p:sp>
          <p:nvSpPr>
            <p:cNvPr id="55" name="CuadroTexto 54">
              <a:extLst>
                <a:ext uri="{FF2B5EF4-FFF2-40B4-BE49-F238E27FC236}">
                  <a16:creationId xmlns:a16="http://schemas.microsoft.com/office/drawing/2014/main" id="{3340EB4D-D450-3A93-EC03-0A0352BE4422}"/>
                </a:ext>
              </a:extLst>
            </p:cNvPr>
            <p:cNvSpPr txBox="1"/>
            <p:nvPr/>
          </p:nvSpPr>
          <p:spPr>
            <a:xfrm>
              <a:off x="4654344" y="1244911"/>
              <a:ext cx="281933" cy="33871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200"/>
                <a:t>+</a:t>
              </a:r>
            </a:p>
          </p:txBody>
        </p:sp>
      </p:grpSp>
      <p:sp>
        <p:nvSpPr>
          <p:cNvPr id="123" name="CuadroTexto 122">
            <a:extLst>
              <a:ext uri="{FF2B5EF4-FFF2-40B4-BE49-F238E27FC236}">
                <a16:creationId xmlns:a16="http://schemas.microsoft.com/office/drawing/2014/main" id="{ADB6E049-3E35-ED91-D48D-5CDE07739EFB}"/>
              </a:ext>
            </a:extLst>
          </p:cNvPr>
          <p:cNvSpPr txBox="1"/>
          <p:nvPr/>
        </p:nvSpPr>
        <p:spPr>
          <a:xfrm>
            <a:off x="4548831" y="2672496"/>
            <a:ext cx="7044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/>
              <a:t>FLAG</a:t>
            </a:r>
          </a:p>
        </p:txBody>
      </p:sp>
      <p:sp>
        <p:nvSpPr>
          <p:cNvPr id="124" name="CuadroTexto 123">
            <a:extLst>
              <a:ext uri="{FF2B5EF4-FFF2-40B4-BE49-F238E27FC236}">
                <a16:creationId xmlns:a16="http://schemas.microsoft.com/office/drawing/2014/main" id="{106C1AF1-94C5-F629-15FD-623F681A8C50}"/>
              </a:ext>
            </a:extLst>
          </p:cNvPr>
          <p:cNvSpPr txBox="1"/>
          <p:nvPr/>
        </p:nvSpPr>
        <p:spPr>
          <a:xfrm>
            <a:off x="4570120" y="5328359"/>
            <a:ext cx="68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/>
              <a:t>LRRFIP1</a:t>
            </a:r>
          </a:p>
        </p:txBody>
      </p:sp>
      <p:cxnSp>
        <p:nvCxnSpPr>
          <p:cNvPr id="127" name="Conector recto 126">
            <a:extLst>
              <a:ext uri="{FF2B5EF4-FFF2-40B4-BE49-F238E27FC236}">
                <a16:creationId xmlns:a16="http://schemas.microsoft.com/office/drawing/2014/main" id="{8839E733-E7A2-2B25-2A5F-F486A05DED28}"/>
              </a:ext>
            </a:extLst>
          </p:cNvPr>
          <p:cNvCxnSpPr>
            <a:cxnSpLocks/>
            <a:stCxn id="42" idx="0"/>
            <a:endCxn id="54" idx="0"/>
          </p:cNvCxnSpPr>
          <p:nvPr/>
        </p:nvCxnSpPr>
        <p:spPr>
          <a:xfrm>
            <a:off x="2648756" y="1178641"/>
            <a:ext cx="121324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CuadroTexto 127">
            <a:extLst>
              <a:ext uri="{FF2B5EF4-FFF2-40B4-BE49-F238E27FC236}">
                <a16:creationId xmlns:a16="http://schemas.microsoft.com/office/drawing/2014/main" id="{4DDF8618-B36F-119A-CA7A-EE88C352364F}"/>
              </a:ext>
            </a:extLst>
          </p:cNvPr>
          <p:cNvSpPr txBox="1"/>
          <p:nvPr/>
        </p:nvSpPr>
        <p:spPr>
          <a:xfrm>
            <a:off x="2813896" y="964216"/>
            <a:ext cx="7741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 dirty="0"/>
              <a:t>IP:FLAG</a:t>
            </a:r>
          </a:p>
        </p:txBody>
      </p:sp>
      <p:sp>
        <p:nvSpPr>
          <p:cNvPr id="133" name="CuadroTexto 132">
            <a:extLst>
              <a:ext uri="{FF2B5EF4-FFF2-40B4-BE49-F238E27FC236}">
                <a16:creationId xmlns:a16="http://schemas.microsoft.com/office/drawing/2014/main" id="{F7D03FBE-A81A-6BC4-1C33-3A183B86791D}"/>
              </a:ext>
            </a:extLst>
          </p:cNvPr>
          <p:cNvSpPr txBox="1"/>
          <p:nvPr/>
        </p:nvSpPr>
        <p:spPr>
          <a:xfrm>
            <a:off x="1627463" y="1984166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200" dirty="0"/>
              <a:t>182kDa</a:t>
            </a:r>
          </a:p>
        </p:txBody>
      </p:sp>
      <p:sp>
        <p:nvSpPr>
          <p:cNvPr id="134" name="CuadroTexto 133">
            <a:extLst>
              <a:ext uri="{FF2B5EF4-FFF2-40B4-BE49-F238E27FC236}">
                <a16:creationId xmlns:a16="http://schemas.microsoft.com/office/drawing/2014/main" id="{913B9BB6-4065-0AE0-54C4-70791E5BB21A}"/>
              </a:ext>
            </a:extLst>
          </p:cNvPr>
          <p:cNvSpPr txBox="1"/>
          <p:nvPr/>
        </p:nvSpPr>
        <p:spPr>
          <a:xfrm>
            <a:off x="1627463" y="2458738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200"/>
              <a:t>116kDa</a:t>
            </a:r>
          </a:p>
        </p:txBody>
      </p:sp>
      <p:sp>
        <p:nvSpPr>
          <p:cNvPr id="135" name="CuadroTexto 134">
            <a:extLst>
              <a:ext uri="{FF2B5EF4-FFF2-40B4-BE49-F238E27FC236}">
                <a16:creationId xmlns:a16="http://schemas.microsoft.com/office/drawing/2014/main" id="{34F0A8C1-B00F-FC42-FA0E-7F64DFB6A559}"/>
              </a:ext>
            </a:extLst>
          </p:cNvPr>
          <p:cNvSpPr txBox="1"/>
          <p:nvPr/>
        </p:nvSpPr>
        <p:spPr>
          <a:xfrm>
            <a:off x="1681341" y="281099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200"/>
              <a:t>82kDa</a:t>
            </a:r>
          </a:p>
        </p:txBody>
      </p:sp>
      <p:sp>
        <p:nvSpPr>
          <p:cNvPr id="136" name="CuadroTexto 135">
            <a:extLst>
              <a:ext uri="{FF2B5EF4-FFF2-40B4-BE49-F238E27FC236}">
                <a16:creationId xmlns:a16="http://schemas.microsoft.com/office/drawing/2014/main" id="{DE770029-C13A-362F-EA6B-452F863DBC8A}"/>
              </a:ext>
            </a:extLst>
          </p:cNvPr>
          <p:cNvSpPr txBox="1"/>
          <p:nvPr/>
        </p:nvSpPr>
        <p:spPr>
          <a:xfrm>
            <a:off x="1697067" y="3280150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200"/>
              <a:t>64kDa</a:t>
            </a:r>
          </a:p>
        </p:txBody>
      </p:sp>
      <p:sp>
        <p:nvSpPr>
          <p:cNvPr id="139" name="CuadroTexto 138">
            <a:extLst>
              <a:ext uri="{FF2B5EF4-FFF2-40B4-BE49-F238E27FC236}">
                <a16:creationId xmlns:a16="http://schemas.microsoft.com/office/drawing/2014/main" id="{02190607-545A-EAEF-B8B5-30DDD473E609}"/>
              </a:ext>
            </a:extLst>
          </p:cNvPr>
          <p:cNvSpPr txBox="1"/>
          <p:nvPr/>
        </p:nvSpPr>
        <p:spPr>
          <a:xfrm>
            <a:off x="1712033" y="365234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200"/>
              <a:t>37kDa</a:t>
            </a:r>
          </a:p>
        </p:txBody>
      </p:sp>
      <p:grpSp>
        <p:nvGrpSpPr>
          <p:cNvPr id="7" name="Grupo 6">
            <a:extLst>
              <a:ext uri="{FF2B5EF4-FFF2-40B4-BE49-F238E27FC236}">
                <a16:creationId xmlns:a16="http://schemas.microsoft.com/office/drawing/2014/main" id="{8D97C7FF-949E-1C1F-907C-9204A55EBD96}"/>
              </a:ext>
            </a:extLst>
          </p:cNvPr>
          <p:cNvGrpSpPr/>
          <p:nvPr/>
        </p:nvGrpSpPr>
        <p:grpSpPr>
          <a:xfrm>
            <a:off x="1637543" y="4667558"/>
            <a:ext cx="2787795" cy="2831423"/>
            <a:chOff x="1439890" y="4339167"/>
            <a:chExt cx="2349014" cy="2090735"/>
          </a:xfrm>
        </p:grpSpPr>
        <p:grpSp>
          <p:nvGrpSpPr>
            <p:cNvPr id="204" name="Grupo 203">
              <a:extLst>
                <a:ext uri="{FF2B5EF4-FFF2-40B4-BE49-F238E27FC236}">
                  <a16:creationId xmlns:a16="http://schemas.microsoft.com/office/drawing/2014/main" id="{8ACC7B1E-E575-A5C9-001D-648B9DED9431}"/>
                </a:ext>
              </a:extLst>
            </p:cNvPr>
            <p:cNvGrpSpPr/>
            <p:nvPr/>
          </p:nvGrpSpPr>
          <p:grpSpPr>
            <a:xfrm>
              <a:off x="2020425" y="4483913"/>
              <a:ext cx="121460" cy="1189357"/>
              <a:chOff x="2126145" y="3916017"/>
              <a:chExt cx="408332" cy="1454371"/>
            </a:xfrm>
          </p:grpSpPr>
          <p:cxnSp>
            <p:nvCxnSpPr>
              <p:cNvPr id="205" name="Conector recto 204">
                <a:extLst>
                  <a:ext uri="{FF2B5EF4-FFF2-40B4-BE49-F238E27FC236}">
                    <a16:creationId xmlns:a16="http://schemas.microsoft.com/office/drawing/2014/main" id="{740BA44F-D247-349E-363F-65A0FDBE4E40}"/>
                  </a:ext>
                </a:extLst>
              </p:cNvPr>
              <p:cNvCxnSpPr/>
              <p:nvPr/>
            </p:nvCxnSpPr>
            <p:spPr>
              <a:xfrm>
                <a:off x="2126146" y="3916017"/>
                <a:ext cx="37768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6" name="Conector recto 205">
                <a:extLst>
                  <a:ext uri="{FF2B5EF4-FFF2-40B4-BE49-F238E27FC236}">
                    <a16:creationId xmlns:a16="http://schemas.microsoft.com/office/drawing/2014/main" id="{7078B968-C719-5F90-98A2-8D1838D02E9A}"/>
                  </a:ext>
                </a:extLst>
              </p:cNvPr>
              <p:cNvCxnSpPr/>
              <p:nvPr/>
            </p:nvCxnSpPr>
            <p:spPr>
              <a:xfrm>
                <a:off x="2126145" y="4485861"/>
                <a:ext cx="37768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" name="Conector recto 206">
                <a:extLst>
                  <a:ext uri="{FF2B5EF4-FFF2-40B4-BE49-F238E27FC236}">
                    <a16:creationId xmlns:a16="http://schemas.microsoft.com/office/drawing/2014/main" id="{4EBF6361-0149-0467-B190-B5CD93833555}"/>
                  </a:ext>
                </a:extLst>
              </p:cNvPr>
              <p:cNvCxnSpPr/>
              <p:nvPr/>
            </p:nvCxnSpPr>
            <p:spPr>
              <a:xfrm>
                <a:off x="2126145" y="4934778"/>
                <a:ext cx="37768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Conector recto 207">
                <a:extLst>
                  <a:ext uri="{FF2B5EF4-FFF2-40B4-BE49-F238E27FC236}">
                    <a16:creationId xmlns:a16="http://schemas.microsoft.com/office/drawing/2014/main" id="{9EF16A84-0776-03ED-FF8A-4557944FE18D}"/>
                  </a:ext>
                </a:extLst>
              </p:cNvPr>
              <p:cNvCxnSpPr/>
              <p:nvPr/>
            </p:nvCxnSpPr>
            <p:spPr>
              <a:xfrm>
                <a:off x="2156791" y="5370388"/>
                <a:ext cx="37768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10" name="CuadroTexto 209">
              <a:extLst>
                <a:ext uri="{FF2B5EF4-FFF2-40B4-BE49-F238E27FC236}">
                  <a16:creationId xmlns:a16="http://schemas.microsoft.com/office/drawing/2014/main" id="{71A1120A-ECF7-C944-D0A7-629ED2FD6F5D}"/>
                </a:ext>
              </a:extLst>
            </p:cNvPr>
            <p:cNvSpPr txBox="1"/>
            <p:nvPr/>
          </p:nvSpPr>
          <p:spPr>
            <a:xfrm>
              <a:off x="1439890" y="4339167"/>
              <a:ext cx="555408" cy="204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200"/>
                <a:t>182kDa</a:t>
              </a:r>
            </a:p>
          </p:txBody>
        </p:sp>
        <p:sp>
          <p:nvSpPr>
            <p:cNvPr id="211" name="CuadroTexto 210">
              <a:extLst>
                <a:ext uri="{FF2B5EF4-FFF2-40B4-BE49-F238E27FC236}">
                  <a16:creationId xmlns:a16="http://schemas.microsoft.com/office/drawing/2014/main" id="{2A665B5F-90E1-1DF7-3916-53928A302641}"/>
                </a:ext>
              </a:extLst>
            </p:cNvPr>
            <p:cNvSpPr txBox="1"/>
            <p:nvPr/>
          </p:nvSpPr>
          <p:spPr>
            <a:xfrm>
              <a:off x="1439891" y="4813741"/>
              <a:ext cx="555408" cy="204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200"/>
                <a:t>116kDa</a:t>
              </a:r>
            </a:p>
          </p:txBody>
        </p:sp>
        <p:sp>
          <p:nvSpPr>
            <p:cNvPr id="212" name="CuadroTexto 211">
              <a:extLst>
                <a:ext uri="{FF2B5EF4-FFF2-40B4-BE49-F238E27FC236}">
                  <a16:creationId xmlns:a16="http://schemas.microsoft.com/office/drawing/2014/main" id="{0DCE5BAF-A005-6A19-35A8-D034638BD2A3}"/>
                </a:ext>
              </a:extLst>
            </p:cNvPr>
            <p:cNvSpPr txBox="1"/>
            <p:nvPr/>
          </p:nvSpPr>
          <p:spPr>
            <a:xfrm>
              <a:off x="1493770" y="5165999"/>
              <a:ext cx="489224" cy="204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200"/>
                <a:t>82kDa</a:t>
              </a:r>
            </a:p>
          </p:txBody>
        </p:sp>
        <p:sp>
          <p:nvSpPr>
            <p:cNvPr id="213" name="CuadroTexto 212">
              <a:extLst>
                <a:ext uri="{FF2B5EF4-FFF2-40B4-BE49-F238E27FC236}">
                  <a16:creationId xmlns:a16="http://schemas.microsoft.com/office/drawing/2014/main" id="{9B2CD68D-1162-BD7B-04C0-5EA88A3A3A9E}"/>
                </a:ext>
              </a:extLst>
            </p:cNvPr>
            <p:cNvSpPr txBox="1"/>
            <p:nvPr/>
          </p:nvSpPr>
          <p:spPr>
            <a:xfrm>
              <a:off x="1516504" y="5515889"/>
              <a:ext cx="489224" cy="2045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200"/>
                <a:t>64kDa</a:t>
              </a:r>
            </a:p>
          </p:txBody>
        </p:sp>
        <p:pic>
          <p:nvPicPr>
            <p:cNvPr id="218" name="Imagen 217" descr="Imagen en blanco y negro&#10;&#10;Descripción generada automáticamente con confianza baja">
              <a:extLst>
                <a:ext uri="{FF2B5EF4-FFF2-40B4-BE49-F238E27FC236}">
                  <a16:creationId xmlns:a16="http://schemas.microsoft.com/office/drawing/2014/main" id="{79CCC012-5C18-36BB-7BFB-CDF561A3F51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13" t="20672" r="56657" b="21082"/>
            <a:stretch/>
          </p:blipFill>
          <p:spPr>
            <a:xfrm>
              <a:off x="2148982" y="4344176"/>
              <a:ext cx="1639922" cy="208572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9" name="Rectángulo 8">
            <a:extLst>
              <a:ext uri="{FF2B5EF4-FFF2-40B4-BE49-F238E27FC236}">
                <a16:creationId xmlns:a16="http://schemas.microsoft.com/office/drawing/2014/main" id="{146086C0-B663-8443-F4B7-2719B3DFBC7A}"/>
              </a:ext>
            </a:extLst>
          </p:cNvPr>
          <p:cNvSpPr/>
          <p:nvPr/>
        </p:nvSpPr>
        <p:spPr>
          <a:xfrm>
            <a:off x="2583010" y="1877652"/>
            <a:ext cx="1656175" cy="229973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" name="Rectángulo 20">
            <a:extLst>
              <a:ext uri="{FF2B5EF4-FFF2-40B4-BE49-F238E27FC236}">
                <a16:creationId xmlns:a16="http://schemas.microsoft.com/office/drawing/2014/main" id="{E6FAAC9E-4562-B972-E7DE-16A5145C38A0}"/>
              </a:ext>
            </a:extLst>
          </p:cNvPr>
          <p:cNvSpPr/>
          <p:nvPr/>
        </p:nvSpPr>
        <p:spPr>
          <a:xfrm>
            <a:off x="2488109" y="4811576"/>
            <a:ext cx="1937229" cy="516784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87989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8" name="Grupo 67">
            <a:extLst>
              <a:ext uri="{FF2B5EF4-FFF2-40B4-BE49-F238E27FC236}">
                <a16:creationId xmlns:a16="http://schemas.microsoft.com/office/drawing/2014/main" id="{EDE8E204-7F0E-208F-EB7A-81EFD0FE618B}"/>
              </a:ext>
            </a:extLst>
          </p:cNvPr>
          <p:cNvGrpSpPr/>
          <p:nvPr/>
        </p:nvGrpSpPr>
        <p:grpSpPr>
          <a:xfrm>
            <a:off x="1314984" y="1873977"/>
            <a:ext cx="2750923" cy="532338"/>
            <a:chOff x="1410235" y="388077"/>
            <a:chExt cx="2700298" cy="532338"/>
          </a:xfrm>
        </p:grpSpPr>
        <p:grpSp>
          <p:nvGrpSpPr>
            <p:cNvPr id="5" name="Grupo 4">
              <a:extLst>
                <a:ext uri="{FF2B5EF4-FFF2-40B4-BE49-F238E27FC236}">
                  <a16:creationId xmlns:a16="http://schemas.microsoft.com/office/drawing/2014/main" id="{CC8D6B1B-11E6-E58F-DB82-3C3805254A4C}"/>
                </a:ext>
              </a:extLst>
            </p:cNvPr>
            <p:cNvGrpSpPr/>
            <p:nvPr/>
          </p:nvGrpSpPr>
          <p:grpSpPr>
            <a:xfrm>
              <a:off x="1410235" y="562449"/>
              <a:ext cx="1633647" cy="355423"/>
              <a:chOff x="821154" y="922744"/>
              <a:chExt cx="2503617" cy="373148"/>
            </a:xfrm>
          </p:grpSpPr>
          <p:sp>
            <p:nvSpPr>
              <p:cNvPr id="53" name="CuadroTexto 52">
                <a:extLst>
                  <a:ext uri="{FF2B5EF4-FFF2-40B4-BE49-F238E27FC236}">
                    <a16:creationId xmlns:a16="http://schemas.microsoft.com/office/drawing/2014/main" id="{B841DFBC-3206-9213-1131-051CE9803F4A}"/>
                  </a:ext>
                </a:extLst>
              </p:cNvPr>
              <p:cNvSpPr txBox="1"/>
              <p:nvPr/>
            </p:nvSpPr>
            <p:spPr>
              <a:xfrm>
                <a:off x="829486" y="922744"/>
                <a:ext cx="2495285" cy="2423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/>
                  <a:t>NLRP1 (full </a:t>
                </a:r>
                <a:r>
                  <a:rPr lang="es-ES" sz="900" dirty="0" err="1"/>
                  <a:t>length</a:t>
                </a:r>
                <a:r>
                  <a:rPr lang="es-ES" sz="900" dirty="0"/>
                  <a:t>)-</a:t>
                </a:r>
                <a:r>
                  <a:rPr lang="es-ES" sz="900" dirty="0" err="1"/>
                  <a:t>Flag</a:t>
                </a:r>
                <a:endParaRPr lang="es-ES" sz="900" dirty="0"/>
              </a:p>
            </p:txBody>
          </p:sp>
          <p:sp>
            <p:nvSpPr>
              <p:cNvPr id="54" name="CuadroTexto 53">
                <a:extLst>
                  <a:ext uri="{FF2B5EF4-FFF2-40B4-BE49-F238E27FC236}">
                    <a16:creationId xmlns:a16="http://schemas.microsoft.com/office/drawing/2014/main" id="{1EFF6E1B-BCF1-9006-0458-C202BFC32981}"/>
                  </a:ext>
                </a:extLst>
              </p:cNvPr>
              <p:cNvSpPr txBox="1"/>
              <p:nvPr/>
            </p:nvSpPr>
            <p:spPr>
              <a:xfrm>
                <a:off x="821154" y="1053549"/>
                <a:ext cx="2406660" cy="24234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/>
                  <a:t>UPA-CARD-</a:t>
                </a:r>
                <a:r>
                  <a:rPr lang="es-ES" sz="900" err="1"/>
                  <a:t>Flag</a:t>
                </a:r>
                <a:endParaRPr lang="es-ES" sz="900"/>
              </a:p>
            </p:txBody>
          </p:sp>
        </p:grpSp>
        <p:sp>
          <p:nvSpPr>
            <p:cNvPr id="6" name="CuadroTexto 5">
              <a:extLst>
                <a:ext uri="{FF2B5EF4-FFF2-40B4-BE49-F238E27FC236}">
                  <a16:creationId xmlns:a16="http://schemas.microsoft.com/office/drawing/2014/main" id="{87336119-D584-C803-7DA7-B285C21A5862}"/>
                </a:ext>
              </a:extLst>
            </p:cNvPr>
            <p:cNvSpPr txBox="1"/>
            <p:nvPr/>
          </p:nvSpPr>
          <p:spPr>
            <a:xfrm>
              <a:off x="2924352" y="588043"/>
              <a:ext cx="2056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/>
                <a:t>-</a:t>
              </a:r>
            </a:p>
          </p:txBody>
        </p:sp>
        <p:sp>
          <p:nvSpPr>
            <p:cNvPr id="7" name="CuadroTexto 6">
              <a:extLst>
                <a:ext uri="{FF2B5EF4-FFF2-40B4-BE49-F238E27FC236}">
                  <a16:creationId xmlns:a16="http://schemas.microsoft.com/office/drawing/2014/main" id="{DFC1C928-B58C-5B39-6A36-94B095AF7742}"/>
                </a:ext>
              </a:extLst>
            </p:cNvPr>
            <p:cNvSpPr txBox="1"/>
            <p:nvPr/>
          </p:nvSpPr>
          <p:spPr>
            <a:xfrm>
              <a:off x="2925912" y="689583"/>
              <a:ext cx="2056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/>
                <a:t>-</a:t>
              </a:r>
            </a:p>
          </p:txBody>
        </p:sp>
        <p:sp>
          <p:nvSpPr>
            <p:cNvPr id="9" name="CuadroTexto 8">
              <a:extLst>
                <a:ext uri="{FF2B5EF4-FFF2-40B4-BE49-F238E27FC236}">
                  <a16:creationId xmlns:a16="http://schemas.microsoft.com/office/drawing/2014/main" id="{212ED726-7A90-A745-4B8C-A235A7C7A7AD}"/>
                </a:ext>
              </a:extLst>
            </p:cNvPr>
            <p:cNvSpPr txBox="1"/>
            <p:nvPr/>
          </p:nvSpPr>
          <p:spPr>
            <a:xfrm>
              <a:off x="3098679" y="588043"/>
              <a:ext cx="2266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900"/>
                <a:t>+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:a16="http://schemas.microsoft.com/office/drawing/2014/main" id="{ED2B8D90-DDC0-18CA-4ADE-49ED80D89D0C}"/>
                </a:ext>
              </a:extLst>
            </p:cNvPr>
            <p:cNvSpPr txBox="1"/>
            <p:nvPr/>
          </p:nvSpPr>
          <p:spPr>
            <a:xfrm>
              <a:off x="3110733" y="689583"/>
              <a:ext cx="2056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900"/>
                <a:t>-</a:t>
              </a:r>
            </a:p>
          </p:txBody>
        </p:sp>
        <p:sp>
          <p:nvSpPr>
            <p:cNvPr id="12" name="CuadroTexto 11">
              <a:extLst>
                <a:ext uri="{FF2B5EF4-FFF2-40B4-BE49-F238E27FC236}">
                  <a16:creationId xmlns:a16="http://schemas.microsoft.com/office/drawing/2014/main" id="{1901EB10-0267-51F1-3E8E-B92CA8345349}"/>
                </a:ext>
              </a:extLst>
            </p:cNvPr>
            <p:cNvSpPr txBox="1"/>
            <p:nvPr/>
          </p:nvSpPr>
          <p:spPr>
            <a:xfrm>
              <a:off x="3317603" y="588043"/>
              <a:ext cx="2266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900"/>
                <a:t>+</a:t>
              </a:r>
            </a:p>
          </p:txBody>
        </p:sp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id="{89944078-0670-9E61-4EE3-C9F0F12D0445}"/>
                </a:ext>
              </a:extLst>
            </p:cNvPr>
            <p:cNvSpPr txBox="1"/>
            <p:nvPr/>
          </p:nvSpPr>
          <p:spPr>
            <a:xfrm>
              <a:off x="3329656" y="689583"/>
              <a:ext cx="2056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900"/>
                <a:t>-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id="{111DD018-B35B-46AF-D271-B4D5562EB4EC}"/>
                </a:ext>
              </a:extLst>
            </p:cNvPr>
            <p:cNvSpPr txBox="1"/>
            <p:nvPr/>
          </p:nvSpPr>
          <p:spPr>
            <a:xfrm>
              <a:off x="3571138" y="588043"/>
              <a:ext cx="2056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/>
                <a:t>-</a:t>
              </a: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id="{EF85D84E-9936-A6B4-8EB3-4B8746D40B27}"/>
                </a:ext>
              </a:extLst>
            </p:cNvPr>
            <p:cNvSpPr txBox="1"/>
            <p:nvPr/>
          </p:nvSpPr>
          <p:spPr>
            <a:xfrm>
              <a:off x="3531330" y="689583"/>
              <a:ext cx="2266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900"/>
                <a:t>+</a:t>
              </a:r>
            </a:p>
          </p:txBody>
        </p: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6F29A7E9-B002-6434-C9AC-4FB140B133D5}"/>
                </a:ext>
              </a:extLst>
            </p:cNvPr>
            <p:cNvSpPr txBox="1"/>
            <p:nvPr/>
          </p:nvSpPr>
          <p:spPr>
            <a:xfrm>
              <a:off x="3755960" y="588043"/>
              <a:ext cx="2056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900"/>
                <a:t>-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14C537EF-4122-C74C-20BE-787C651BFE3F}"/>
                </a:ext>
              </a:extLst>
            </p:cNvPr>
            <p:cNvSpPr txBox="1"/>
            <p:nvPr/>
          </p:nvSpPr>
          <p:spPr>
            <a:xfrm>
              <a:off x="3747025" y="689583"/>
              <a:ext cx="2266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900"/>
                <a:t>+</a:t>
              </a:r>
            </a:p>
          </p:txBody>
        </p:sp>
        <p:cxnSp>
          <p:nvCxnSpPr>
            <p:cNvPr id="27" name="Conector recto 26">
              <a:extLst>
                <a:ext uri="{FF2B5EF4-FFF2-40B4-BE49-F238E27FC236}">
                  <a16:creationId xmlns:a16="http://schemas.microsoft.com/office/drawing/2014/main" id="{186F89D3-D222-0730-62F8-0B6F3E9908A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830946" y="627229"/>
              <a:ext cx="1279587" cy="72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0C3DE269-C139-498D-2E2F-B9880FAF1A5B}"/>
                </a:ext>
              </a:extLst>
            </p:cNvPr>
            <p:cNvSpPr txBox="1"/>
            <p:nvPr/>
          </p:nvSpPr>
          <p:spPr>
            <a:xfrm>
              <a:off x="3211542" y="388077"/>
              <a:ext cx="5444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900" dirty="0"/>
                <a:t>INPUT</a:t>
              </a:r>
            </a:p>
          </p:txBody>
        </p:sp>
      </p:grpSp>
      <p:sp>
        <p:nvSpPr>
          <p:cNvPr id="29" name="CuadroTexto 28">
            <a:extLst>
              <a:ext uri="{FF2B5EF4-FFF2-40B4-BE49-F238E27FC236}">
                <a16:creationId xmlns:a16="http://schemas.microsoft.com/office/drawing/2014/main" id="{D3DB174C-10F2-F6E0-AA63-4002509948D3}"/>
              </a:ext>
            </a:extLst>
          </p:cNvPr>
          <p:cNvSpPr txBox="1"/>
          <p:nvPr/>
        </p:nvSpPr>
        <p:spPr>
          <a:xfrm>
            <a:off x="4065908" y="3137758"/>
            <a:ext cx="3738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 err="1"/>
              <a:t>Flag</a:t>
            </a:r>
            <a:endParaRPr lang="es-ES" sz="900" dirty="0"/>
          </a:p>
        </p:txBody>
      </p:sp>
      <p:pic>
        <p:nvPicPr>
          <p:cNvPr id="30" name="Imagen 29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CC5382B6-4F70-EC2E-215A-07B1AC04625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793" t="20672" r="17954" b="22045"/>
          <a:stretch/>
        </p:blipFill>
        <p:spPr>
          <a:xfrm>
            <a:off x="2869346" y="4415436"/>
            <a:ext cx="1156270" cy="1356976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1" name="Grupo 30">
            <a:extLst>
              <a:ext uri="{FF2B5EF4-FFF2-40B4-BE49-F238E27FC236}">
                <a16:creationId xmlns:a16="http://schemas.microsoft.com/office/drawing/2014/main" id="{E2CAE058-47B3-DC66-5560-FA2CD01F9303}"/>
              </a:ext>
            </a:extLst>
          </p:cNvPr>
          <p:cNvGrpSpPr/>
          <p:nvPr/>
        </p:nvGrpSpPr>
        <p:grpSpPr>
          <a:xfrm>
            <a:off x="2310960" y="4409105"/>
            <a:ext cx="546454" cy="806173"/>
            <a:chOff x="1423962" y="4246945"/>
            <a:chExt cx="711095" cy="1433731"/>
          </a:xfrm>
        </p:grpSpPr>
        <p:grpSp>
          <p:nvGrpSpPr>
            <p:cNvPr id="46" name="Grupo 45">
              <a:extLst>
                <a:ext uri="{FF2B5EF4-FFF2-40B4-BE49-F238E27FC236}">
                  <a16:creationId xmlns:a16="http://schemas.microsoft.com/office/drawing/2014/main" id="{7136ED82-5400-9726-CB49-085643C6F2B8}"/>
                </a:ext>
              </a:extLst>
            </p:cNvPr>
            <p:cNvGrpSpPr/>
            <p:nvPr/>
          </p:nvGrpSpPr>
          <p:grpSpPr>
            <a:xfrm>
              <a:off x="2013984" y="4412085"/>
              <a:ext cx="121073" cy="1018761"/>
              <a:chOff x="2126145" y="3916017"/>
              <a:chExt cx="377688" cy="1018761"/>
            </a:xfrm>
          </p:grpSpPr>
          <p:cxnSp>
            <p:nvCxnSpPr>
              <p:cNvPr id="50" name="Conector recto 49">
                <a:extLst>
                  <a:ext uri="{FF2B5EF4-FFF2-40B4-BE49-F238E27FC236}">
                    <a16:creationId xmlns:a16="http://schemas.microsoft.com/office/drawing/2014/main" id="{EE321CE7-6324-8E19-B0BB-818ACE86D567}"/>
                  </a:ext>
                </a:extLst>
              </p:cNvPr>
              <p:cNvCxnSpPr/>
              <p:nvPr/>
            </p:nvCxnSpPr>
            <p:spPr>
              <a:xfrm>
                <a:off x="2126146" y="3916017"/>
                <a:ext cx="37768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ector recto 50">
                <a:extLst>
                  <a:ext uri="{FF2B5EF4-FFF2-40B4-BE49-F238E27FC236}">
                    <a16:creationId xmlns:a16="http://schemas.microsoft.com/office/drawing/2014/main" id="{BE8F1F3D-25CF-C932-C5CD-8027BC0C7650}"/>
                  </a:ext>
                </a:extLst>
              </p:cNvPr>
              <p:cNvCxnSpPr/>
              <p:nvPr/>
            </p:nvCxnSpPr>
            <p:spPr>
              <a:xfrm>
                <a:off x="2126145" y="4485861"/>
                <a:ext cx="37768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ector recto 51">
                <a:extLst>
                  <a:ext uri="{FF2B5EF4-FFF2-40B4-BE49-F238E27FC236}">
                    <a16:creationId xmlns:a16="http://schemas.microsoft.com/office/drawing/2014/main" id="{1D5337B2-EE45-01E8-0E83-7C7E11C4505C}"/>
                  </a:ext>
                </a:extLst>
              </p:cNvPr>
              <p:cNvCxnSpPr/>
              <p:nvPr/>
            </p:nvCxnSpPr>
            <p:spPr>
              <a:xfrm>
                <a:off x="2126145" y="4934778"/>
                <a:ext cx="377687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7" name="CuadroTexto 46">
              <a:extLst>
                <a:ext uri="{FF2B5EF4-FFF2-40B4-BE49-F238E27FC236}">
                  <a16:creationId xmlns:a16="http://schemas.microsoft.com/office/drawing/2014/main" id="{B8994DA2-EAD8-5FD1-0F50-BFAD4C5113B9}"/>
                </a:ext>
              </a:extLst>
            </p:cNvPr>
            <p:cNvSpPr txBox="1"/>
            <p:nvPr/>
          </p:nvSpPr>
          <p:spPr>
            <a:xfrm>
              <a:off x="1423962" y="4246945"/>
              <a:ext cx="651863" cy="410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900" dirty="0"/>
                <a:t>182kDa</a:t>
              </a:r>
            </a:p>
          </p:txBody>
        </p:sp>
        <p:sp>
          <p:nvSpPr>
            <p:cNvPr id="48" name="CuadroTexto 47">
              <a:extLst>
                <a:ext uri="{FF2B5EF4-FFF2-40B4-BE49-F238E27FC236}">
                  <a16:creationId xmlns:a16="http://schemas.microsoft.com/office/drawing/2014/main" id="{F411CD92-9E55-61B7-7816-75760D40E348}"/>
                </a:ext>
              </a:extLst>
            </p:cNvPr>
            <p:cNvSpPr txBox="1"/>
            <p:nvPr/>
          </p:nvSpPr>
          <p:spPr>
            <a:xfrm>
              <a:off x="1423962" y="4819742"/>
              <a:ext cx="651863" cy="410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900" dirty="0"/>
                <a:t>116kDa</a:t>
              </a:r>
            </a:p>
          </p:txBody>
        </p:sp>
        <p:sp>
          <p:nvSpPr>
            <p:cNvPr id="49" name="CuadroTexto 48">
              <a:extLst>
                <a:ext uri="{FF2B5EF4-FFF2-40B4-BE49-F238E27FC236}">
                  <a16:creationId xmlns:a16="http://schemas.microsoft.com/office/drawing/2014/main" id="{BF76BA7C-92C5-C1F6-B293-AEED1A1599D3}"/>
                </a:ext>
              </a:extLst>
            </p:cNvPr>
            <p:cNvSpPr txBox="1"/>
            <p:nvPr/>
          </p:nvSpPr>
          <p:spPr>
            <a:xfrm>
              <a:off x="1482086" y="5270155"/>
              <a:ext cx="581645" cy="4105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900"/>
                <a:t>82kDa</a:t>
              </a:r>
            </a:p>
          </p:txBody>
        </p:sp>
      </p:grpSp>
      <p:sp>
        <p:nvSpPr>
          <p:cNvPr id="32" name="CuadroTexto 31">
            <a:extLst>
              <a:ext uri="{FF2B5EF4-FFF2-40B4-BE49-F238E27FC236}">
                <a16:creationId xmlns:a16="http://schemas.microsoft.com/office/drawing/2014/main" id="{0DDAFD28-20F1-385F-18AB-284038AAE9B0}"/>
              </a:ext>
            </a:extLst>
          </p:cNvPr>
          <p:cNvSpPr txBox="1"/>
          <p:nvPr/>
        </p:nvSpPr>
        <p:spPr>
          <a:xfrm>
            <a:off x="4480208" y="4710345"/>
            <a:ext cx="5565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LRRFIP1</a:t>
            </a:r>
          </a:p>
        </p:txBody>
      </p:sp>
      <p:grpSp>
        <p:nvGrpSpPr>
          <p:cNvPr id="33" name="Grupo 32">
            <a:extLst>
              <a:ext uri="{FF2B5EF4-FFF2-40B4-BE49-F238E27FC236}">
                <a16:creationId xmlns:a16="http://schemas.microsoft.com/office/drawing/2014/main" id="{20BDCBC8-51D1-41FD-88D5-43AEEA46DA21}"/>
              </a:ext>
            </a:extLst>
          </p:cNvPr>
          <p:cNvGrpSpPr/>
          <p:nvPr/>
        </p:nvGrpSpPr>
        <p:grpSpPr>
          <a:xfrm>
            <a:off x="2310983" y="2620750"/>
            <a:ext cx="546784" cy="1491884"/>
            <a:chOff x="5141480" y="1763820"/>
            <a:chExt cx="631118" cy="2174185"/>
          </a:xfrm>
        </p:grpSpPr>
        <p:grpSp>
          <p:nvGrpSpPr>
            <p:cNvPr id="37" name="Grupo 36">
              <a:extLst>
                <a:ext uri="{FF2B5EF4-FFF2-40B4-BE49-F238E27FC236}">
                  <a16:creationId xmlns:a16="http://schemas.microsoft.com/office/drawing/2014/main" id="{05507EE9-8901-FE84-2A55-94756AAE124F}"/>
                </a:ext>
              </a:extLst>
            </p:cNvPr>
            <p:cNvGrpSpPr/>
            <p:nvPr/>
          </p:nvGrpSpPr>
          <p:grpSpPr>
            <a:xfrm>
              <a:off x="5665142" y="2766959"/>
              <a:ext cx="107456" cy="1018761"/>
              <a:chOff x="2126145" y="3916017"/>
              <a:chExt cx="377688" cy="1018761"/>
            </a:xfrm>
          </p:grpSpPr>
          <p:cxnSp>
            <p:nvCxnSpPr>
              <p:cNvPr id="43" name="Conector recto 42">
                <a:extLst>
                  <a:ext uri="{FF2B5EF4-FFF2-40B4-BE49-F238E27FC236}">
                    <a16:creationId xmlns:a16="http://schemas.microsoft.com/office/drawing/2014/main" id="{E3AB3F25-4D10-4C3D-C0DE-CD23D0F63C10}"/>
                  </a:ext>
                </a:extLst>
              </p:cNvPr>
              <p:cNvCxnSpPr/>
              <p:nvPr/>
            </p:nvCxnSpPr>
            <p:spPr>
              <a:xfrm>
                <a:off x="2126146" y="3916017"/>
                <a:ext cx="37768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Conector recto 43">
                <a:extLst>
                  <a:ext uri="{FF2B5EF4-FFF2-40B4-BE49-F238E27FC236}">
                    <a16:creationId xmlns:a16="http://schemas.microsoft.com/office/drawing/2014/main" id="{D7F45660-667C-46A6-C412-CE619C680D4A}"/>
                  </a:ext>
                </a:extLst>
              </p:cNvPr>
              <p:cNvCxnSpPr/>
              <p:nvPr/>
            </p:nvCxnSpPr>
            <p:spPr>
              <a:xfrm>
                <a:off x="2126145" y="4485861"/>
                <a:ext cx="37768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Conector recto 44">
                <a:extLst>
                  <a:ext uri="{FF2B5EF4-FFF2-40B4-BE49-F238E27FC236}">
                    <a16:creationId xmlns:a16="http://schemas.microsoft.com/office/drawing/2014/main" id="{4722DD0C-E762-4059-8AB1-E60316CF1F81}"/>
                  </a:ext>
                </a:extLst>
              </p:cNvPr>
              <p:cNvCxnSpPr/>
              <p:nvPr/>
            </p:nvCxnSpPr>
            <p:spPr>
              <a:xfrm>
                <a:off x="2126145" y="4934778"/>
                <a:ext cx="37768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8" name="CuadroTexto 37">
              <a:extLst>
                <a:ext uri="{FF2B5EF4-FFF2-40B4-BE49-F238E27FC236}">
                  <a16:creationId xmlns:a16="http://schemas.microsoft.com/office/drawing/2014/main" id="{00188FDE-CA41-410D-E08E-E8D3367643A5}"/>
                </a:ext>
              </a:extLst>
            </p:cNvPr>
            <p:cNvSpPr txBox="1"/>
            <p:nvPr/>
          </p:nvSpPr>
          <p:spPr>
            <a:xfrm>
              <a:off x="5141480" y="1763820"/>
              <a:ext cx="578199" cy="33640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s-ES_tradnl" sz="900" dirty="0"/>
                <a:t>182kDa</a:t>
              </a:r>
            </a:p>
          </p:txBody>
        </p:sp>
        <p:sp>
          <p:nvSpPr>
            <p:cNvPr id="39" name="CuadroTexto 38">
              <a:extLst>
                <a:ext uri="{FF2B5EF4-FFF2-40B4-BE49-F238E27FC236}">
                  <a16:creationId xmlns:a16="http://schemas.microsoft.com/office/drawing/2014/main" id="{DC21415E-6453-1A82-1604-603DC3D60727}"/>
                </a:ext>
              </a:extLst>
            </p:cNvPr>
            <p:cNvSpPr txBox="1"/>
            <p:nvPr/>
          </p:nvSpPr>
          <p:spPr>
            <a:xfrm>
              <a:off x="5141480" y="2209493"/>
              <a:ext cx="578199" cy="33640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s-ES_tradnl" sz="900" dirty="0"/>
                <a:t>116kDa</a:t>
              </a:r>
            </a:p>
          </p:txBody>
        </p:sp>
        <p:sp>
          <p:nvSpPr>
            <p:cNvPr id="40" name="CuadroTexto 39">
              <a:extLst>
                <a:ext uri="{FF2B5EF4-FFF2-40B4-BE49-F238E27FC236}">
                  <a16:creationId xmlns:a16="http://schemas.microsoft.com/office/drawing/2014/main" id="{FA2C3190-C79E-9910-7663-4976DD6A2BF0}"/>
                </a:ext>
              </a:extLst>
            </p:cNvPr>
            <p:cNvSpPr txBox="1"/>
            <p:nvPr/>
          </p:nvSpPr>
          <p:spPr>
            <a:xfrm>
              <a:off x="5193015" y="2540299"/>
              <a:ext cx="515915" cy="33640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s-ES_tradnl" sz="900" dirty="0"/>
                <a:t>82kDa</a:t>
              </a:r>
            </a:p>
          </p:txBody>
        </p:sp>
        <p:sp>
          <p:nvSpPr>
            <p:cNvPr id="41" name="CuadroTexto 40">
              <a:extLst>
                <a:ext uri="{FF2B5EF4-FFF2-40B4-BE49-F238E27FC236}">
                  <a16:creationId xmlns:a16="http://schemas.microsoft.com/office/drawing/2014/main" id="{5FE59B0F-AA69-2091-5CA8-90EDDF1F6632}"/>
                </a:ext>
              </a:extLst>
            </p:cNvPr>
            <p:cNvSpPr txBox="1"/>
            <p:nvPr/>
          </p:nvSpPr>
          <p:spPr>
            <a:xfrm>
              <a:off x="5187330" y="3168603"/>
              <a:ext cx="515915" cy="33640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s-ES_tradnl" sz="900" dirty="0"/>
                <a:t>64kDa</a:t>
              </a:r>
            </a:p>
          </p:txBody>
        </p:sp>
        <p:sp>
          <p:nvSpPr>
            <p:cNvPr id="42" name="CuadroTexto 41">
              <a:extLst>
                <a:ext uri="{FF2B5EF4-FFF2-40B4-BE49-F238E27FC236}">
                  <a16:creationId xmlns:a16="http://schemas.microsoft.com/office/drawing/2014/main" id="{EB15988B-5F2B-820D-ADE2-D46AEA7E8F56}"/>
                </a:ext>
              </a:extLst>
            </p:cNvPr>
            <p:cNvSpPr txBox="1"/>
            <p:nvPr/>
          </p:nvSpPr>
          <p:spPr>
            <a:xfrm>
              <a:off x="5191559" y="3601604"/>
              <a:ext cx="515915" cy="336401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s-ES_tradnl" sz="900" dirty="0"/>
                <a:t>37kDa</a:t>
              </a:r>
            </a:p>
          </p:txBody>
        </p:sp>
      </p:grpSp>
      <p:pic>
        <p:nvPicPr>
          <p:cNvPr id="34" name="Imagen 33" descr="Captura de pantalla de un celular&#10;&#10;Descripción generada automáticamente">
            <a:extLst>
              <a:ext uri="{FF2B5EF4-FFF2-40B4-BE49-F238E27FC236}">
                <a16:creationId xmlns:a16="http://schemas.microsoft.com/office/drawing/2014/main" id="{92ECEA78-A2D2-3378-562F-27F11BF467A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2699" t="9466" r="18697" b="22646"/>
          <a:stretch/>
        </p:blipFill>
        <p:spPr>
          <a:xfrm>
            <a:off x="2869018" y="2491416"/>
            <a:ext cx="1082009" cy="15235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Imagen 34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BE0F3318-E226-9648-0369-3F5D1C87D6F4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676" t="9070" r="27699" b="-249"/>
          <a:stretch/>
        </p:blipFill>
        <p:spPr>
          <a:xfrm>
            <a:off x="2857414" y="6076578"/>
            <a:ext cx="1168202" cy="18267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6" name="CuadroTexto 35">
            <a:extLst>
              <a:ext uri="{FF2B5EF4-FFF2-40B4-BE49-F238E27FC236}">
                <a16:creationId xmlns:a16="http://schemas.microsoft.com/office/drawing/2014/main" id="{7B5E06C9-E8AC-F79B-49C0-62474A6786F2}"/>
              </a:ext>
            </a:extLst>
          </p:cNvPr>
          <p:cNvSpPr txBox="1"/>
          <p:nvPr/>
        </p:nvSpPr>
        <p:spPr>
          <a:xfrm>
            <a:off x="4458788" y="7302269"/>
            <a:ext cx="43152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/>
              <a:t>ACTB</a:t>
            </a:r>
          </a:p>
        </p:txBody>
      </p:sp>
      <p:cxnSp>
        <p:nvCxnSpPr>
          <p:cNvPr id="56" name="Conector recto 55">
            <a:extLst>
              <a:ext uri="{FF2B5EF4-FFF2-40B4-BE49-F238E27FC236}">
                <a16:creationId xmlns:a16="http://schemas.microsoft.com/office/drawing/2014/main" id="{F58A9D6E-16BB-2EB5-1515-F0583110A374}"/>
              </a:ext>
            </a:extLst>
          </p:cNvPr>
          <p:cNvCxnSpPr/>
          <p:nvPr/>
        </p:nvCxnSpPr>
        <p:spPr>
          <a:xfrm>
            <a:off x="2764670" y="5305633"/>
            <a:ext cx="930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ector recto 56">
            <a:extLst>
              <a:ext uri="{FF2B5EF4-FFF2-40B4-BE49-F238E27FC236}">
                <a16:creationId xmlns:a16="http://schemas.microsoft.com/office/drawing/2014/main" id="{68460041-6498-1223-9006-01C8ADFE6EB9}"/>
              </a:ext>
            </a:extLst>
          </p:cNvPr>
          <p:cNvCxnSpPr/>
          <p:nvPr/>
        </p:nvCxnSpPr>
        <p:spPr>
          <a:xfrm>
            <a:off x="2764670" y="5483041"/>
            <a:ext cx="930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CuadroTexto 57">
            <a:extLst>
              <a:ext uri="{FF2B5EF4-FFF2-40B4-BE49-F238E27FC236}">
                <a16:creationId xmlns:a16="http://schemas.microsoft.com/office/drawing/2014/main" id="{DA9C0367-C746-1F75-B0CD-30C330BFC6E4}"/>
              </a:ext>
            </a:extLst>
          </p:cNvPr>
          <p:cNvSpPr txBox="1"/>
          <p:nvPr/>
        </p:nvSpPr>
        <p:spPr>
          <a:xfrm>
            <a:off x="2350706" y="5190217"/>
            <a:ext cx="446975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_tradnl" sz="900" dirty="0"/>
              <a:t>64kDa</a:t>
            </a:r>
          </a:p>
        </p:txBody>
      </p:sp>
      <p:sp>
        <p:nvSpPr>
          <p:cNvPr id="59" name="CuadroTexto 58">
            <a:extLst>
              <a:ext uri="{FF2B5EF4-FFF2-40B4-BE49-F238E27FC236}">
                <a16:creationId xmlns:a16="http://schemas.microsoft.com/office/drawing/2014/main" id="{828D087D-B454-4477-E550-E31F2A808496}"/>
              </a:ext>
            </a:extLst>
          </p:cNvPr>
          <p:cNvSpPr txBox="1"/>
          <p:nvPr/>
        </p:nvSpPr>
        <p:spPr>
          <a:xfrm>
            <a:off x="2354370" y="5356704"/>
            <a:ext cx="478016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_tradnl" sz="900" dirty="0"/>
              <a:t>48kDa</a:t>
            </a:r>
          </a:p>
        </p:txBody>
      </p:sp>
      <p:grpSp>
        <p:nvGrpSpPr>
          <p:cNvPr id="64" name="Grupo 63">
            <a:extLst>
              <a:ext uri="{FF2B5EF4-FFF2-40B4-BE49-F238E27FC236}">
                <a16:creationId xmlns:a16="http://schemas.microsoft.com/office/drawing/2014/main" id="{A6FE1016-2A3F-AC26-ED41-361693AB8198}"/>
              </a:ext>
            </a:extLst>
          </p:cNvPr>
          <p:cNvGrpSpPr/>
          <p:nvPr/>
        </p:nvGrpSpPr>
        <p:grpSpPr>
          <a:xfrm>
            <a:off x="2342081" y="7160539"/>
            <a:ext cx="507061" cy="514292"/>
            <a:chOff x="2398706" y="5765298"/>
            <a:chExt cx="507061" cy="397319"/>
          </a:xfrm>
        </p:grpSpPr>
        <p:cxnSp>
          <p:nvCxnSpPr>
            <p:cNvPr id="60" name="Conector recto 59">
              <a:extLst>
                <a:ext uri="{FF2B5EF4-FFF2-40B4-BE49-F238E27FC236}">
                  <a16:creationId xmlns:a16="http://schemas.microsoft.com/office/drawing/2014/main" id="{9CDADBC7-925D-21BE-C3DE-DAAD8599AD49}"/>
                </a:ext>
              </a:extLst>
            </p:cNvPr>
            <p:cNvCxnSpPr/>
            <p:nvPr/>
          </p:nvCxnSpPr>
          <p:spPr>
            <a:xfrm>
              <a:off x="2812670" y="5880714"/>
              <a:ext cx="93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ector recto 60">
              <a:extLst>
                <a:ext uri="{FF2B5EF4-FFF2-40B4-BE49-F238E27FC236}">
                  <a16:creationId xmlns:a16="http://schemas.microsoft.com/office/drawing/2014/main" id="{3F57266D-F57A-985B-D335-622D8C902424}"/>
                </a:ext>
              </a:extLst>
            </p:cNvPr>
            <p:cNvCxnSpPr/>
            <p:nvPr/>
          </p:nvCxnSpPr>
          <p:spPr>
            <a:xfrm>
              <a:off x="2812670" y="6058122"/>
              <a:ext cx="9309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CuadroTexto 61">
              <a:extLst>
                <a:ext uri="{FF2B5EF4-FFF2-40B4-BE49-F238E27FC236}">
                  <a16:creationId xmlns:a16="http://schemas.microsoft.com/office/drawing/2014/main" id="{1BD1084E-A646-D01B-7C11-3C05FA8364BC}"/>
                </a:ext>
              </a:extLst>
            </p:cNvPr>
            <p:cNvSpPr txBox="1"/>
            <p:nvPr/>
          </p:nvSpPr>
          <p:spPr>
            <a:xfrm>
              <a:off x="2398706" y="5765298"/>
              <a:ext cx="478016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s-ES_tradnl" sz="900" dirty="0"/>
                <a:t>48kDa</a:t>
              </a:r>
            </a:p>
          </p:txBody>
        </p:sp>
        <p:sp>
          <p:nvSpPr>
            <p:cNvPr id="63" name="CuadroTexto 62">
              <a:extLst>
                <a:ext uri="{FF2B5EF4-FFF2-40B4-BE49-F238E27FC236}">
                  <a16:creationId xmlns:a16="http://schemas.microsoft.com/office/drawing/2014/main" id="{11C42550-096C-B696-7B08-DF1AC037E0CF}"/>
                </a:ext>
              </a:extLst>
            </p:cNvPr>
            <p:cNvSpPr txBox="1"/>
            <p:nvPr/>
          </p:nvSpPr>
          <p:spPr>
            <a:xfrm>
              <a:off x="2402370" y="5931785"/>
              <a:ext cx="44697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s-ES_tradnl" sz="900" dirty="0"/>
                <a:t>37kDa</a:t>
              </a:r>
            </a:p>
          </p:txBody>
        </p:sp>
      </p:grpSp>
      <p:sp>
        <p:nvSpPr>
          <p:cNvPr id="65" name="Rectángulo 64">
            <a:extLst>
              <a:ext uri="{FF2B5EF4-FFF2-40B4-BE49-F238E27FC236}">
                <a16:creationId xmlns:a16="http://schemas.microsoft.com/office/drawing/2014/main" id="{F064E958-1712-56DF-238F-E2F035C4367C}"/>
              </a:ext>
            </a:extLst>
          </p:cNvPr>
          <p:cNvSpPr/>
          <p:nvPr/>
        </p:nvSpPr>
        <p:spPr>
          <a:xfrm>
            <a:off x="2832387" y="2560972"/>
            <a:ext cx="1109172" cy="141796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6" name="Rectángulo 65">
            <a:extLst>
              <a:ext uri="{FF2B5EF4-FFF2-40B4-BE49-F238E27FC236}">
                <a16:creationId xmlns:a16="http://schemas.microsoft.com/office/drawing/2014/main" id="{F4FF40EB-946E-3A6B-20C7-F4FD333134CA}"/>
              </a:ext>
            </a:extLst>
          </p:cNvPr>
          <p:cNvSpPr/>
          <p:nvPr/>
        </p:nvSpPr>
        <p:spPr>
          <a:xfrm>
            <a:off x="2839562" y="4512032"/>
            <a:ext cx="1215838" cy="703246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7" name="Rectángulo 66">
            <a:extLst>
              <a:ext uri="{FF2B5EF4-FFF2-40B4-BE49-F238E27FC236}">
                <a16:creationId xmlns:a16="http://schemas.microsoft.com/office/drawing/2014/main" id="{7F152798-73F4-22FF-0EE5-BFD03457299F}"/>
              </a:ext>
            </a:extLst>
          </p:cNvPr>
          <p:cNvSpPr/>
          <p:nvPr/>
        </p:nvSpPr>
        <p:spPr>
          <a:xfrm>
            <a:off x="2882834" y="7230277"/>
            <a:ext cx="1192815" cy="35162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F9D90965-11B9-B89A-CD49-86E9DC7AC05E}"/>
              </a:ext>
            </a:extLst>
          </p:cNvPr>
          <p:cNvSpPr txBox="1"/>
          <p:nvPr/>
        </p:nvSpPr>
        <p:spPr>
          <a:xfrm>
            <a:off x="2306445" y="6150576"/>
            <a:ext cx="500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/>
              <a:t>182kDa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79A126E4-6F4C-074D-2CDC-4BD9DF390A42}"/>
              </a:ext>
            </a:extLst>
          </p:cNvPr>
          <p:cNvSpPr txBox="1"/>
          <p:nvPr/>
        </p:nvSpPr>
        <p:spPr>
          <a:xfrm>
            <a:off x="2306445" y="6472654"/>
            <a:ext cx="500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/>
              <a:t>116kDa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1B8E72D8-1892-3747-D63B-9CEE1596979D}"/>
              </a:ext>
            </a:extLst>
          </p:cNvPr>
          <p:cNvSpPr txBox="1"/>
          <p:nvPr/>
        </p:nvSpPr>
        <p:spPr>
          <a:xfrm>
            <a:off x="2345744" y="6763221"/>
            <a:ext cx="44697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900" dirty="0"/>
              <a:t>82kDa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5773C4E2-C6E0-2569-F388-9FC50316B98D}"/>
              </a:ext>
            </a:extLst>
          </p:cNvPr>
          <p:cNvSpPr txBox="1"/>
          <p:nvPr/>
        </p:nvSpPr>
        <p:spPr>
          <a:xfrm>
            <a:off x="2338849" y="6958880"/>
            <a:ext cx="478016" cy="2308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s-ES_tradnl" sz="900" dirty="0"/>
              <a:t>64kDa</a:t>
            </a:r>
          </a:p>
        </p:txBody>
      </p:sp>
      <p:cxnSp>
        <p:nvCxnSpPr>
          <p:cNvPr id="11" name="Conector recto 10">
            <a:extLst>
              <a:ext uri="{FF2B5EF4-FFF2-40B4-BE49-F238E27FC236}">
                <a16:creationId xmlns:a16="http://schemas.microsoft.com/office/drawing/2014/main" id="{9D73E918-DCA0-2DF1-ED2B-404242F0910A}"/>
              </a:ext>
            </a:extLst>
          </p:cNvPr>
          <p:cNvCxnSpPr/>
          <p:nvPr/>
        </p:nvCxnSpPr>
        <p:spPr>
          <a:xfrm>
            <a:off x="2748876" y="6903517"/>
            <a:ext cx="930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9F48C4E8-6221-156B-0F41-51A23DD54686}"/>
              </a:ext>
            </a:extLst>
          </p:cNvPr>
          <p:cNvCxnSpPr/>
          <p:nvPr/>
        </p:nvCxnSpPr>
        <p:spPr>
          <a:xfrm>
            <a:off x="2748876" y="7080925"/>
            <a:ext cx="930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ector recto 16">
            <a:extLst>
              <a:ext uri="{FF2B5EF4-FFF2-40B4-BE49-F238E27FC236}">
                <a16:creationId xmlns:a16="http://schemas.microsoft.com/office/drawing/2014/main" id="{7470D822-AB04-7F40-7F52-468FF9E0B50F}"/>
              </a:ext>
            </a:extLst>
          </p:cNvPr>
          <p:cNvCxnSpPr/>
          <p:nvPr/>
        </p:nvCxnSpPr>
        <p:spPr>
          <a:xfrm>
            <a:off x="2758208" y="6614267"/>
            <a:ext cx="930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ector recto 19">
            <a:extLst>
              <a:ext uri="{FF2B5EF4-FFF2-40B4-BE49-F238E27FC236}">
                <a16:creationId xmlns:a16="http://schemas.microsoft.com/office/drawing/2014/main" id="{1EFDB093-4404-6E5A-ACE2-0A12877D5822}"/>
              </a:ext>
            </a:extLst>
          </p:cNvPr>
          <p:cNvCxnSpPr/>
          <p:nvPr/>
        </p:nvCxnSpPr>
        <p:spPr>
          <a:xfrm>
            <a:off x="2758211" y="6275379"/>
            <a:ext cx="930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04913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1</TotalTime>
  <Words>69</Words>
  <Application>Microsoft Office PowerPoint</Application>
  <PresentationFormat>Panorámica</PresentationFormat>
  <Paragraphs>57</Paragraphs>
  <Slides>2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MANUEL LOZANO GIL</dc:creator>
  <cp:lastModifiedBy>JUAN MANUEL LOZANO GIL</cp:lastModifiedBy>
  <cp:revision>1</cp:revision>
  <dcterms:created xsi:type="dcterms:W3CDTF">2022-10-20T13:34:47Z</dcterms:created>
  <dcterms:modified xsi:type="dcterms:W3CDTF">2023-07-19T10:58:16Z</dcterms:modified>
</cp:coreProperties>
</file>